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drawings/drawing4.xml" ContentType="application/vnd.openxmlformats-officedocument.drawingml.chartshapes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drawings/drawing5.xml" ContentType="application/vnd.openxmlformats-officedocument.drawingml.chartshapes+xml"/>
  <Override PartName="/ppt/charts/chart9.xml" ContentType="application/vnd.openxmlformats-officedocument.drawingml.chart+xml"/>
  <Override PartName="/ppt/drawings/drawing6.xml" ContentType="application/vnd.openxmlformats-officedocument.drawingml.chartshapes+xml"/>
  <Override PartName="/ppt/charts/chart10.xml" ContentType="application/vnd.openxmlformats-officedocument.drawingml.chart+xml"/>
  <Override PartName="/ppt/drawings/drawing7.xml" ContentType="application/vnd.openxmlformats-officedocument.drawingml.chartshapes+xml"/>
  <Override PartName="/ppt/charts/chart11.xml" ContentType="application/vnd.openxmlformats-officedocument.drawingml.chart+xml"/>
  <Override PartName="/ppt/drawings/drawing8.xml" ContentType="application/vnd.openxmlformats-officedocument.drawingml.chartshapes+xml"/>
  <Override PartName="/ppt/charts/chart12.xml" ContentType="application/vnd.openxmlformats-officedocument.drawingml.chart+xml"/>
  <Override PartName="/ppt/drawings/drawing9.xml" ContentType="application/vnd.openxmlformats-officedocument.drawingml.chartshapes+xml"/>
  <Override PartName="/ppt/charts/chart13.xml" ContentType="application/vnd.openxmlformats-officedocument.drawingml.chart+xml"/>
  <Override PartName="/ppt/drawings/drawing10.xml" ContentType="application/vnd.openxmlformats-officedocument.drawingml.chartshapes+xml"/>
  <Override PartName="/ppt/charts/chart14.xml" ContentType="application/vnd.openxmlformats-officedocument.drawingml.chart+xml"/>
  <Override PartName="/ppt/drawings/drawing11.xml" ContentType="application/vnd.openxmlformats-officedocument.drawingml.chartshapes+xml"/>
  <Override PartName="/ppt/charts/chart15.xml" ContentType="application/vnd.openxmlformats-officedocument.drawingml.chart+xml"/>
  <Override PartName="/ppt/drawings/drawing12.xml" ContentType="application/vnd.openxmlformats-officedocument.drawingml.chartshapes+xml"/>
  <Override PartName="/ppt/charts/chart16.xml" ContentType="application/vnd.openxmlformats-officedocument.drawingml.chart+xml"/>
  <Override PartName="/ppt/drawings/drawing13.xml" ContentType="application/vnd.openxmlformats-officedocument.drawingml.chartshapes+xml"/>
  <Override PartName="/ppt/charts/chart17.xml" ContentType="application/vnd.openxmlformats-officedocument.drawingml.chart+xml"/>
  <Override PartName="/ppt/drawings/drawing14.xml" ContentType="application/vnd.openxmlformats-officedocument.drawingml.chartshapes+xml"/>
  <Override PartName="/ppt/charts/chart18.xml" ContentType="application/vnd.openxmlformats-officedocument.drawingml.chart+xml"/>
  <Override PartName="/ppt/drawings/drawing15.xml" ContentType="application/vnd.openxmlformats-officedocument.drawingml.chartshapes+xml"/>
  <Override PartName="/ppt/charts/chart19.xml" ContentType="application/vnd.openxmlformats-officedocument.drawingml.chart+xml"/>
  <Override PartName="/ppt/drawings/drawing16.xml" ContentType="application/vnd.openxmlformats-officedocument.drawingml.chartshapes+xml"/>
  <Override PartName="/ppt/charts/chart20.xml" ContentType="application/vnd.openxmlformats-officedocument.drawingml.chart+xml"/>
  <Override PartName="/ppt/drawings/drawing17.xml" ContentType="application/vnd.openxmlformats-officedocument.drawingml.chartshapes+xml"/>
  <Override PartName="/ppt/charts/chart21.xml" ContentType="application/vnd.openxmlformats-officedocument.drawingml.chart+xml"/>
  <Override PartName="/ppt/drawings/drawing18.xml" ContentType="application/vnd.openxmlformats-officedocument.drawingml.chartshapes+xml"/>
  <Override PartName="/ppt/charts/chart22.xml" ContentType="application/vnd.openxmlformats-officedocument.drawingml.chart+xml"/>
  <Override PartName="/ppt/drawings/drawing19.xml" ContentType="application/vnd.openxmlformats-officedocument.drawingml.chartshapes+xml"/>
  <Override PartName="/ppt/charts/chart23.xml" ContentType="application/vnd.openxmlformats-officedocument.drawingml.chart+xml"/>
  <Override PartName="/ppt/drawings/drawing20.xml" ContentType="application/vnd.openxmlformats-officedocument.drawingml.chartshapes+xml"/>
  <Override PartName="/ppt/charts/chart24.xml" ContentType="application/vnd.openxmlformats-officedocument.drawingml.chart+xml"/>
  <Override PartName="/ppt/drawings/drawing21.xml" ContentType="application/vnd.openxmlformats-officedocument.drawingml.chartshapes+xml"/>
  <Override PartName="/ppt/charts/chart25.xml" ContentType="application/vnd.openxmlformats-officedocument.drawingml.chart+xml"/>
  <Override PartName="/ppt/drawings/drawing22.xml" ContentType="application/vnd.openxmlformats-officedocument.drawingml.chartshapes+xml"/>
  <Override PartName="/ppt/charts/chart26.xml" ContentType="application/vnd.openxmlformats-officedocument.drawingml.chart+xml"/>
  <Override PartName="/ppt/drawings/drawing23.xml" ContentType="application/vnd.openxmlformats-officedocument.drawingml.chartshapes+xml"/>
  <Override PartName="/ppt/charts/chart27.xml" ContentType="application/vnd.openxmlformats-officedocument.drawingml.chart+xml"/>
  <Override PartName="/ppt/drawings/drawing24.xml" ContentType="application/vnd.openxmlformats-officedocument.drawingml.chartshapes+xml"/>
  <Override PartName="/ppt/charts/chart28.xml" ContentType="application/vnd.openxmlformats-officedocument.drawingml.chart+xml"/>
  <Override PartName="/ppt/drawings/drawing25.xml" ContentType="application/vnd.openxmlformats-officedocument.drawingml.chartshapes+xml"/>
  <Override PartName="/ppt/charts/chart29.xml" ContentType="application/vnd.openxmlformats-officedocument.drawingml.chart+xml"/>
  <Override PartName="/ppt/drawings/drawing26.xml" ContentType="application/vnd.openxmlformats-officedocument.drawingml.chartshapes+xml"/>
  <Override PartName="/ppt/charts/chart30.xml" ContentType="application/vnd.openxmlformats-officedocument.drawingml.chart+xml"/>
  <Override PartName="/ppt/drawings/drawing27.xml" ContentType="application/vnd.openxmlformats-officedocument.drawingml.chartshapes+xml"/>
  <Override PartName="/ppt/charts/chart31.xml" ContentType="application/vnd.openxmlformats-officedocument.drawingml.chart+xml"/>
  <Override PartName="/ppt/drawings/drawing28.xml" ContentType="application/vnd.openxmlformats-officedocument.drawingml.chartshapes+xml"/>
  <Override PartName="/ppt/charts/chart32.xml" ContentType="application/vnd.openxmlformats-officedocument.drawingml.chart+xml"/>
  <Override PartName="/ppt/drawings/drawing29.xml" ContentType="application/vnd.openxmlformats-officedocument.drawingml.chartshapes+xml"/>
  <Override PartName="/ppt/charts/chart33.xml" ContentType="application/vnd.openxmlformats-officedocument.drawingml.chart+xml"/>
  <Override PartName="/ppt/drawings/drawing30.xml" ContentType="application/vnd.openxmlformats-officedocument.drawingml.chartshapes+xml"/>
  <Override PartName="/ppt/charts/chart34.xml" ContentType="application/vnd.openxmlformats-officedocument.drawingml.chart+xml"/>
  <Override PartName="/ppt/charts/chart35.xml" ContentType="application/vnd.openxmlformats-officedocument.drawingml.chart+xml"/>
  <Override PartName="/ppt/charts/chart36.xml" ContentType="application/vnd.openxmlformats-officedocument.drawingml.chart+xml"/>
  <Override PartName="/ppt/charts/chart37.xml" ContentType="application/vnd.openxmlformats-officedocument.drawingml.chart+xml"/>
  <Override PartName="/ppt/charts/chart38.xml" ContentType="application/vnd.openxmlformats-officedocument.drawingml.chart+xml"/>
  <Override PartName="/ppt/charts/chart39.xml" ContentType="application/vnd.openxmlformats-officedocument.drawingml.chart+xml"/>
  <Override PartName="/ppt/charts/chart40.xml" ContentType="application/vnd.openxmlformats-officedocument.drawingml.chart+xml"/>
  <Override PartName="/ppt/charts/chart41.xml" ContentType="application/vnd.openxmlformats-officedocument.drawingml.chart+xml"/>
  <Override PartName="/ppt/charts/chart42.xml" ContentType="application/vnd.openxmlformats-officedocument.drawingml.chart+xml"/>
  <Override PartName="/ppt/charts/chart43.xml" ContentType="application/vnd.openxmlformats-officedocument.drawingml.chart+xml"/>
  <Override PartName="/ppt/charts/chart44.xml" ContentType="application/vnd.openxmlformats-officedocument.drawingml.chart+xml"/>
  <Override PartName="/ppt/charts/chart45.xml" ContentType="application/vnd.openxmlformats-officedocument.drawingml.chart+xml"/>
  <Override PartName="/ppt/charts/chart46.xml" ContentType="application/vnd.openxmlformats-officedocument.drawingml.chart+xml"/>
  <Override PartName="/ppt/charts/chart47.xml" ContentType="application/vnd.openxmlformats-officedocument.drawingml.chart+xml"/>
  <Override PartName="/ppt/charts/chart48.xml" ContentType="application/vnd.openxmlformats-officedocument.drawingml.chart+xml"/>
  <Override PartName="/ppt/charts/chart49.xml" ContentType="application/vnd.openxmlformats-officedocument.drawingml.chart+xml"/>
  <Override PartName="/ppt/charts/chart50.xml" ContentType="application/vnd.openxmlformats-officedocument.drawingml.chart+xml"/>
  <Override PartName="/ppt/charts/chart51.xml" ContentType="application/vnd.openxmlformats-officedocument.drawingml.chart+xml"/>
  <Override PartName="/ppt/charts/chart52.xml" ContentType="application/vnd.openxmlformats-officedocument.drawingml.chart+xml"/>
  <Override PartName="/ppt/charts/chart53.xml" ContentType="application/vnd.openxmlformats-officedocument.drawingml.chart+xml"/>
  <Override PartName="/ppt/charts/chart54.xml" ContentType="application/vnd.openxmlformats-officedocument.drawingml.chart+xml"/>
  <Override PartName="/ppt/charts/chart55.xml" ContentType="application/vnd.openxmlformats-officedocument.drawingml.chart+xml"/>
  <Override PartName="/ppt/charts/chart56.xml" ContentType="application/vnd.openxmlformats-officedocument.drawingml.chart+xml"/>
  <Override PartName="/ppt/charts/chart57.xml" ContentType="application/vnd.openxmlformats-officedocument.drawingml.chart+xml"/>
  <Override PartName="/ppt/charts/chart5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32"/>
  </p:handoutMasterIdLst>
  <p:sldIdLst>
    <p:sldId id="303" r:id="rId2"/>
    <p:sldId id="256" r:id="rId3"/>
    <p:sldId id="288" r:id="rId4"/>
    <p:sldId id="289" r:id="rId5"/>
    <p:sldId id="290" r:id="rId6"/>
    <p:sldId id="263" r:id="rId7"/>
    <p:sldId id="291" r:id="rId8"/>
    <p:sldId id="292" r:id="rId9"/>
    <p:sldId id="293" r:id="rId10"/>
    <p:sldId id="261" r:id="rId11"/>
    <p:sldId id="280" r:id="rId12"/>
    <p:sldId id="262" r:id="rId13"/>
    <p:sldId id="265" r:id="rId14"/>
    <p:sldId id="294" r:id="rId15"/>
    <p:sldId id="295" r:id="rId16"/>
    <p:sldId id="266" r:id="rId17"/>
    <p:sldId id="257" r:id="rId18"/>
    <p:sldId id="270" r:id="rId19"/>
    <p:sldId id="298" r:id="rId20"/>
    <p:sldId id="260" r:id="rId21"/>
    <p:sldId id="299" r:id="rId22"/>
    <p:sldId id="300" r:id="rId23"/>
    <p:sldId id="301" r:id="rId24"/>
    <p:sldId id="258" r:id="rId25"/>
    <p:sldId id="267" r:id="rId26"/>
    <p:sldId id="268" r:id="rId27"/>
    <p:sldId id="271" r:id="rId28"/>
    <p:sldId id="269" r:id="rId29"/>
    <p:sldId id="302" r:id="rId30"/>
    <p:sldId id="264" r:id="rId31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8" d="100"/>
          <a:sy n="78" d="100"/>
        </p:scale>
        <p:origin x="-264" y="-6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handoutMaster" Target="handoutMasters/handoutMaster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Excel_Worksheet1.xlsx"/></Relationships>
</file>

<file path=ppt/charts/_rels/chart10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7.xml"/><Relationship Id="rId1" Type="http://schemas.openxmlformats.org/officeDocument/2006/relationships/package" Target="../embeddings/Microsoft_Excel_Worksheet10.xlsx"/></Relationships>
</file>

<file path=ppt/charts/_rels/chart1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8.xml"/><Relationship Id="rId1" Type="http://schemas.openxmlformats.org/officeDocument/2006/relationships/package" Target="../embeddings/Microsoft_Excel_Worksheet11.xlsx"/></Relationships>
</file>

<file path=ppt/charts/_rels/chart1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9.xml"/><Relationship Id="rId1" Type="http://schemas.openxmlformats.org/officeDocument/2006/relationships/package" Target="../embeddings/Microsoft_Excel_Worksheet12.xlsx"/></Relationships>
</file>

<file path=ppt/charts/_rels/chart1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0.xml"/><Relationship Id="rId1" Type="http://schemas.openxmlformats.org/officeDocument/2006/relationships/package" Target="../embeddings/Microsoft_Excel_Worksheet13.xlsx"/></Relationships>
</file>

<file path=ppt/charts/_rels/chart1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1.xml"/><Relationship Id="rId1" Type="http://schemas.openxmlformats.org/officeDocument/2006/relationships/package" Target="../embeddings/Microsoft_Excel_Worksheet14.xlsx"/></Relationships>
</file>

<file path=ppt/charts/_rels/chart15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2.xml"/><Relationship Id="rId1" Type="http://schemas.openxmlformats.org/officeDocument/2006/relationships/package" Target="../embeddings/Microsoft_Excel_Worksheet15.xlsx"/></Relationships>
</file>

<file path=ppt/charts/_rels/chart16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3.xml"/><Relationship Id="rId1" Type="http://schemas.openxmlformats.org/officeDocument/2006/relationships/package" Target="../embeddings/Microsoft_Excel_Worksheet16.xlsx"/></Relationships>
</file>

<file path=ppt/charts/_rels/chart17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4.xml"/><Relationship Id="rId1" Type="http://schemas.openxmlformats.org/officeDocument/2006/relationships/package" Target="../embeddings/Microsoft_Excel_Worksheet17.xlsx"/></Relationships>
</file>

<file path=ppt/charts/_rels/chart18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5.xml"/><Relationship Id="rId1" Type="http://schemas.openxmlformats.org/officeDocument/2006/relationships/package" Target="../embeddings/Microsoft_Excel_Worksheet18.xlsx"/></Relationships>
</file>

<file path=ppt/charts/_rels/chart19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6.xml"/><Relationship Id="rId1" Type="http://schemas.openxmlformats.org/officeDocument/2006/relationships/package" Target="../embeddings/Microsoft_Excel_Worksheet19.xlsx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package" Target="../embeddings/Microsoft_Excel_Worksheet2.xlsx"/></Relationships>
</file>

<file path=ppt/charts/_rels/chart20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7.xml"/><Relationship Id="rId1" Type="http://schemas.openxmlformats.org/officeDocument/2006/relationships/package" Target="../embeddings/Microsoft_Excel_Worksheet20.xlsx"/></Relationships>
</file>

<file path=ppt/charts/_rels/chart2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8.xml"/><Relationship Id="rId1" Type="http://schemas.openxmlformats.org/officeDocument/2006/relationships/package" Target="../embeddings/Microsoft_Excel_Worksheet21.xlsx"/></Relationships>
</file>

<file path=ppt/charts/_rels/chart2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9.xml"/><Relationship Id="rId1" Type="http://schemas.openxmlformats.org/officeDocument/2006/relationships/package" Target="../embeddings/Microsoft_Excel_Worksheet22.xlsx"/></Relationships>
</file>

<file path=ppt/charts/_rels/chart2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0.xml"/><Relationship Id="rId1" Type="http://schemas.openxmlformats.org/officeDocument/2006/relationships/package" Target="../embeddings/Microsoft_Excel_Worksheet23.xlsx"/></Relationships>
</file>

<file path=ppt/charts/_rels/chart2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1.xml"/><Relationship Id="rId1" Type="http://schemas.openxmlformats.org/officeDocument/2006/relationships/package" Target="../embeddings/Microsoft_Excel_Worksheet24.xlsx"/></Relationships>
</file>

<file path=ppt/charts/_rels/chart25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2.xml"/><Relationship Id="rId1" Type="http://schemas.openxmlformats.org/officeDocument/2006/relationships/package" Target="../embeddings/Microsoft_Excel_Worksheet25.xlsx"/></Relationships>
</file>

<file path=ppt/charts/_rels/chart26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3.xml"/><Relationship Id="rId1" Type="http://schemas.openxmlformats.org/officeDocument/2006/relationships/package" Target="../embeddings/Microsoft_Excel_Worksheet26.xlsx"/></Relationships>
</file>

<file path=ppt/charts/_rels/chart27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4.xml"/><Relationship Id="rId1" Type="http://schemas.openxmlformats.org/officeDocument/2006/relationships/package" Target="../embeddings/Microsoft_Excel_Worksheet27.xlsx"/></Relationships>
</file>

<file path=ppt/charts/_rels/chart28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5.xml"/><Relationship Id="rId1" Type="http://schemas.openxmlformats.org/officeDocument/2006/relationships/package" Target="../embeddings/Microsoft_Excel_Worksheet28.xlsx"/></Relationships>
</file>

<file path=ppt/charts/_rels/chart29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6.xml"/><Relationship Id="rId1" Type="http://schemas.openxmlformats.org/officeDocument/2006/relationships/package" Target="../embeddings/Microsoft_Excel_Worksheet29.xlsx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package" Target="../embeddings/Microsoft_Excel_Worksheet3.xlsx"/></Relationships>
</file>

<file path=ppt/charts/_rels/chart30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7.xml"/><Relationship Id="rId1" Type="http://schemas.openxmlformats.org/officeDocument/2006/relationships/package" Target="../embeddings/Microsoft_Excel_Worksheet30.xlsx"/></Relationships>
</file>

<file path=ppt/charts/_rels/chart3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8.xml"/><Relationship Id="rId1" Type="http://schemas.openxmlformats.org/officeDocument/2006/relationships/package" Target="../embeddings/Microsoft_Excel_Worksheet31.xlsx"/></Relationships>
</file>

<file path=ppt/charts/_rels/chart3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9.xml"/><Relationship Id="rId1" Type="http://schemas.openxmlformats.org/officeDocument/2006/relationships/package" Target="../embeddings/Microsoft_Excel_Worksheet32.xlsx"/></Relationships>
</file>

<file path=ppt/charts/_rels/chart3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0.xml"/><Relationship Id="rId1" Type="http://schemas.openxmlformats.org/officeDocument/2006/relationships/package" Target="../embeddings/Microsoft_Excel_Worksheet33.xlsx"/></Relationships>
</file>

<file path=ppt/charts/_rels/chart3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4.xlsx"/></Relationships>
</file>

<file path=ppt/charts/_rels/chart3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5.xlsx"/></Relationships>
</file>

<file path=ppt/charts/_rels/chart3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6.xlsx"/></Relationships>
</file>

<file path=ppt/charts/_rels/chart37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7.xlsx"/></Relationships>
</file>

<file path=ppt/charts/_rels/chart38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8.xlsx"/></Relationships>
</file>

<file path=ppt/charts/_rels/chart39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9.xlsx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4.xml"/><Relationship Id="rId1" Type="http://schemas.openxmlformats.org/officeDocument/2006/relationships/package" Target="../embeddings/Microsoft_Excel_Worksheet4.xlsx"/></Relationships>
</file>

<file path=ppt/charts/_rels/chart40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0.xlsx"/></Relationships>
</file>

<file path=ppt/charts/_rels/chart4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1.xlsx"/></Relationships>
</file>

<file path=ppt/charts/_rels/chart4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2.xlsx"/></Relationships>
</file>

<file path=ppt/charts/_rels/chart4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3.xlsx"/></Relationships>
</file>

<file path=ppt/charts/_rels/chart4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4.xlsx"/></Relationships>
</file>

<file path=ppt/charts/_rels/chart4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5.xlsx"/></Relationships>
</file>

<file path=ppt/charts/_rels/chart4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6.xlsx"/></Relationships>
</file>

<file path=ppt/charts/_rels/chart47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7.xlsx"/></Relationships>
</file>

<file path=ppt/charts/_rels/chart48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8.xlsx"/></Relationships>
</file>

<file path=ppt/charts/_rels/chart49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9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5.xlsx"/></Relationships>
</file>

<file path=ppt/charts/_rels/chart50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50.xlsx"/></Relationships>
</file>

<file path=ppt/charts/_rels/chart5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51.xlsx"/></Relationships>
</file>

<file path=ppt/charts/_rels/chart5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52.xlsx"/></Relationships>
</file>

<file path=ppt/charts/_rels/chart5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53.xlsx"/></Relationships>
</file>

<file path=ppt/charts/_rels/chart5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54.xlsx"/></Relationships>
</file>

<file path=ppt/charts/_rels/chart5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55.xlsx"/></Relationships>
</file>

<file path=ppt/charts/_rels/chart5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56.xlsx"/></Relationships>
</file>

<file path=ppt/charts/_rels/chart57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57.xlsx"/></Relationships>
</file>

<file path=ppt/charts/_rels/chart58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58.xlsx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6.xlsx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7.xlsx"/></Relationships>
</file>

<file path=ppt/charts/_rels/chart8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5.xml"/><Relationship Id="rId1" Type="http://schemas.openxmlformats.org/officeDocument/2006/relationships/package" Target="../embeddings/Microsoft_Excel_Worksheet8.xlsx"/></Relationships>
</file>

<file path=ppt/charts/_rels/chart9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6.xml"/><Relationship Id="rId1" Type="http://schemas.openxmlformats.org/officeDocument/2006/relationships/package" Target="../embeddings/Microsoft_Excel_Worksheet9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dirty="0" smtClean="0"/>
              <a:t>Transcript</a:t>
            </a:r>
            <a:r>
              <a:rPr lang="en-US" baseline="0" dirty="0" smtClean="0"/>
              <a:t> ID</a:t>
            </a:r>
            <a:endParaRPr lang="en-US" dirty="0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E$2</c:f>
              <c:strCache>
                <c:ptCount val="1"/>
                <c:pt idx="0">
                  <c:v>AAEL014561-RA</c:v>
                </c:pt>
              </c:strCache>
            </c:strRef>
          </c:tx>
          <c:invertIfNegative val="0"/>
          <c:cat>
            <c:strRef>
              <c:f>Sheet1!$F$1:$AU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F$2:$AU$2</c:f>
              <c:numCache>
                <c:formatCode>General</c:formatCode>
                <c:ptCount val="4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22.691500000000001</c:v>
                </c:pt>
                <c:pt idx="4">
                  <c:v>207.77500000000001</c:v>
                </c:pt>
                <c:pt idx="5">
                  <c:v>63.426299999999998</c:v>
                </c:pt>
                <c:pt idx="6">
                  <c:v>1.85602</c:v>
                </c:pt>
                <c:pt idx="7">
                  <c:v>4.5336600000000002</c:v>
                </c:pt>
                <c:pt idx="8">
                  <c:v>0.18744</c:v>
                </c:pt>
                <c:pt idx="9">
                  <c:v>9.6411800000000006E-2</c:v>
                </c:pt>
                <c:pt idx="10">
                  <c:v>1543</c:v>
                </c:pt>
                <c:pt idx="11">
                  <c:v>40375.300000000003</c:v>
                </c:pt>
                <c:pt idx="12">
                  <c:v>80140.5</c:v>
                </c:pt>
                <c:pt idx="13">
                  <c:v>5.0199299999999996</c:v>
                </c:pt>
                <c:pt idx="14">
                  <c:v>6.1937199999999999</c:v>
                </c:pt>
                <c:pt idx="15">
                  <c:v>0</c:v>
                </c:pt>
                <c:pt idx="16">
                  <c:v>0</c:v>
                </c:pt>
                <c:pt idx="17">
                  <c:v>0.14954500000000001</c:v>
                </c:pt>
                <c:pt idx="18">
                  <c:v>0.24452499999999999</c:v>
                </c:pt>
                <c:pt idx="19">
                  <c:v>0</c:v>
                </c:pt>
                <c:pt idx="20">
                  <c:v>102.054</c:v>
                </c:pt>
                <c:pt idx="21">
                  <c:v>13.739599999999999</c:v>
                </c:pt>
                <c:pt idx="22">
                  <c:v>17.352900000000002</c:v>
                </c:pt>
                <c:pt idx="23">
                  <c:v>0.10421</c:v>
                </c:pt>
                <c:pt idx="24">
                  <c:v>0</c:v>
                </c:pt>
                <c:pt idx="25">
                  <c:v>0</c:v>
                </c:pt>
                <c:pt idx="26">
                  <c:v>19.616700000000002</c:v>
                </c:pt>
                <c:pt idx="27">
                  <c:v>58.690399999999997</c:v>
                </c:pt>
                <c:pt idx="28">
                  <c:v>16.8916</c:v>
                </c:pt>
                <c:pt idx="29">
                  <c:v>2.2621500000000001</c:v>
                </c:pt>
                <c:pt idx="30">
                  <c:v>1.7268300000000001</c:v>
                </c:pt>
                <c:pt idx="31">
                  <c:v>0.41216399999999997</c:v>
                </c:pt>
                <c:pt idx="32">
                  <c:v>17.920999999999999</c:v>
                </c:pt>
                <c:pt idx="33">
                  <c:v>0</c:v>
                </c:pt>
                <c:pt idx="34">
                  <c:v>0.10848099999999999</c:v>
                </c:pt>
                <c:pt idx="35">
                  <c:v>0</c:v>
                </c:pt>
                <c:pt idx="36">
                  <c:v>0.72809500000000005</c:v>
                </c:pt>
                <c:pt idx="37">
                  <c:v>0.38210300000000003</c:v>
                </c:pt>
                <c:pt idx="38">
                  <c:v>5.0009400000000002E-2</c:v>
                </c:pt>
                <c:pt idx="39">
                  <c:v>0.53092099999999998</c:v>
                </c:pt>
                <c:pt idx="40">
                  <c:v>0.10848099999999999</c:v>
                </c:pt>
                <c:pt idx="41">
                  <c:v>1251.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6627072"/>
        <c:axId val="86628992"/>
      </c:barChart>
      <c:catAx>
        <c:axId val="8662707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86628992"/>
        <c:crosses val="autoZero"/>
        <c:auto val="1"/>
        <c:lblAlgn val="ctr"/>
        <c:lblOffset val="100"/>
        <c:noMultiLvlLbl val="0"/>
      </c:catAx>
      <c:valAx>
        <c:axId val="8662899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8662707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A$12</c:f>
              <c:strCache>
                <c:ptCount val="1"/>
                <c:pt idx="0">
                  <c:v>AAEL000796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12:$AQ$12</c:f>
              <c:numCache>
                <c:formatCode>General</c:formatCode>
                <c:ptCount val="42"/>
                <c:pt idx="0">
                  <c:v>9.6144700000000005E-7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17.650600000000001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.22450999999999999</c:v>
                </c:pt>
                <c:pt idx="13">
                  <c:v>346.73399999999998</c:v>
                </c:pt>
                <c:pt idx="14">
                  <c:v>89.9893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2.70444E-2</c:v>
                </c:pt>
                <c:pt idx="20">
                  <c:v>6.7507100000000005E-7</c:v>
                </c:pt>
                <c:pt idx="21">
                  <c:v>1.9401000000000002E-2</c:v>
                </c:pt>
                <c:pt idx="22">
                  <c:v>3.5104699999999998E-7</c:v>
                </c:pt>
                <c:pt idx="23">
                  <c:v>4.2587199999999999E-7</c:v>
                </c:pt>
                <c:pt idx="24">
                  <c:v>8.6185300000000006E-2</c:v>
                </c:pt>
                <c:pt idx="25">
                  <c:v>3.71757E-9</c:v>
                </c:pt>
                <c:pt idx="26">
                  <c:v>9.7458900000000001E-2</c:v>
                </c:pt>
                <c:pt idx="27">
                  <c:v>0</c:v>
                </c:pt>
                <c:pt idx="28">
                  <c:v>0</c:v>
                </c:pt>
                <c:pt idx="29">
                  <c:v>4.2399999999999999E-7</c:v>
                </c:pt>
                <c:pt idx="30">
                  <c:v>0</c:v>
                </c:pt>
                <c:pt idx="31">
                  <c:v>0</c:v>
                </c:pt>
                <c:pt idx="32">
                  <c:v>5.0638199999999996E-7</c:v>
                </c:pt>
                <c:pt idx="33">
                  <c:v>4.7306799999999998E-7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3.1762400000000003E-2</c:v>
                </c:pt>
                <c:pt idx="40">
                  <c:v>0</c:v>
                </c:pt>
                <c:pt idx="41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2777600"/>
        <c:axId val="42779392"/>
      </c:barChart>
      <c:catAx>
        <c:axId val="4277760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42779392"/>
        <c:crosses val="autoZero"/>
        <c:auto val="1"/>
        <c:lblAlgn val="ctr"/>
        <c:lblOffset val="100"/>
        <c:noMultiLvlLbl val="0"/>
      </c:catAx>
      <c:valAx>
        <c:axId val="4277939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4277760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A$14</c:f>
              <c:strCache>
                <c:ptCount val="1"/>
                <c:pt idx="0">
                  <c:v>AAEL000833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14:$AQ$14</c:f>
              <c:numCache>
                <c:formatCode>General</c:formatCode>
                <c:ptCount val="4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6.842830000000000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5.2837500000000003E-2</c:v>
                </c:pt>
                <c:pt idx="13">
                  <c:v>174.87899999999999</c:v>
                </c:pt>
                <c:pt idx="14">
                  <c:v>76.941000000000003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.32767800000000002</c:v>
                </c:pt>
                <c:pt idx="20">
                  <c:v>0</c:v>
                </c:pt>
                <c:pt idx="21">
                  <c:v>9.4027399999999997E-2</c:v>
                </c:pt>
                <c:pt idx="22">
                  <c:v>4.3447699999999999E-2</c:v>
                </c:pt>
                <c:pt idx="23">
                  <c:v>0</c:v>
                </c:pt>
                <c:pt idx="24">
                  <c:v>4.6409899999999997E-2</c:v>
                </c:pt>
                <c:pt idx="25">
                  <c:v>0</c:v>
                </c:pt>
                <c:pt idx="26">
                  <c:v>4.5810999999999998E-2</c:v>
                </c:pt>
                <c:pt idx="27">
                  <c:v>4.5665200000000003E-2</c:v>
                </c:pt>
                <c:pt idx="28">
                  <c:v>0</c:v>
                </c:pt>
                <c:pt idx="29">
                  <c:v>9.6010799999999993E-2</c:v>
                </c:pt>
                <c:pt idx="30">
                  <c:v>0.19333900000000001</c:v>
                </c:pt>
                <c:pt idx="31">
                  <c:v>0.13444200000000001</c:v>
                </c:pt>
                <c:pt idx="32">
                  <c:v>0.21559900000000001</c:v>
                </c:pt>
                <c:pt idx="33">
                  <c:v>5.0352800000000003E-2</c:v>
                </c:pt>
                <c:pt idx="34">
                  <c:v>9.4360399999999997E-2</c:v>
                </c:pt>
                <c:pt idx="35">
                  <c:v>0</c:v>
                </c:pt>
                <c:pt idx="36">
                  <c:v>0</c:v>
                </c:pt>
                <c:pt idx="37">
                  <c:v>0.20718300000000001</c:v>
                </c:pt>
                <c:pt idx="38">
                  <c:v>0</c:v>
                </c:pt>
                <c:pt idx="39">
                  <c:v>0</c:v>
                </c:pt>
                <c:pt idx="40">
                  <c:v>9.4360399999999997E-2</c:v>
                </c:pt>
                <c:pt idx="41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9849472"/>
        <c:axId val="49851392"/>
      </c:barChart>
      <c:catAx>
        <c:axId val="4984947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49851392"/>
        <c:crosses val="autoZero"/>
        <c:auto val="1"/>
        <c:lblAlgn val="ctr"/>
        <c:lblOffset val="100"/>
        <c:noMultiLvlLbl val="0"/>
      </c:catAx>
      <c:valAx>
        <c:axId val="4985139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4984947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11</c:f>
              <c:strCache>
                <c:ptCount val="1"/>
                <c:pt idx="0">
                  <c:v>AAEL000835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11:$AQ$11</c:f>
              <c:numCache>
                <c:formatCode>General</c:formatCode>
                <c:ptCount val="42"/>
                <c:pt idx="0">
                  <c:v>7.8469200000000003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22.335699999999999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.70097500000000001</c:v>
                </c:pt>
                <c:pt idx="13">
                  <c:v>628.66600000000005</c:v>
                </c:pt>
                <c:pt idx="14">
                  <c:v>160.38800000000001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.44995400000000002</c:v>
                </c:pt>
                <c:pt idx="21">
                  <c:v>9.9130599999999999E-2</c:v>
                </c:pt>
                <c:pt idx="22">
                  <c:v>0.24159700000000001</c:v>
                </c:pt>
                <c:pt idx="23">
                  <c:v>0.15639800000000001</c:v>
                </c:pt>
                <c:pt idx="24">
                  <c:v>1.60848E-2</c:v>
                </c:pt>
                <c:pt idx="25">
                  <c:v>3.3351700000000001E-7</c:v>
                </c:pt>
                <c:pt idx="26">
                  <c:v>0.361952</c:v>
                </c:pt>
                <c:pt idx="27">
                  <c:v>0</c:v>
                </c:pt>
                <c:pt idx="28">
                  <c:v>7.6344899999999993E-2</c:v>
                </c:pt>
                <c:pt idx="29">
                  <c:v>0.16561200000000001</c:v>
                </c:pt>
                <c:pt idx="30">
                  <c:v>7.4119000000000004E-2</c:v>
                </c:pt>
                <c:pt idx="31">
                  <c:v>6.8724199999999999E-2</c:v>
                </c:pt>
                <c:pt idx="32">
                  <c:v>0.25830399999999998</c:v>
                </c:pt>
                <c:pt idx="33">
                  <c:v>0.24129200000000001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7.4126899999999996E-2</c:v>
                </c:pt>
                <c:pt idx="39">
                  <c:v>0.214367</c:v>
                </c:pt>
                <c:pt idx="40">
                  <c:v>0</c:v>
                </c:pt>
                <c:pt idx="41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9841280"/>
        <c:axId val="49931776"/>
      </c:barChart>
      <c:catAx>
        <c:axId val="4984128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49931776"/>
        <c:crosses val="autoZero"/>
        <c:auto val="1"/>
        <c:lblAlgn val="ctr"/>
        <c:lblOffset val="100"/>
        <c:noMultiLvlLbl val="0"/>
      </c:catAx>
      <c:valAx>
        <c:axId val="4993177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4984128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15</c:f>
              <c:strCache>
                <c:ptCount val="1"/>
                <c:pt idx="0">
                  <c:v>AAEL000837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15:$AQ$15</c:f>
              <c:numCache>
                <c:formatCode>General</c:formatCode>
                <c:ptCount val="42"/>
                <c:pt idx="0">
                  <c:v>0</c:v>
                </c:pt>
                <c:pt idx="1">
                  <c:v>0.19645699999999999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4.53233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8.6661199999999994E-2</c:v>
                </c:pt>
                <c:pt idx="11">
                  <c:v>0</c:v>
                </c:pt>
                <c:pt idx="12">
                  <c:v>0</c:v>
                </c:pt>
                <c:pt idx="13">
                  <c:v>150.28800000000001</c:v>
                </c:pt>
                <c:pt idx="14">
                  <c:v>50.564700000000002</c:v>
                </c:pt>
                <c:pt idx="15">
                  <c:v>8.4715799999999994E-2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.29554399999999997</c:v>
                </c:pt>
                <c:pt idx="20">
                  <c:v>8.1010799999999994E-2</c:v>
                </c:pt>
                <c:pt idx="21">
                  <c:v>5.3004000000000003E-2</c:v>
                </c:pt>
                <c:pt idx="22">
                  <c:v>9.7967299999999993E-2</c:v>
                </c:pt>
                <c:pt idx="23">
                  <c:v>0</c:v>
                </c:pt>
                <c:pt idx="24">
                  <c:v>0</c:v>
                </c:pt>
                <c:pt idx="25">
                  <c:v>5.8669800000000001E-2</c:v>
                </c:pt>
                <c:pt idx="26">
                  <c:v>5.1648100000000002E-2</c:v>
                </c:pt>
                <c:pt idx="27">
                  <c:v>0.154451</c:v>
                </c:pt>
                <c:pt idx="28">
                  <c:v>0</c:v>
                </c:pt>
                <c:pt idx="29">
                  <c:v>5.4119800000000003E-2</c:v>
                </c:pt>
                <c:pt idx="30">
                  <c:v>0</c:v>
                </c:pt>
                <c:pt idx="31">
                  <c:v>0</c:v>
                </c:pt>
                <c:pt idx="32">
                  <c:v>6.0767500000000002E-2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5.8394500000000002E-2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0108288"/>
        <c:axId val="50109824"/>
      </c:barChart>
      <c:catAx>
        <c:axId val="5010828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50109824"/>
        <c:crosses val="autoZero"/>
        <c:auto val="1"/>
        <c:lblAlgn val="ctr"/>
        <c:lblOffset val="100"/>
        <c:noMultiLvlLbl val="0"/>
      </c:catAx>
      <c:valAx>
        <c:axId val="5010982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5010828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30</c:f>
              <c:strCache>
                <c:ptCount val="1"/>
                <c:pt idx="0">
                  <c:v>AAEL001153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30:$AQ$30</c:f>
              <c:numCache>
                <c:formatCode>General</c:formatCode>
                <c:ptCount val="42"/>
                <c:pt idx="0">
                  <c:v>0</c:v>
                </c:pt>
                <c:pt idx="1">
                  <c:v>0</c:v>
                </c:pt>
                <c:pt idx="2">
                  <c:v>9.3672000000000005E-2</c:v>
                </c:pt>
                <c:pt idx="3">
                  <c:v>0.21800600000000001</c:v>
                </c:pt>
                <c:pt idx="4">
                  <c:v>0</c:v>
                </c:pt>
                <c:pt idx="5">
                  <c:v>0.129723</c:v>
                </c:pt>
                <c:pt idx="6">
                  <c:v>0.142513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6.1040900000000002</c:v>
                </c:pt>
                <c:pt idx="14">
                  <c:v>3.3130099999999998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.122999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0037504"/>
        <c:axId val="50039040"/>
      </c:barChart>
      <c:catAx>
        <c:axId val="5003750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50039040"/>
        <c:crosses val="autoZero"/>
        <c:auto val="1"/>
        <c:lblAlgn val="ctr"/>
        <c:lblOffset val="100"/>
        <c:noMultiLvlLbl val="0"/>
      </c:catAx>
      <c:valAx>
        <c:axId val="5003904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5003750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59</c:f>
              <c:strCache>
                <c:ptCount val="1"/>
                <c:pt idx="0">
                  <c:v>AAEL003315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59:$AQ$59</c:f>
              <c:numCache>
                <c:formatCode>General</c:formatCode>
                <c:ptCount val="4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21.207100000000001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5.6228599999999997E-2</c:v>
                </c:pt>
                <c:pt idx="12">
                  <c:v>0.123296</c:v>
                </c:pt>
                <c:pt idx="13">
                  <c:v>147.34299999999999</c:v>
                </c:pt>
                <c:pt idx="14">
                  <c:v>27.002600000000001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5.3450900000000003E-2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.125777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0158592"/>
        <c:axId val="50168576"/>
      </c:barChart>
      <c:catAx>
        <c:axId val="5015859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50168576"/>
        <c:crosses val="autoZero"/>
        <c:auto val="1"/>
        <c:lblAlgn val="ctr"/>
        <c:lblOffset val="100"/>
        <c:noMultiLvlLbl val="0"/>
      </c:catAx>
      <c:valAx>
        <c:axId val="5016857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5015859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62</c:f>
              <c:strCache>
                <c:ptCount val="1"/>
                <c:pt idx="0">
                  <c:v>AAEL003511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62:$AQ$62</c:f>
              <c:numCache>
                <c:formatCode>General</c:formatCode>
                <c:ptCount val="42"/>
                <c:pt idx="0">
                  <c:v>0</c:v>
                </c:pt>
                <c:pt idx="1">
                  <c:v>0</c:v>
                </c:pt>
                <c:pt idx="2">
                  <c:v>0.106222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53.437100000000001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722.38</c:v>
                </c:pt>
                <c:pt idx="14">
                  <c:v>96.913899999999998</c:v>
                </c:pt>
                <c:pt idx="15">
                  <c:v>9.4647300000000004E-2</c:v>
                </c:pt>
                <c:pt idx="16">
                  <c:v>0</c:v>
                </c:pt>
                <c:pt idx="17">
                  <c:v>0</c:v>
                </c:pt>
                <c:pt idx="18">
                  <c:v>7.53495E-2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5.4726200000000003E-2</c:v>
                </c:pt>
                <c:pt idx="23">
                  <c:v>0</c:v>
                </c:pt>
                <c:pt idx="24">
                  <c:v>5.8452400000000002E-2</c:v>
                </c:pt>
                <c:pt idx="25">
                  <c:v>0</c:v>
                </c:pt>
                <c:pt idx="26">
                  <c:v>0.11540599999999999</c:v>
                </c:pt>
                <c:pt idx="27">
                  <c:v>0.115039</c:v>
                </c:pt>
                <c:pt idx="28">
                  <c:v>0</c:v>
                </c:pt>
                <c:pt idx="29">
                  <c:v>0</c:v>
                </c:pt>
                <c:pt idx="30">
                  <c:v>6.0880200000000002E-2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8.4528800000000001E-2</c:v>
                </c:pt>
                <c:pt idx="36">
                  <c:v>0</c:v>
                </c:pt>
                <c:pt idx="37">
                  <c:v>0</c:v>
                </c:pt>
                <c:pt idx="38">
                  <c:v>6.0886799999999998E-2</c:v>
                </c:pt>
                <c:pt idx="39">
                  <c:v>9.6948699999999999E-2</c:v>
                </c:pt>
                <c:pt idx="40">
                  <c:v>0</c:v>
                </c:pt>
                <c:pt idx="41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0247936"/>
        <c:axId val="50249728"/>
      </c:barChart>
      <c:catAx>
        <c:axId val="5024793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50249728"/>
        <c:crosses val="autoZero"/>
        <c:auto val="1"/>
        <c:lblAlgn val="ctr"/>
        <c:lblOffset val="100"/>
        <c:noMultiLvlLbl val="0"/>
      </c:catAx>
      <c:valAx>
        <c:axId val="50249728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5024793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63</c:f>
              <c:strCache>
                <c:ptCount val="1"/>
                <c:pt idx="0">
                  <c:v>AAEL003513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63:$AQ$63</c:f>
              <c:numCache>
                <c:formatCode>General</c:formatCode>
                <c:ptCount val="42"/>
                <c:pt idx="0">
                  <c:v>7.2780600000000001E-2</c:v>
                </c:pt>
                <c:pt idx="1">
                  <c:v>0.123922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14.2339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736.45100000000002</c:v>
                </c:pt>
                <c:pt idx="14">
                  <c:v>99.224999999999994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.102204</c:v>
                </c:pt>
                <c:pt idx="21">
                  <c:v>6.6870700000000005E-2</c:v>
                </c:pt>
                <c:pt idx="22">
                  <c:v>0.25234400000000001</c:v>
                </c:pt>
                <c:pt idx="23">
                  <c:v>0.20147499999999999</c:v>
                </c:pt>
                <c:pt idx="24">
                  <c:v>0.19800899999999999</c:v>
                </c:pt>
                <c:pt idx="25">
                  <c:v>0.52119800000000005</c:v>
                </c:pt>
                <c:pt idx="26">
                  <c:v>3.2579999999999998E-2</c:v>
                </c:pt>
                <c:pt idx="27">
                  <c:v>0.32476300000000002</c:v>
                </c:pt>
                <c:pt idx="28">
                  <c:v>0.35847699999999999</c:v>
                </c:pt>
                <c:pt idx="29">
                  <c:v>0</c:v>
                </c:pt>
                <c:pt idx="30">
                  <c:v>0.137493</c:v>
                </c:pt>
                <c:pt idx="31">
                  <c:v>0.12748399999999999</c:v>
                </c:pt>
                <c:pt idx="32">
                  <c:v>0.38811699999999999</c:v>
                </c:pt>
                <c:pt idx="33">
                  <c:v>0.292435</c:v>
                </c:pt>
                <c:pt idx="34">
                  <c:v>0.33973199999999998</c:v>
                </c:pt>
                <c:pt idx="35">
                  <c:v>0</c:v>
                </c:pt>
                <c:pt idx="36">
                  <c:v>0</c:v>
                </c:pt>
                <c:pt idx="37">
                  <c:v>7.3668999999999998E-2</c:v>
                </c:pt>
                <c:pt idx="38">
                  <c:v>0</c:v>
                </c:pt>
                <c:pt idx="39">
                  <c:v>0</c:v>
                </c:pt>
                <c:pt idx="40">
                  <c:v>0.33973199999999998</c:v>
                </c:pt>
                <c:pt idx="41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9713536"/>
        <c:axId val="49715072"/>
      </c:barChart>
      <c:catAx>
        <c:axId val="4971353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49715072"/>
        <c:crosses val="autoZero"/>
        <c:auto val="1"/>
        <c:lblAlgn val="ctr"/>
        <c:lblOffset val="100"/>
        <c:noMultiLvlLbl val="0"/>
      </c:catAx>
      <c:valAx>
        <c:axId val="4971507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4971353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73</c:f>
              <c:strCache>
                <c:ptCount val="1"/>
                <c:pt idx="0">
                  <c:v>AAEL003525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73:$AQ$73</c:f>
              <c:numCache>
                <c:formatCode>0.00E+00</c:formatCode>
                <c:ptCount val="42"/>
                <c:pt idx="0" formatCode="General">
                  <c:v>3.5158200000000001E-2</c:v>
                </c:pt>
                <c:pt idx="1">
                  <c:v>3.08817E-128</c:v>
                </c:pt>
                <c:pt idx="2" formatCode="General">
                  <c:v>0</c:v>
                </c:pt>
                <c:pt idx="3" formatCode="General">
                  <c:v>0</c:v>
                </c:pt>
                <c:pt idx="4" formatCode="General">
                  <c:v>0.112775</c:v>
                </c:pt>
                <c:pt idx="5" formatCode="General">
                  <c:v>5.8965900000000002E-2</c:v>
                </c:pt>
                <c:pt idx="6" formatCode="General">
                  <c:v>17.1784</c:v>
                </c:pt>
                <c:pt idx="7" formatCode="General">
                  <c:v>0</c:v>
                </c:pt>
                <c:pt idx="8">
                  <c:v>1.5786300000000001E-76</c:v>
                </c:pt>
                <c:pt idx="9">
                  <c:v>3.7230599999999998E-58</c:v>
                </c:pt>
                <c:pt idx="10" formatCode="General">
                  <c:v>0</c:v>
                </c:pt>
                <c:pt idx="11" formatCode="General">
                  <c:v>5.13932E-2</c:v>
                </c:pt>
                <c:pt idx="12">
                  <c:v>1.5909E-145</c:v>
                </c:pt>
                <c:pt idx="13" formatCode="General">
                  <c:v>846.98599999999999</c:v>
                </c:pt>
                <c:pt idx="14" formatCode="General">
                  <c:v>256.755</c:v>
                </c:pt>
                <c:pt idx="15">
                  <c:v>7.4851399999999995E-196</c:v>
                </c:pt>
                <c:pt idx="16" formatCode="General">
                  <c:v>0</c:v>
                </c:pt>
                <c:pt idx="17" formatCode="General">
                  <c:v>0</c:v>
                </c:pt>
                <c:pt idx="18" formatCode="General">
                  <c:v>0</c:v>
                </c:pt>
                <c:pt idx="19" formatCode="General">
                  <c:v>6.7705600000000005E-2</c:v>
                </c:pt>
                <c:pt idx="20" formatCode="General">
                  <c:v>8.3865400000000007E-2</c:v>
                </c:pt>
                <c:pt idx="21" formatCode="General">
                  <c:v>5.2990700000000002E-2</c:v>
                </c:pt>
                <c:pt idx="22">
                  <c:v>1.45839E-63</c:v>
                </c:pt>
                <c:pt idx="23">
                  <c:v>4.5379900000000002E-80</c:v>
                </c:pt>
                <c:pt idx="24">
                  <c:v>1.5786199999999999E-172</c:v>
                </c:pt>
                <c:pt idx="25" formatCode="General">
                  <c:v>0</c:v>
                </c:pt>
                <c:pt idx="26" formatCode="General">
                  <c:v>5.21275E-2</c:v>
                </c:pt>
                <c:pt idx="27">
                  <c:v>9.3169200000000001E-170</c:v>
                </c:pt>
                <c:pt idx="28">
                  <c:v>1.55249E-123</c:v>
                </c:pt>
                <c:pt idx="29">
                  <c:v>3.2300000000000002E-84</c:v>
                </c:pt>
                <c:pt idx="30">
                  <c:v>2.7619899999999999E-65</c:v>
                </c:pt>
                <c:pt idx="31" formatCode="General">
                  <c:v>9.7439999999999999E-2</c:v>
                </c:pt>
                <c:pt idx="32" formatCode="General">
                  <c:v>0.104265</c:v>
                </c:pt>
                <c:pt idx="33">
                  <c:v>1.47987E-116</c:v>
                </c:pt>
                <c:pt idx="34" formatCode="General">
                  <c:v>0</c:v>
                </c:pt>
                <c:pt idx="35" formatCode="General">
                  <c:v>9.0403600000000001E-2</c:v>
                </c:pt>
                <c:pt idx="36" formatCode="General">
                  <c:v>0</c:v>
                </c:pt>
                <c:pt idx="37" formatCode="General">
                  <c:v>0.20830199999999999</c:v>
                </c:pt>
                <c:pt idx="38">
                  <c:v>8.3054300000000003E-9</c:v>
                </c:pt>
                <c:pt idx="39" formatCode="General">
                  <c:v>0</c:v>
                </c:pt>
                <c:pt idx="40" formatCode="General">
                  <c:v>0</c:v>
                </c:pt>
                <c:pt idx="41" formatCode="General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9638400"/>
        <c:axId val="49660672"/>
      </c:barChart>
      <c:catAx>
        <c:axId val="4963840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49660672"/>
        <c:crosses val="autoZero"/>
        <c:auto val="1"/>
        <c:lblAlgn val="ctr"/>
        <c:lblOffset val="100"/>
        <c:noMultiLvlLbl val="0"/>
      </c:catAx>
      <c:valAx>
        <c:axId val="4966067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4963840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64</c:f>
              <c:strCache>
                <c:ptCount val="1"/>
                <c:pt idx="0">
                  <c:v>AAEL003538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64:$AQ$64</c:f>
              <c:numCache>
                <c:formatCode>General</c:formatCode>
                <c:ptCount val="42"/>
                <c:pt idx="0">
                  <c:v>0.2214270000000000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22.0854</c:v>
                </c:pt>
                <c:pt idx="7">
                  <c:v>3.9778000000000001E-2</c:v>
                </c:pt>
                <c:pt idx="8">
                  <c:v>0</c:v>
                </c:pt>
                <c:pt idx="9">
                  <c:v>8.9605799999999999E-2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736.32</c:v>
                </c:pt>
                <c:pt idx="14">
                  <c:v>99.060100000000006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6.9098900000000005E-2</c:v>
                </c:pt>
                <c:pt idx="21">
                  <c:v>0</c:v>
                </c:pt>
                <c:pt idx="22">
                  <c:v>0.13056599999999999</c:v>
                </c:pt>
                <c:pt idx="23">
                  <c:v>0.13622100000000001</c:v>
                </c:pt>
                <c:pt idx="24">
                  <c:v>0.13389100000000001</c:v>
                </c:pt>
                <c:pt idx="25">
                  <c:v>0.25334699999999999</c:v>
                </c:pt>
                <c:pt idx="26">
                  <c:v>0.13766800000000001</c:v>
                </c:pt>
                <c:pt idx="27">
                  <c:v>0.39522200000000002</c:v>
                </c:pt>
                <c:pt idx="28">
                  <c:v>0.71896300000000002</c:v>
                </c:pt>
                <c:pt idx="29">
                  <c:v>9.2329099999999997E-2</c:v>
                </c:pt>
                <c:pt idx="30">
                  <c:v>0.32536700000000002</c:v>
                </c:pt>
                <c:pt idx="31">
                  <c:v>0.56023699999999999</c:v>
                </c:pt>
                <c:pt idx="32">
                  <c:v>1.34816</c:v>
                </c:pt>
                <c:pt idx="33">
                  <c:v>0.437307</c:v>
                </c:pt>
                <c:pt idx="34">
                  <c:v>0.45496500000000001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.45496500000000001</c:v>
                </c:pt>
                <c:pt idx="41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0300416"/>
        <c:axId val="50301952"/>
      </c:barChart>
      <c:catAx>
        <c:axId val="5030041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50301952"/>
        <c:crosses val="autoZero"/>
        <c:auto val="1"/>
        <c:lblAlgn val="ctr"/>
        <c:lblOffset val="100"/>
        <c:noMultiLvlLbl val="0"/>
      </c:catAx>
      <c:valAx>
        <c:axId val="5030195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5030041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E$2</c:f>
              <c:strCache>
                <c:ptCount val="1"/>
                <c:pt idx="0">
                  <c:v>AAEL014561-RA</c:v>
                </c:pt>
              </c:strCache>
            </c:strRef>
          </c:tx>
          <c:invertIfNegative val="0"/>
          <c:cat>
            <c:strRef>
              <c:f>Sheet1!$F$1:$AU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F$2:$AU$2</c:f>
              <c:numCache>
                <c:formatCode>General</c:formatCode>
                <c:ptCount val="4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22.691500000000001</c:v>
                </c:pt>
                <c:pt idx="4">
                  <c:v>207.77500000000001</c:v>
                </c:pt>
                <c:pt idx="5">
                  <c:v>63.426299999999998</c:v>
                </c:pt>
                <c:pt idx="6">
                  <c:v>1.85602</c:v>
                </c:pt>
                <c:pt idx="7">
                  <c:v>4.5336600000000002</c:v>
                </c:pt>
                <c:pt idx="8">
                  <c:v>0.18744</c:v>
                </c:pt>
                <c:pt idx="9">
                  <c:v>9.6411800000000006E-2</c:v>
                </c:pt>
                <c:pt idx="10">
                  <c:v>1543</c:v>
                </c:pt>
                <c:pt idx="11">
                  <c:v>40375.300000000003</c:v>
                </c:pt>
                <c:pt idx="12">
                  <c:v>80140.5</c:v>
                </c:pt>
                <c:pt idx="13">
                  <c:v>5.0199299999999996</c:v>
                </c:pt>
                <c:pt idx="14">
                  <c:v>6.1937199999999999</c:v>
                </c:pt>
                <c:pt idx="15">
                  <c:v>0</c:v>
                </c:pt>
                <c:pt idx="16">
                  <c:v>0</c:v>
                </c:pt>
                <c:pt idx="17">
                  <c:v>0.14954500000000001</c:v>
                </c:pt>
                <c:pt idx="18">
                  <c:v>0.24452499999999999</c:v>
                </c:pt>
                <c:pt idx="19">
                  <c:v>0</c:v>
                </c:pt>
                <c:pt idx="20">
                  <c:v>102.054</c:v>
                </c:pt>
                <c:pt idx="21">
                  <c:v>13.739599999999999</c:v>
                </c:pt>
                <c:pt idx="22">
                  <c:v>17.352900000000002</c:v>
                </c:pt>
                <c:pt idx="23">
                  <c:v>0.10421</c:v>
                </c:pt>
                <c:pt idx="24">
                  <c:v>0</c:v>
                </c:pt>
                <c:pt idx="25">
                  <c:v>0</c:v>
                </c:pt>
                <c:pt idx="26">
                  <c:v>19.616700000000002</c:v>
                </c:pt>
                <c:pt idx="27">
                  <c:v>58.690399999999997</c:v>
                </c:pt>
                <c:pt idx="28">
                  <c:v>16.8916</c:v>
                </c:pt>
                <c:pt idx="29">
                  <c:v>2.2621500000000001</c:v>
                </c:pt>
                <c:pt idx="30">
                  <c:v>1.7268300000000001</c:v>
                </c:pt>
                <c:pt idx="31">
                  <c:v>0.41216399999999997</c:v>
                </c:pt>
                <c:pt idx="32">
                  <c:v>17.920999999999999</c:v>
                </c:pt>
                <c:pt idx="33">
                  <c:v>0</c:v>
                </c:pt>
                <c:pt idx="34">
                  <c:v>0.10848099999999999</c:v>
                </c:pt>
                <c:pt idx="35">
                  <c:v>0</c:v>
                </c:pt>
                <c:pt idx="36">
                  <c:v>0.72809500000000005</c:v>
                </c:pt>
                <c:pt idx="37">
                  <c:v>0.38210300000000003</c:v>
                </c:pt>
                <c:pt idx="38">
                  <c:v>5.0009400000000002E-2</c:v>
                </c:pt>
                <c:pt idx="39">
                  <c:v>0.53092099999999998</c:v>
                </c:pt>
                <c:pt idx="40">
                  <c:v>0.10848099999999999</c:v>
                </c:pt>
                <c:pt idx="41">
                  <c:v>1251.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2306176"/>
        <c:axId val="62307712"/>
      </c:barChart>
      <c:catAx>
        <c:axId val="6230617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62307712"/>
        <c:crosses val="autoZero"/>
        <c:auto val="1"/>
        <c:lblAlgn val="ctr"/>
        <c:lblOffset val="100"/>
        <c:noMultiLvlLbl val="0"/>
      </c:catAx>
      <c:valAx>
        <c:axId val="6230771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6230617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5</c:f>
              <c:strCache>
                <c:ptCount val="1"/>
                <c:pt idx="0">
                  <c:v>AAEL004856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5:$AQ$5</c:f>
              <c:numCache>
                <c:formatCode>General</c:formatCode>
                <c:ptCount val="42"/>
                <c:pt idx="0">
                  <c:v>0</c:v>
                </c:pt>
                <c:pt idx="1">
                  <c:v>0</c:v>
                </c:pt>
                <c:pt idx="2">
                  <c:v>0.114191</c:v>
                </c:pt>
                <c:pt idx="3">
                  <c:v>0</c:v>
                </c:pt>
                <c:pt idx="4">
                  <c:v>0</c:v>
                </c:pt>
                <c:pt idx="5">
                  <c:v>0.158139</c:v>
                </c:pt>
                <c:pt idx="6">
                  <c:v>5.7908500000000002E-2</c:v>
                </c:pt>
                <c:pt idx="7">
                  <c:v>0.28003099999999997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423.22899999999998</c:v>
                </c:pt>
                <c:pt idx="14">
                  <c:v>336.26100000000002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5.8831500000000002E-2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.185503</c:v>
                </c:pt>
                <c:pt idx="28">
                  <c:v>6.7410700000000004E-2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1889792"/>
        <c:axId val="41892864"/>
      </c:barChart>
      <c:catAx>
        <c:axId val="4188979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41892864"/>
        <c:crosses val="autoZero"/>
        <c:auto val="1"/>
        <c:lblAlgn val="ctr"/>
        <c:lblOffset val="100"/>
        <c:noMultiLvlLbl val="0"/>
      </c:catAx>
      <c:valAx>
        <c:axId val="4189286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4188979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25</c:f>
              <c:strCache>
                <c:ptCount val="1"/>
                <c:pt idx="0">
                  <c:v>AAEL006385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25:$AQ$25</c:f>
              <c:numCache>
                <c:formatCode>General</c:formatCode>
                <c:ptCount val="4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5.9881400000000001E-2</c:v>
                </c:pt>
                <c:pt idx="4">
                  <c:v>3.2270800000000002E-2</c:v>
                </c:pt>
                <c:pt idx="5">
                  <c:v>0</c:v>
                </c:pt>
                <c:pt idx="6">
                  <c:v>140.50299999999999</c:v>
                </c:pt>
                <c:pt idx="7">
                  <c:v>0</c:v>
                </c:pt>
                <c:pt idx="8">
                  <c:v>9.9488599999999996E-2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.14508399999999999</c:v>
                </c:pt>
                <c:pt idx="13">
                  <c:v>3296.34</c:v>
                </c:pt>
                <c:pt idx="14">
                  <c:v>1046.58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5.5908300000000001E-2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1.96624E-2</c:v>
                </c:pt>
                <c:pt idx="31">
                  <c:v>0</c:v>
                </c:pt>
                <c:pt idx="32">
                  <c:v>3.2890000000000003E-2</c:v>
                </c:pt>
                <c:pt idx="33">
                  <c:v>0</c:v>
                </c:pt>
                <c:pt idx="34">
                  <c:v>0</c:v>
                </c:pt>
                <c:pt idx="35">
                  <c:v>0.232961</c:v>
                </c:pt>
                <c:pt idx="36">
                  <c:v>6.7569500000000005E-2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4.2067199999999999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2541440"/>
        <c:axId val="42543360"/>
      </c:barChart>
      <c:catAx>
        <c:axId val="4254144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42543360"/>
        <c:crosses val="autoZero"/>
        <c:auto val="1"/>
        <c:lblAlgn val="ctr"/>
        <c:lblOffset val="100"/>
        <c:noMultiLvlLbl val="0"/>
      </c:catAx>
      <c:valAx>
        <c:axId val="4254336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4254144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2"/>
          <c:order val="0"/>
          <c:tx>
            <c:strRef>
              <c:f>Sheet1!$A$23</c:f>
              <c:strCache>
                <c:ptCount val="1"/>
                <c:pt idx="0">
                  <c:v>AAEL006387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23:$AQ$23</c:f>
              <c:numCache>
                <c:formatCode>General</c:formatCode>
                <c:ptCount val="42"/>
                <c:pt idx="0">
                  <c:v>0.144175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3.2089099999999999E-67</c:v>
                </c:pt>
                <c:pt idx="5">
                  <c:v>0</c:v>
                </c:pt>
                <c:pt idx="6">
                  <c:v>115.193</c:v>
                </c:pt>
                <c:pt idx="7">
                  <c:v>1.1958799999999999E-44</c:v>
                </c:pt>
                <c:pt idx="8">
                  <c:v>0</c:v>
                </c:pt>
                <c:pt idx="9">
                  <c:v>0</c:v>
                </c:pt>
                <c:pt idx="10">
                  <c:v>3.28041E-24</c:v>
                </c:pt>
                <c:pt idx="11">
                  <c:v>3.9865900000000003E-2</c:v>
                </c:pt>
                <c:pt idx="12">
                  <c:v>1.4536100000000001</c:v>
                </c:pt>
                <c:pt idx="13">
                  <c:v>2737.6</c:v>
                </c:pt>
                <c:pt idx="14">
                  <c:v>870.94200000000001</c:v>
                </c:pt>
                <c:pt idx="15">
                  <c:v>0.10349700000000001</c:v>
                </c:pt>
                <c:pt idx="16">
                  <c:v>0</c:v>
                </c:pt>
                <c:pt idx="17">
                  <c:v>6.9636199999999999E-18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8.4112800000000005E-12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6.3317200000000004E-2</c:v>
                </c:pt>
                <c:pt idx="27">
                  <c:v>0.166962</c:v>
                </c:pt>
                <c:pt idx="28">
                  <c:v>2.6137300000000001E-33</c:v>
                </c:pt>
                <c:pt idx="29">
                  <c:v>5.7065699999999997E-2</c:v>
                </c:pt>
                <c:pt idx="30">
                  <c:v>5.5440999999999997E-2</c:v>
                </c:pt>
                <c:pt idx="31">
                  <c:v>0</c:v>
                </c:pt>
                <c:pt idx="32">
                  <c:v>5.5219800000000005E-20</c:v>
                </c:pt>
                <c:pt idx="33">
                  <c:v>0.208537</c:v>
                </c:pt>
                <c:pt idx="34">
                  <c:v>1.0904399999999999E-11</c:v>
                </c:pt>
                <c:pt idx="35">
                  <c:v>0.31840200000000002</c:v>
                </c:pt>
                <c:pt idx="36">
                  <c:v>2.8190699999999999E-13</c:v>
                </c:pt>
                <c:pt idx="37">
                  <c:v>5.7959299999999998E-31</c:v>
                </c:pt>
                <c:pt idx="38">
                  <c:v>3.1336300000000002E-46</c:v>
                </c:pt>
                <c:pt idx="39">
                  <c:v>0</c:v>
                </c:pt>
                <c:pt idx="40">
                  <c:v>1.0904399999999999E-11</c:v>
                </c:pt>
                <c:pt idx="41">
                  <c:v>0.330025999999999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1563264"/>
        <c:axId val="41564800"/>
      </c:barChart>
      <c:catAx>
        <c:axId val="4156326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41564800"/>
        <c:crosses val="autoZero"/>
        <c:auto val="1"/>
        <c:lblAlgn val="ctr"/>
        <c:lblOffset val="100"/>
        <c:noMultiLvlLbl val="0"/>
      </c:catAx>
      <c:valAx>
        <c:axId val="4156480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4156326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21</c:f>
              <c:strCache>
                <c:ptCount val="1"/>
                <c:pt idx="0">
                  <c:v>AAEL006393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21:$AQ$21</c:f>
              <c:numCache>
                <c:formatCode>General</c:formatCode>
                <c:ptCount val="42"/>
                <c:pt idx="0">
                  <c:v>6.1691200000000003E-24</c:v>
                </c:pt>
                <c:pt idx="1">
                  <c:v>7.6488199999999995E-219</c:v>
                </c:pt>
                <c:pt idx="2">
                  <c:v>0</c:v>
                </c:pt>
                <c:pt idx="3">
                  <c:v>3.1315400000000001E-105</c:v>
                </c:pt>
                <c:pt idx="4">
                  <c:v>1.59226E-4</c:v>
                </c:pt>
                <c:pt idx="5">
                  <c:v>1.2974999999999999E-177</c:v>
                </c:pt>
                <c:pt idx="6">
                  <c:v>109.70399999999999</c:v>
                </c:pt>
                <c:pt idx="7">
                  <c:v>3.9305599999999999E-5</c:v>
                </c:pt>
                <c:pt idx="8">
                  <c:v>9.3058600000000002E-145</c:v>
                </c:pt>
                <c:pt idx="9">
                  <c:v>0</c:v>
                </c:pt>
                <c:pt idx="10">
                  <c:v>1.2321199999999999E-74</c:v>
                </c:pt>
                <c:pt idx="11">
                  <c:v>1.55235E-289</c:v>
                </c:pt>
                <c:pt idx="12">
                  <c:v>0.34396100000000002</c:v>
                </c:pt>
                <c:pt idx="13">
                  <c:v>2179.15</c:v>
                </c:pt>
                <c:pt idx="14">
                  <c:v>743.94899999999996</c:v>
                </c:pt>
                <c:pt idx="15">
                  <c:v>1.4097E-154</c:v>
                </c:pt>
                <c:pt idx="16">
                  <c:v>0</c:v>
                </c:pt>
                <c:pt idx="17">
                  <c:v>9.8787299999999997E-36</c:v>
                </c:pt>
                <c:pt idx="18">
                  <c:v>7.0700200000000005E-2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1.8786400000000001E-15</c:v>
                </c:pt>
                <c:pt idx="23">
                  <c:v>0</c:v>
                </c:pt>
                <c:pt idx="24">
                  <c:v>2.4029300000000001E-37</c:v>
                </c:pt>
                <c:pt idx="25">
                  <c:v>1.9590100000000002E-220</c:v>
                </c:pt>
                <c:pt idx="26">
                  <c:v>2.9823899999999999E-30</c:v>
                </c:pt>
                <c:pt idx="27">
                  <c:v>0.308027</c:v>
                </c:pt>
                <c:pt idx="28">
                  <c:v>0.29104600000000003</c:v>
                </c:pt>
                <c:pt idx="29">
                  <c:v>0.206537</c:v>
                </c:pt>
                <c:pt idx="30">
                  <c:v>3.3670499999999998E-64</c:v>
                </c:pt>
                <c:pt idx="31">
                  <c:v>7.0241700000000004E-12</c:v>
                </c:pt>
                <c:pt idx="32">
                  <c:v>0.35037000000000001</c:v>
                </c:pt>
                <c:pt idx="33">
                  <c:v>1.17656E-23</c:v>
                </c:pt>
                <c:pt idx="34">
                  <c:v>6.91664E-10</c:v>
                </c:pt>
                <c:pt idx="35">
                  <c:v>1.1631100000000001</c:v>
                </c:pt>
                <c:pt idx="36">
                  <c:v>0.56551300000000004</c:v>
                </c:pt>
                <c:pt idx="37">
                  <c:v>0.20293700000000001</c:v>
                </c:pt>
                <c:pt idx="38">
                  <c:v>9.4100900000000001E-2</c:v>
                </c:pt>
                <c:pt idx="39">
                  <c:v>0</c:v>
                </c:pt>
                <c:pt idx="40">
                  <c:v>6.91664E-10</c:v>
                </c:pt>
                <c:pt idx="41">
                  <c:v>8.91288E-17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1745024"/>
        <c:axId val="41746816"/>
      </c:barChart>
      <c:catAx>
        <c:axId val="4174502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41746816"/>
        <c:crosses val="autoZero"/>
        <c:auto val="1"/>
        <c:lblAlgn val="ctr"/>
        <c:lblOffset val="100"/>
        <c:noMultiLvlLbl val="0"/>
      </c:catAx>
      <c:valAx>
        <c:axId val="4174681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4174502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72</c:f>
              <c:strCache>
                <c:ptCount val="1"/>
                <c:pt idx="0">
                  <c:v>AAEL006396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72:$AQ$72</c:f>
              <c:numCache>
                <c:formatCode>General</c:formatCode>
                <c:ptCount val="4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6.6414600000000004E-2</c:v>
                </c:pt>
                <c:pt idx="6">
                  <c:v>175.304</c:v>
                </c:pt>
                <c:pt idx="7">
                  <c:v>4.7044799999999998E-2</c:v>
                </c:pt>
                <c:pt idx="8">
                  <c:v>0</c:v>
                </c:pt>
                <c:pt idx="9">
                  <c:v>0.105979</c:v>
                </c:pt>
                <c:pt idx="10">
                  <c:v>0.19670799999999999</c:v>
                </c:pt>
                <c:pt idx="11">
                  <c:v>0.383683</c:v>
                </c:pt>
                <c:pt idx="12">
                  <c:v>1.0817000000000001</c:v>
                </c:pt>
                <c:pt idx="13">
                  <c:v>3273.86</c:v>
                </c:pt>
                <c:pt idx="14">
                  <c:v>882.69899999999996</c:v>
                </c:pt>
                <c:pt idx="15">
                  <c:v>8.5463200000000003E-2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2.4707900000000001E-2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5.2103700000000003E-2</c:v>
                </c:pt>
                <c:pt idx="27">
                  <c:v>0</c:v>
                </c:pt>
                <c:pt idx="28">
                  <c:v>0</c:v>
                </c:pt>
                <c:pt idx="29">
                  <c:v>2.72985E-2</c:v>
                </c:pt>
                <c:pt idx="30">
                  <c:v>4.5811200000000003E-2</c:v>
                </c:pt>
                <c:pt idx="31">
                  <c:v>5.0969899999999999E-2</c:v>
                </c:pt>
                <c:pt idx="32">
                  <c:v>0</c:v>
                </c:pt>
                <c:pt idx="33">
                  <c:v>5.72685E-2</c:v>
                </c:pt>
                <c:pt idx="34">
                  <c:v>2.68305E-2</c:v>
                </c:pt>
                <c:pt idx="35">
                  <c:v>0.141347</c:v>
                </c:pt>
                <c:pt idx="36">
                  <c:v>3.1486E-2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2.68305E-2</c:v>
                </c:pt>
                <c:pt idx="41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1749888"/>
        <c:axId val="47782912"/>
      </c:barChart>
      <c:catAx>
        <c:axId val="4174988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47782912"/>
        <c:crosses val="autoZero"/>
        <c:auto val="1"/>
        <c:lblAlgn val="ctr"/>
        <c:lblOffset val="100"/>
        <c:noMultiLvlLbl val="0"/>
      </c:catAx>
      <c:valAx>
        <c:axId val="4778291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4174988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A$24</c:f>
              <c:strCache>
                <c:ptCount val="1"/>
                <c:pt idx="0">
                  <c:v>AAEL006398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24:$AQ$24</c:f>
              <c:numCache>
                <c:formatCode>General</c:formatCode>
                <c:ptCount val="42"/>
                <c:pt idx="0">
                  <c:v>0</c:v>
                </c:pt>
                <c:pt idx="1">
                  <c:v>9.7256599999999999E-2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6.5182400000000001E-2</c:v>
                </c:pt>
                <c:pt idx="6">
                  <c:v>40.1965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.21518200000000001</c:v>
                </c:pt>
                <c:pt idx="12">
                  <c:v>1.1795899999999999</c:v>
                </c:pt>
                <c:pt idx="13">
                  <c:v>773.02</c:v>
                </c:pt>
                <c:pt idx="14">
                  <c:v>326.71300000000002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5.1137000000000002E-2</c:v>
                </c:pt>
                <c:pt idx="27">
                  <c:v>5.09743E-2</c:v>
                </c:pt>
                <c:pt idx="28">
                  <c:v>0</c:v>
                </c:pt>
                <c:pt idx="29">
                  <c:v>0.214338</c:v>
                </c:pt>
                <c:pt idx="30">
                  <c:v>0.37767600000000001</c:v>
                </c:pt>
                <c:pt idx="31">
                  <c:v>0.35016999999999998</c:v>
                </c:pt>
                <c:pt idx="32">
                  <c:v>0.24066499999999999</c:v>
                </c:pt>
                <c:pt idx="33">
                  <c:v>5.6206199999999998E-2</c:v>
                </c:pt>
                <c:pt idx="34">
                  <c:v>5.2665400000000001E-2</c:v>
                </c:pt>
                <c:pt idx="35">
                  <c:v>0</c:v>
                </c:pt>
                <c:pt idx="36">
                  <c:v>0</c:v>
                </c:pt>
                <c:pt idx="37">
                  <c:v>5.7816800000000002E-2</c:v>
                </c:pt>
                <c:pt idx="38">
                  <c:v>0.75543199999999999</c:v>
                </c:pt>
                <c:pt idx="39">
                  <c:v>0.51550300000000004</c:v>
                </c:pt>
                <c:pt idx="40">
                  <c:v>5.2665400000000001E-2</c:v>
                </c:pt>
                <c:pt idx="41">
                  <c:v>0.692587999999999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1036416"/>
        <c:axId val="101039104"/>
      </c:barChart>
      <c:catAx>
        <c:axId val="10103641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01039104"/>
        <c:crosses val="autoZero"/>
        <c:auto val="1"/>
        <c:lblAlgn val="ctr"/>
        <c:lblOffset val="100"/>
        <c:noMultiLvlLbl val="0"/>
      </c:catAx>
      <c:valAx>
        <c:axId val="10103910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0103641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32</c:f>
              <c:strCache>
                <c:ptCount val="1"/>
                <c:pt idx="0">
                  <c:v>AAEL009433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32:$AQ$32</c:f>
              <c:numCache>
                <c:formatCode>General</c:formatCode>
                <c:ptCount val="4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3.2011100000000001E-2</c:v>
                </c:pt>
                <c:pt idx="5">
                  <c:v>3.5345300000000003E-2</c:v>
                </c:pt>
                <c:pt idx="6">
                  <c:v>6.93757</c:v>
                </c:pt>
                <c:pt idx="7">
                  <c:v>0.112664</c:v>
                </c:pt>
                <c:pt idx="8">
                  <c:v>0</c:v>
                </c:pt>
                <c:pt idx="9">
                  <c:v>0.79432100000000005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994.90300000000002</c:v>
                </c:pt>
                <c:pt idx="14">
                  <c:v>703.29399999999998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3.6209199999999997E-2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3.0477600000000001E-2</c:v>
                </c:pt>
                <c:pt idx="34">
                  <c:v>2.8557900000000001E-2</c:v>
                </c:pt>
                <c:pt idx="35">
                  <c:v>0</c:v>
                </c:pt>
                <c:pt idx="36">
                  <c:v>3.3512899999999998E-2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2.8557900000000001E-2</c:v>
                </c:pt>
                <c:pt idx="41">
                  <c:v>0.18777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2019840"/>
        <c:axId val="102022528"/>
      </c:barChart>
      <c:catAx>
        <c:axId val="10201984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02022528"/>
        <c:crosses val="autoZero"/>
        <c:auto val="1"/>
        <c:lblAlgn val="ctr"/>
        <c:lblOffset val="100"/>
        <c:noMultiLvlLbl val="0"/>
      </c:catAx>
      <c:valAx>
        <c:axId val="102022528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0201984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33</c:f>
              <c:strCache>
                <c:ptCount val="1"/>
                <c:pt idx="0">
                  <c:v>AAEL009599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33:$AQ$33</c:f>
              <c:numCache>
                <c:formatCode>General</c:formatCode>
                <c:ptCount val="4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5.7249300000000003E-2</c:v>
                </c:pt>
                <c:pt idx="4">
                  <c:v>0</c:v>
                </c:pt>
                <c:pt idx="5">
                  <c:v>0</c:v>
                </c:pt>
                <c:pt idx="6">
                  <c:v>28.1431</c:v>
                </c:pt>
                <c:pt idx="7">
                  <c:v>4.8260900000000002E-2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.36988799999999999</c:v>
                </c:pt>
                <c:pt idx="13">
                  <c:v>1422.96</c:v>
                </c:pt>
                <c:pt idx="14">
                  <c:v>569.18100000000004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.109708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5.3450900000000003E-2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.54389299999999996</c:v>
                </c:pt>
                <c:pt idx="38">
                  <c:v>0.225603</c:v>
                </c:pt>
                <c:pt idx="39">
                  <c:v>0</c:v>
                </c:pt>
                <c:pt idx="40">
                  <c:v>0</c:v>
                </c:pt>
                <c:pt idx="41">
                  <c:v>0.24130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2359808"/>
        <c:axId val="102361728"/>
      </c:barChart>
      <c:catAx>
        <c:axId val="10235980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02361728"/>
        <c:crosses val="autoZero"/>
        <c:auto val="1"/>
        <c:lblAlgn val="ctr"/>
        <c:lblOffset val="100"/>
        <c:noMultiLvlLbl val="0"/>
      </c:catAx>
      <c:valAx>
        <c:axId val="102361728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0235980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34</c:f>
              <c:strCache>
                <c:ptCount val="1"/>
                <c:pt idx="0">
                  <c:v>AAEL010718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34:$AQ$34</c:f>
              <c:numCache>
                <c:formatCode>General</c:formatCode>
                <c:ptCount val="4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.42177900000000002</c:v>
                </c:pt>
                <c:pt idx="7">
                  <c:v>4.0789600000000002E-2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172.86099999999999</c:v>
                </c:pt>
                <c:pt idx="14">
                  <c:v>116.36499999999999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4.4200900000000001E-2</c:v>
                </c:pt>
                <c:pt idx="32">
                  <c:v>5.31622E-2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3876864"/>
        <c:axId val="103912960"/>
      </c:barChart>
      <c:catAx>
        <c:axId val="10387686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03912960"/>
        <c:crosses val="autoZero"/>
        <c:auto val="1"/>
        <c:lblAlgn val="ctr"/>
        <c:lblOffset val="100"/>
        <c:noMultiLvlLbl val="0"/>
      </c:catAx>
      <c:valAx>
        <c:axId val="10391296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0387686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36</c:f>
              <c:strCache>
                <c:ptCount val="1"/>
                <c:pt idx="0">
                  <c:v>AAEL010872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36:$AQ$36</c:f>
              <c:numCache>
                <c:formatCode>General</c:formatCode>
                <c:ptCount val="4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251.07499999999999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.10144499999999999</c:v>
                </c:pt>
                <c:pt idx="12">
                  <c:v>0.55609900000000001</c:v>
                </c:pt>
                <c:pt idx="13">
                  <c:v>6267.71</c:v>
                </c:pt>
                <c:pt idx="14">
                  <c:v>1498.95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.113456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5.8272600000000001E-2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4139904"/>
        <c:axId val="134142208"/>
      </c:barChart>
      <c:catAx>
        <c:axId val="13413990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34142208"/>
        <c:crosses val="autoZero"/>
        <c:auto val="1"/>
        <c:lblAlgn val="ctr"/>
        <c:lblOffset val="100"/>
        <c:noMultiLvlLbl val="0"/>
      </c:catAx>
      <c:valAx>
        <c:axId val="134142208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3413990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58</c:f>
              <c:strCache>
                <c:ptCount val="1"/>
                <c:pt idx="0">
                  <c:v>AAEL013027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58:$AQ$58</c:f>
              <c:numCache>
                <c:formatCode>General</c:formatCode>
                <c:ptCount val="4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26.879300000000001</c:v>
                </c:pt>
                <c:pt idx="4">
                  <c:v>153.39699999999999</c:v>
                </c:pt>
                <c:pt idx="5">
                  <c:v>73.153700000000001</c:v>
                </c:pt>
                <c:pt idx="6">
                  <c:v>3.7331799999999999</c:v>
                </c:pt>
                <c:pt idx="7">
                  <c:v>4.6932799999999997</c:v>
                </c:pt>
                <c:pt idx="8">
                  <c:v>0</c:v>
                </c:pt>
                <c:pt idx="9">
                  <c:v>0</c:v>
                </c:pt>
                <c:pt idx="10">
                  <c:v>63.023499999999999</c:v>
                </c:pt>
                <c:pt idx="11">
                  <c:v>31912.7</c:v>
                </c:pt>
                <c:pt idx="12">
                  <c:v>86182.2</c:v>
                </c:pt>
                <c:pt idx="13">
                  <c:v>58.048900000000003</c:v>
                </c:pt>
                <c:pt idx="14">
                  <c:v>44.9651</c:v>
                </c:pt>
                <c:pt idx="15">
                  <c:v>0.49199599999999999</c:v>
                </c:pt>
                <c:pt idx="16">
                  <c:v>0</c:v>
                </c:pt>
                <c:pt idx="17">
                  <c:v>0.14194999999999999</c:v>
                </c:pt>
                <c:pt idx="18">
                  <c:v>0</c:v>
                </c:pt>
                <c:pt idx="19">
                  <c:v>0</c:v>
                </c:pt>
                <c:pt idx="20">
                  <c:v>96.447999999999993</c:v>
                </c:pt>
                <c:pt idx="21">
                  <c:v>16.1096</c:v>
                </c:pt>
                <c:pt idx="22">
                  <c:v>18.0169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24.995899999999999</c:v>
                </c:pt>
                <c:pt idx="27">
                  <c:v>74.649500000000003</c:v>
                </c:pt>
                <c:pt idx="28">
                  <c:v>19.883700000000001</c:v>
                </c:pt>
                <c:pt idx="29">
                  <c:v>0.10473300000000001</c:v>
                </c:pt>
                <c:pt idx="30">
                  <c:v>0</c:v>
                </c:pt>
                <c:pt idx="31">
                  <c:v>0</c:v>
                </c:pt>
                <c:pt idx="32">
                  <c:v>19.645499999999998</c:v>
                </c:pt>
                <c:pt idx="33">
                  <c:v>0</c:v>
                </c:pt>
                <c:pt idx="34">
                  <c:v>0.10297199999999999</c:v>
                </c:pt>
                <c:pt idx="35">
                  <c:v>0</c:v>
                </c:pt>
                <c:pt idx="36">
                  <c:v>0.84577599999999997</c:v>
                </c:pt>
                <c:pt idx="37">
                  <c:v>0.339092</c:v>
                </c:pt>
                <c:pt idx="38">
                  <c:v>0.10549</c:v>
                </c:pt>
                <c:pt idx="39">
                  <c:v>0.167986</c:v>
                </c:pt>
                <c:pt idx="40">
                  <c:v>0.10297199999999999</c:v>
                </c:pt>
                <c:pt idx="41">
                  <c:v>1235.4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2001152"/>
        <c:axId val="62002688"/>
      </c:barChart>
      <c:catAx>
        <c:axId val="6200115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62002688"/>
        <c:crosses val="autoZero"/>
        <c:auto val="1"/>
        <c:lblAlgn val="ctr"/>
        <c:lblOffset val="100"/>
        <c:noMultiLvlLbl val="0"/>
      </c:catAx>
      <c:valAx>
        <c:axId val="62002688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6200115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>
        <c:manualLayout>
          <c:layoutTarget val="inner"/>
          <c:xMode val="edge"/>
          <c:yMode val="edge"/>
          <c:x val="6.5577792359288428E-2"/>
          <c:y val="0.21795166229221347"/>
          <c:w val="0.9106113298337708"/>
          <c:h val="0.40143336249635464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Sheet1!$A$42</c:f>
              <c:strCache>
                <c:ptCount val="1"/>
                <c:pt idx="0">
                  <c:v>AAEL011483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42:$AQ$42</c:f>
              <c:numCache>
                <c:formatCode>General</c:formatCode>
                <c:ptCount val="4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.37730900000000001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8.3165199999999994E-5</c:v>
                </c:pt>
                <c:pt idx="8">
                  <c:v>0</c:v>
                </c:pt>
                <c:pt idx="9">
                  <c:v>3.09451E-2</c:v>
                </c:pt>
                <c:pt idx="10">
                  <c:v>0.16419</c:v>
                </c:pt>
                <c:pt idx="11">
                  <c:v>0.20581199999999999</c:v>
                </c:pt>
                <c:pt idx="12">
                  <c:v>1.0320400000000001E-6</c:v>
                </c:pt>
                <c:pt idx="13">
                  <c:v>0.348547</c:v>
                </c:pt>
                <c:pt idx="14">
                  <c:v>0.47192600000000001</c:v>
                </c:pt>
                <c:pt idx="15">
                  <c:v>0</c:v>
                </c:pt>
                <c:pt idx="16">
                  <c:v>0.58246500000000001</c:v>
                </c:pt>
                <c:pt idx="17">
                  <c:v>0</c:v>
                </c:pt>
                <c:pt idx="18">
                  <c:v>0.51111700000000004</c:v>
                </c:pt>
                <c:pt idx="19">
                  <c:v>0.139987</c:v>
                </c:pt>
                <c:pt idx="20">
                  <c:v>0.75117400000000001</c:v>
                </c:pt>
                <c:pt idx="21">
                  <c:v>0.62764299999999995</c:v>
                </c:pt>
                <c:pt idx="22">
                  <c:v>0.46403</c:v>
                </c:pt>
                <c:pt idx="23">
                  <c:v>0.51633499999999999</c:v>
                </c:pt>
                <c:pt idx="24">
                  <c:v>6.2512099999999997E-30</c:v>
                </c:pt>
                <c:pt idx="25">
                  <c:v>0</c:v>
                </c:pt>
                <c:pt idx="26">
                  <c:v>0.29356199999999999</c:v>
                </c:pt>
                <c:pt idx="27">
                  <c:v>0.32511299999999999</c:v>
                </c:pt>
                <c:pt idx="28">
                  <c:v>6.4834000000000005E-7</c:v>
                </c:pt>
                <c:pt idx="29">
                  <c:v>0</c:v>
                </c:pt>
                <c:pt idx="30">
                  <c:v>0</c:v>
                </c:pt>
                <c:pt idx="31">
                  <c:v>0.24087900000000001</c:v>
                </c:pt>
                <c:pt idx="32">
                  <c:v>2.2005699999999999</c:v>
                </c:pt>
                <c:pt idx="33">
                  <c:v>3.1127699999999998</c:v>
                </c:pt>
                <c:pt idx="34">
                  <c:v>11.6686</c:v>
                </c:pt>
                <c:pt idx="35">
                  <c:v>3.1798299999999999</c:v>
                </c:pt>
                <c:pt idx="36">
                  <c:v>7.06637</c:v>
                </c:pt>
                <c:pt idx="37">
                  <c:v>35.872</c:v>
                </c:pt>
                <c:pt idx="38">
                  <c:v>10.5441</c:v>
                </c:pt>
                <c:pt idx="39">
                  <c:v>6.3191600000000001</c:v>
                </c:pt>
                <c:pt idx="40">
                  <c:v>11.6686</c:v>
                </c:pt>
                <c:pt idx="41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5516928"/>
        <c:axId val="135518464"/>
      </c:barChart>
      <c:catAx>
        <c:axId val="13551692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35518464"/>
        <c:crosses val="autoZero"/>
        <c:auto val="1"/>
        <c:lblAlgn val="ctr"/>
        <c:lblOffset val="100"/>
        <c:noMultiLvlLbl val="0"/>
      </c:catAx>
      <c:valAx>
        <c:axId val="13551846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3551692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3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69</c:f>
              <c:strCache>
                <c:ptCount val="1"/>
                <c:pt idx="0">
                  <c:v>AAEL013719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69:$AQ$69</c:f>
              <c:numCache>
                <c:formatCode>General</c:formatCode>
                <c:ptCount val="4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.66655900000000001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5.1469000000000001E-2</c:v>
                </c:pt>
                <c:pt idx="13">
                  <c:v>2.0144600000000001</c:v>
                </c:pt>
                <c:pt idx="14">
                  <c:v>0.26901599999999998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4090112"/>
        <c:axId val="134100096"/>
      </c:barChart>
      <c:catAx>
        <c:axId val="13409011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34100096"/>
        <c:crosses val="autoZero"/>
        <c:auto val="1"/>
        <c:lblAlgn val="ctr"/>
        <c:lblOffset val="100"/>
        <c:noMultiLvlLbl val="0"/>
      </c:catAx>
      <c:valAx>
        <c:axId val="13410009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3409011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3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A$4</c:f>
              <c:strCache>
                <c:ptCount val="1"/>
                <c:pt idx="0">
                  <c:v>AAEL014876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4:$AQ$4</c:f>
              <c:numCache>
                <c:formatCode>General</c:formatCode>
                <c:ptCount val="4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7.12642E-2</c:v>
                </c:pt>
                <c:pt idx="6">
                  <c:v>16.127600000000001</c:v>
                </c:pt>
                <c:pt idx="7">
                  <c:v>0</c:v>
                </c:pt>
                <c:pt idx="8">
                  <c:v>0</c:v>
                </c:pt>
                <c:pt idx="9">
                  <c:v>0.113718</c:v>
                </c:pt>
                <c:pt idx="10">
                  <c:v>0</c:v>
                </c:pt>
                <c:pt idx="11">
                  <c:v>0</c:v>
                </c:pt>
                <c:pt idx="12">
                  <c:v>0.128964</c:v>
                </c:pt>
                <c:pt idx="13">
                  <c:v>2411.58</c:v>
                </c:pt>
                <c:pt idx="14">
                  <c:v>1890.94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5.7376099999999999E-2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5.8582200000000001E-2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5.75793E-2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5.75793E-2</c:v>
                </c:pt>
                <c:pt idx="41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4195456"/>
        <c:axId val="134213632"/>
      </c:barChart>
      <c:catAx>
        <c:axId val="13419545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34213632"/>
        <c:crosses val="autoZero"/>
        <c:auto val="1"/>
        <c:lblAlgn val="ctr"/>
        <c:lblOffset val="100"/>
        <c:noMultiLvlLbl val="0"/>
      </c:catAx>
      <c:valAx>
        <c:axId val="13421363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3419545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3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68</c:f>
              <c:strCache>
                <c:ptCount val="1"/>
                <c:pt idx="0">
                  <c:v>AAEL013720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68:$AQ$68</c:f>
              <c:numCache>
                <c:formatCode>General</c:formatCode>
                <c:ptCount val="4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1.4653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7.0091900000000003</c:v>
                </c:pt>
                <c:pt idx="14">
                  <c:v>1.2868900000000001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6.2585399999999999E-2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.12932299999999999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.12932299999999999</c:v>
                </c:pt>
                <c:pt idx="41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4836608"/>
        <c:axId val="134838144"/>
      </c:barChart>
      <c:catAx>
        <c:axId val="13483660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34838144"/>
        <c:crosses val="autoZero"/>
        <c:auto val="1"/>
        <c:lblAlgn val="ctr"/>
        <c:lblOffset val="100"/>
        <c:noMultiLvlLbl val="0"/>
      </c:catAx>
      <c:valAx>
        <c:axId val="13483814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3483660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3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52</c:f>
              <c:strCache>
                <c:ptCount val="1"/>
                <c:pt idx="0">
                  <c:v>AAEL000302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52:$AQ$52</c:f>
              <c:numCache>
                <c:formatCode>General</c:formatCode>
                <c:ptCount val="42"/>
                <c:pt idx="0">
                  <c:v>2.9071899999999998E-8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34.330500000000001</c:v>
                </c:pt>
                <c:pt idx="8">
                  <c:v>2.0686499999999999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22353.3</c:v>
                </c:pt>
                <c:pt idx="14">
                  <c:v>25699.200000000001</c:v>
                </c:pt>
                <c:pt idx="15">
                  <c:v>55.116500000000002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.6730709999999999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2476544"/>
        <c:axId val="92478464"/>
      </c:barChart>
      <c:catAx>
        <c:axId val="9247654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92478464"/>
        <c:crosses val="autoZero"/>
        <c:auto val="1"/>
        <c:lblAlgn val="ctr"/>
        <c:lblOffset val="100"/>
        <c:noMultiLvlLbl val="0"/>
      </c:catAx>
      <c:valAx>
        <c:axId val="9247846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9247654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3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55</c:f>
              <c:strCache>
                <c:ptCount val="1"/>
                <c:pt idx="0">
                  <c:v>AAEL000317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55:$AQ$55</c:f>
              <c:numCache>
                <c:formatCode>General</c:formatCode>
                <c:ptCount val="42"/>
                <c:pt idx="0">
                  <c:v>29.509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.300126</c:v>
                </c:pt>
                <c:pt idx="5">
                  <c:v>0</c:v>
                </c:pt>
                <c:pt idx="6">
                  <c:v>0.84904400000000002</c:v>
                </c:pt>
                <c:pt idx="7">
                  <c:v>22.460899999999999</c:v>
                </c:pt>
                <c:pt idx="8">
                  <c:v>7.9785399999999997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2.7990200000000001E-7</c:v>
                </c:pt>
                <c:pt idx="13">
                  <c:v>8274.9</c:v>
                </c:pt>
                <c:pt idx="14">
                  <c:v>11889</c:v>
                </c:pt>
                <c:pt idx="15">
                  <c:v>175.81100000000001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.26680500000000001</c:v>
                </c:pt>
                <c:pt idx="22">
                  <c:v>5.3872799999999998E-2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.141261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.45678999999999997</c:v>
                </c:pt>
                <c:pt idx="36">
                  <c:v>0.418736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5463296"/>
        <c:axId val="135464832"/>
      </c:barChart>
      <c:catAx>
        <c:axId val="13546329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35464832"/>
        <c:crosses val="autoZero"/>
        <c:auto val="1"/>
        <c:lblAlgn val="ctr"/>
        <c:lblOffset val="100"/>
        <c:noMultiLvlLbl val="0"/>
      </c:catAx>
      <c:valAx>
        <c:axId val="13546483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3546329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3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44</c:f>
              <c:strCache>
                <c:ptCount val="1"/>
                <c:pt idx="0">
                  <c:v>AAEL000333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44:$AQ$44</c:f>
              <c:numCache>
                <c:formatCode>General</c:formatCode>
                <c:ptCount val="42"/>
                <c:pt idx="0">
                  <c:v>0</c:v>
                </c:pt>
                <c:pt idx="1">
                  <c:v>0.157999</c:v>
                </c:pt>
                <c:pt idx="2">
                  <c:v>0</c:v>
                </c:pt>
                <c:pt idx="3">
                  <c:v>0.29659999999999997</c:v>
                </c:pt>
                <c:pt idx="4">
                  <c:v>0</c:v>
                </c:pt>
                <c:pt idx="5">
                  <c:v>1.41192E-2</c:v>
                </c:pt>
                <c:pt idx="6">
                  <c:v>2.9421799999999999E-42</c:v>
                </c:pt>
                <c:pt idx="7">
                  <c:v>6.38605</c:v>
                </c:pt>
                <c:pt idx="8">
                  <c:v>2.9874700000000001E-2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1977.22</c:v>
                </c:pt>
                <c:pt idx="14">
                  <c:v>2668.27</c:v>
                </c:pt>
                <c:pt idx="15">
                  <c:v>0.116451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.130326</c:v>
                </c:pt>
                <c:pt idx="33">
                  <c:v>0</c:v>
                </c:pt>
                <c:pt idx="34">
                  <c:v>0.101507</c:v>
                </c:pt>
                <c:pt idx="35">
                  <c:v>0.146038</c:v>
                </c:pt>
                <c:pt idx="36">
                  <c:v>0.26774399999999998</c:v>
                </c:pt>
                <c:pt idx="37">
                  <c:v>0</c:v>
                </c:pt>
                <c:pt idx="38">
                  <c:v>5.8440199999999998E-2</c:v>
                </c:pt>
                <c:pt idx="39">
                  <c:v>0</c:v>
                </c:pt>
                <c:pt idx="40">
                  <c:v>0.101507</c:v>
                </c:pt>
                <c:pt idx="41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2466176"/>
        <c:axId val="134898432"/>
      </c:barChart>
      <c:catAx>
        <c:axId val="9246617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34898432"/>
        <c:crosses val="autoZero"/>
        <c:auto val="1"/>
        <c:lblAlgn val="ctr"/>
        <c:lblOffset val="100"/>
        <c:noMultiLvlLbl val="0"/>
      </c:catAx>
      <c:valAx>
        <c:axId val="13489843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9246617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3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53</c:f>
              <c:strCache>
                <c:ptCount val="1"/>
                <c:pt idx="0">
                  <c:v>AAEL000361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53:$AQ$53</c:f>
              <c:numCache>
                <c:formatCode>General</c:formatCode>
                <c:ptCount val="42"/>
                <c:pt idx="0">
                  <c:v>14.808199999999999</c:v>
                </c:pt>
                <c:pt idx="1">
                  <c:v>2.9998300000000002</c:v>
                </c:pt>
                <c:pt idx="2">
                  <c:v>5.22973</c:v>
                </c:pt>
                <c:pt idx="3">
                  <c:v>0.338092</c:v>
                </c:pt>
                <c:pt idx="4">
                  <c:v>1.4576100000000001</c:v>
                </c:pt>
                <c:pt idx="5">
                  <c:v>3.6212300000000002</c:v>
                </c:pt>
                <c:pt idx="6">
                  <c:v>5.5954899999999999</c:v>
                </c:pt>
                <c:pt idx="7">
                  <c:v>38.997799999999998</c:v>
                </c:pt>
                <c:pt idx="8">
                  <c:v>6.7405799999999996</c:v>
                </c:pt>
                <c:pt idx="9">
                  <c:v>0.64205500000000004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14690.1</c:v>
                </c:pt>
                <c:pt idx="14">
                  <c:v>19370.099999999999</c:v>
                </c:pt>
                <c:pt idx="15">
                  <c:v>60.578099999999999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1.5783</c:v>
                </c:pt>
                <c:pt idx="27">
                  <c:v>2.8319000000000001</c:v>
                </c:pt>
                <c:pt idx="28">
                  <c:v>1.71516</c:v>
                </c:pt>
                <c:pt idx="29">
                  <c:v>2.31107</c:v>
                </c:pt>
                <c:pt idx="30">
                  <c:v>3.3283499999999999</c:v>
                </c:pt>
                <c:pt idx="31">
                  <c:v>6.1758199999999999</c:v>
                </c:pt>
                <c:pt idx="32">
                  <c:v>8.9134799999999998</c:v>
                </c:pt>
                <c:pt idx="33">
                  <c:v>5.2009600000000002</c:v>
                </c:pt>
                <c:pt idx="34">
                  <c:v>6.8269799999999998</c:v>
                </c:pt>
                <c:pt idx="35">
                  <c:v>0.23106099999999999</c:v>
                </c:pt>
                <c:pt idx="36">
                  <c:v>0.76252299999999995</c:v>
                </c:pt>
                <c:pt idx="37">
                  <c:v>5.7066600000000003</c:v>
                </c:pt>
                <c:pt idx="38">
                  <c:v>6.9902899999999999</c:v>
                </c:pt>
                <c:pt idx="39">
                  <c:v>6.8945600000000002</c:v>
                </c:pt>
                <c:pt idx="40">
                  <c:v>6.8269799999999998</c:v>
                </c:pt>
                <c:pt idx="41">
                  <c:v>0.950049000000000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5648000"/>
        <c:axId val="135649536"/>
      </c:barChart>
      <c:catAx>
        <c:axId val="13564800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35649536"/>
        <c:crosses val="autoZero"/>
        <c:auto val="1"/>
        <c:lblAlgn val="ctr"/>
        <c:lblOffset val="100"/>
        <c:noMultiLvlLbl val="0"/>
      </c:catAx>
      <c:valAx>
        <c:axId val="13564953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3564800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3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56</c:f>
              <c:strCache>
                <c:ptCount val="1"/>
                <c:pt idx="0">
                  <c:v>AAEL000363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56:$AQ$56</c:f>
              <c:numCache>
                <c:formatCode>General</c:formatCode>
                <c:ptCount val="42"/>
                <c:pt idx="0">
                  <c:v>5.8505900000000004</c:v>
                </c:pt>
                <c:pt idx="1">
                  <c:v>0</c:v>
                </c:pt>
                <c:pt idx="2">
                  <c:v>0</c:v>
                </c:pt>
                <c:pt idx="3">
                  <c:v>0.133577</c:v>
                </c:pt>
                <c:pt idx="4">
                  <c:v>0</c:v>
                </c:pt>
                <c:pt idx="5">
                  <c:v>0.158969</c:v>
                </c:pt>
                <c:pt idx="6">
                  <c:v>0</c:v>
                </c:pt>
                <c:pt idx="7">
                  <c:v>7.9922000000000004</c:v>
                </c:pt>
                <c:pt idx="8">
                  <c:v>1.3315699999999999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2465.5</c:v>
                </c:pt>
                <c:pt idx="14">
                  <c:v>3517.79</c:v>
                </c:pt>
                <c:pt idx="15">
                  <c:v>26.3886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9.1331899999999994E-2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5711744"/>
        <c:axId val="135725824"/>
      </c:barChart>
      <c:catAx>
        <c:axId val="13571174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35725824"/>
        <c:crosses val="autoZero"/>
        <c:auto val="1"/>
        <c:lblAlgn val="ctr"/>
        <c:lblOffset val="100"/>
        <c:noMultiLvlLbl val="0"/>
      </c:catAx>
      <c:valAx>
        <c:axId val="13572582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3571174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3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46</c:f>
              <c:strCache>
                <c:ptCount val="1"/>
                <c:pt idx="0">
                  <c:v>AAEL000369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46:$AQ$46</c:f>
              <c:numCache>
                <c:formatCode>General</c:formatCode>
                <c:ptCount val="4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.30277999999999999</c:v>
                </c:pt>
                <c:pt idx="4">
                  <c:v>0</c:v>
                </c:pt>
                <c:pt idx="5">
                  <c:v>0.108101</c:v>
                </c:pt>
                <c:pt idx="6">
                  <c:v>7.2959800000000005E-2</c:v>
                </c:pt>
                <c:pt idx="7">
                  <c:v>1.3326</c:v>
                </c:pt>
                <c:pt idx="8">
                  <c:v>7.4939900000000003E-8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567.48199999999997</c:v>
                </c:pt>
                <c:pt idx="14">
                  <c:v>1086.99</c:v>
                </c:pt>
                <c:pt idx="15">
                  <c:v>1.7619100000000001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.75826499999999997</c:v>
                </c:pt>
                <c:pt idx="20">
                  <c:v>0.133021</c:v>
                </c:pt>
                <c:pt idx="21">
                  <c:v>0.26110100000000003</c:v>
                </c:pt>
                <c:pt idx="22">
                  <c:v>7.4077299999999996E-7</c:v>
                </c:pt>
                <c:pt idx="23">
                  <c:v>8.3907499999999996E-2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4.6079299999999997E-2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.127622999999999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6401280"/>
        <c:axId val="136402816"/>
      </c:barChart>
      <c:catAx>
        <c:axId val="13640128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36402816"/>
        <c:crosses val="autoZero"/>
        <c:auto val="1"/>
        <c:lblAlgn val="ctr"/>
        <c:lblOffset val="100"/>
        <c:noMultiLvlLbl val="0"/>
      </c:catAx>
      <c:valAx>
        <c:axId val="13640281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3640128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57</c:f>
              <c:strCache>
                <c:ptCount val="1"/>
                <c:pt idx="0">
                  <c:v>AAEL017403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57:$AQ$57</c:f>
              <c:numCache>
                <c:formatCode>General</c:formatCode>
                <c:ptCount val="4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53.973399999999998</c:v>
                </c:pt>
                <c:pt idx="4">
                  <c:v>828.35500000000002</c:v>
                </c:pt>
                <c:pt idx="5">
                  <c:v>191.601</c:v>
                </c:pt>
                <c:pt idx="6">
                  <c:v>20.889800000000001</c:v>
                </c:pt>
                <c:pt idx="7">
                  <c:v>10.0932</c:v>
                </c:pt>
                <c:pt idx="8">
                  <c:v>0</c:v>
                </c:pt>
                <c:pt idx="9">
                  <c:v>0</c:v>
                </c:pt>
                <c:pt idx="10">
                  <c:v>6673.27</c:v>
                </c:pt>
                <c:pt idx="11">
                  <c:v>92097.5</c:v>
                </c:pt>
                <c:pt idx="12">
                  <c:v>186450</c:v>
                </c:pt>
                <c:pt idx="13">
                  <c:v>188.77699999999999</c:v>
                </c:pt>
                <c:pt idx="14">
                  <c:v>81.529499999999999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1.2323</c:v>
                </c:pt>
                <c:pt idx="20">
                  <c:v>212.803</c:v>
                </c:pt>
                <c:pt idx="21">
                  <c:v>38.012900000000002</c:v>
                </c:pt>
                <c:pt idx="22">
                  <c:v>43.299300000000002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55.13</c:v>
                </c:pt>
                <c:pt idx="27">
                  <c:v>160.14099999999999</c:v>
                </c:pt>
                <c:pt idx="28">
                  <c:v>47.741300000000003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37.499600000000001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5.2008000000000001</c:v>
                </c:pt>
                <c:pt idx="37">
                  <c:v>0.97306000000000004</c:v>
                </c:pt>
                <c:pt idx="38">
                  <c:v>1.3622099999999999</c:v>
                </c:pt>
                <c:pt idx="39">
                  <c:v>0</c:v>
                </c:pt>
                <c:pt idx="40">
                  <c:v>0</c:v>
                </c:pt>
                <c:pt idx="41">
                  <c:v>1748.7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2534016"/>
        <c:axId val="42535552"/>
      </c:barChart>
      <c:catAx>
        <c:axId val="4253401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42535552"/>
        <c:crosses val="autoZero"/>
        <c:auto val="1"/>
        <c:lblAlgn val="ctr"/>
        <c:lblOffset val="100"/>
        <c:noMultiLvlLbl val="0"/>
      </c:catAx>
      <c:valAx>
        <c:axId val="4253555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4253401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4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51</c:f>
              <c:strCache>
                <c:ptCount val="1"/>
                <c:pt idx="0">
                  <c:v>AAEL000375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51:$AQ$51</c:f>
              <c:numCache>
                <c:formatCode>General</c:formatCode>
                <c:ptCount val="4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3.9819499999999999</c:v>
                </c:pt>
                <c:pt idx="7">
                  <c:v>5.2209000000000003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.23150200000000001</c:v>
                </c:pt>
                <c:pt idx="12">
                  <c:v>0</c:v>
                </c:pt>
                <c:pt idx="13">
                  <c:v>6506.32</c:v>
                </c:pt>
                <c:pt idx="14">
                  <c:v>3740.92</c:v>
                </c:pt>
                <c:pt idx="15">
                  <c:v>2.6537799999999998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1.89327</c:v>
                </c:pt>
                <c:pt idx="40">
                  <c:v>0</c:v>
                </c:pt>
                <c:pt idx="41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7251456"/>
        <c:axId val="137257344"/>
      </c:barChart>
      <c:catAx>
        <c:axId val="13725145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37257344"/>
        <c:crosses val="autoZero"/>
        <c:auto val="1"/>
        <c:lblAlgn val="ctr"/>
        <c:lblOffset val="100"/>
        <c:noMultiLvlLbl val="0"/>
      </c:catAx>
      <c:valAx>
        <c:axId val="13725734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3725145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4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7</c:f>
              <c:strCache>
                <c:ptCount val="1"/>
                <c:pt idx="0">
                  <c:v>AAEL005090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7:$AQ$7</c:f>
              <c:numCache>
                <c:formatCode>General</c:formatCode>
                <c:ptCount val="42"/>
                <c:pt idx="0">
                  <c:v>0.74031199999999997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9.5643000000000006E-2</c:v>
                </c:pt>
                <c:pt idx="5">
                  <c:v>0</c:v>
                </c:pt>
                <c:pt idx="6">
                  <c:v>0</c:v>
                </c:pt>
                <c:pt idx="7">
                  <c:v>4.1882099999999998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2288.63</c:v>
                </c:pt>
                <c:pt idx="14">
                  <c:v>2334.9899999999998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.18006800000000001</c:v>
                </c:pt>
                <c:pt idx="29">
                  <c:v>0.390349</c:v>
                </c:pt>
                <c:pt idx="30">
                  <c:v>1.0573999999999999</c:v>
                </c:pt>
                <c:pt idx="31">
                  <c:v>3.24187</c:v>
                </c:pt>
                <c:pt idx="32">
                  <c:v>5.4605800000000002</c:v>
                </c:pt>
                <c:pt idx="33">
                  <c:v>1.4631000000000001</c:v>
                </c:pt>
                <c:pt idx="34">
                  <c:v>1.0239100000000001</c:v>
                </c:pt>
                <c:pt idx="35">
                  <c:v>0.121334</c:v>
                </c:pt>
                <c:pt idx="36">
                  <c:v>0.62564699999999995</c:v>
                </c:pt>
                <c:pt idx="37">
                  <c:v>0.18729199999999999</c:v>
                </c:pt>
                <c:pt idx="38">
                  <c:v>8.7398000000000003E-2</c:v>
                </c:pt>
                <c:pt idx="39">
                  <c:v>0</c:v>
                </c:pt>
                <c:pt idx="40">
                  <c:v>1.0239100000000001</c:v>
                </c:pt>
                <c:pt idx="41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2225920"/>
        <c:axId val="92227456"/>
      </c:barChart>
      <c:catAx>
        <c:axId val="9222592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92227456"/>
        <c:crosses val="autoZero"/>
        <c:auto val="1"/>
        <c:lblAlgn val="ctr"/>
        <c:lblOffset val="100"/>
        <c:noMultiLvlLbl val="0"/>
      </c:catAx>
      <c:valAx>
        <c:axId val="9222745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9222592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A$6</c:f>
              <c:strCache>
                <c:ptCount val="1"/>
                <c:pt idx="0">
                  <c:v>AAEL005098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6:$AQ$6</c:f>
              <c:numCache>
                <c:formatCode>General</c:formatCode>
                <c:ptCount val="42"/>
                <c:pt idx="0">
                  <c:v>6.2484099999999998</c:v>
                </c:pt>
                <c:pt idx="1">
                  <c:v>0.220525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.80032800000000004</c:v>
                </c:pt>
                <c:pt idx="7">
                  <c:v>10.991899999999999</c:v>
                </c:pt>
                <c:pt idx="8">
                  <c:v>14.652799999999999</c:v>
                </c:pt>
                <c:pt idx="9">
                  <c:v>1.8676699999999999E-6</c:v>
                </c:pt>
                <c:pt idx="10">
                  <c:v>0</c:v>
                </c:pt>
                <c:pt idx="11">
                  <c:v>0.27340300000000001</c:v>
                </c:pt>
                <c:pt idx="12">
                  <c:v>0.89155799999999996</c:v>
                </c:pt>
                <c:pt idx="13">
                  <c:v>6968.33</c:v>
                </c:pt>
                <c:pt idx="14">
                  <c:v>8108.35</c:v>
                </c:pt>
                <c:pt idx="15">
                  <c:v>596.71600000000001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.18189900000000001</c:v>
                </c:pt>
                <c:pt idx="21">
                  <c:v>0</c:v>
                </c:pt>
                <c:pt idx="22">
                  <c:v>0.109986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2318336"/>
        <c:axId val="92328320"/>
      </c:barChart>
      <c:catAx>
        <c:axId val="9231833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92328320"/>
        <c:crosses val="autoZero"/>
        <c:auto val="1"/>
        <c:lblAlgn val="ctr"/>
        <c:lblOffset val="100"/>
        <c:noMultiLvlLbl val="0"/>
      </c:catAx>
      <c:valAx>
        <c:axId val="9232832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9231833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</c:title>
    <c:autoTitleDeleted val="0"/>
    <c:plotArea>
      <c:layout>
        <c:manualLayout>
          <c:layoutTarget val="inner"/>
          <c:xMode val="edge"/>
          <c:yMode val="edge"/>
          <c:x val="6.7783731894624277E-2"/>
          <c:y val="0.12535906969962088"/>
          <c:w val="0.9106113298337708"/>
          <c:h val="0.40143336249635464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Sheet1!$A$9</c:f>
              <c:strCache>
                <c:ptCount val="1"/>
                <c:pt idx="0">
                  <c:v>AAEL005487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9:$AQ$9</c:f>
              <c:numCache>
                <c:formatCode>General</c:formatCode>
                <c:ptCount val="42"/>
                <c:pt idx="0">
                  <c:v>0.59755899999999995</c:v>
                </c:pt>
                <c:pt idx="1">
                  <c:v>0.49433100000000002</c:v>
                </c:pt>
                <c:pt idx="2">
                  <c:v>0.87603900000000001</c:v>
                </c:pt>
                <c:pt idx="3">
                  <c:v>0.67961099999999997</c:v>
                </c:pt>
                <c:pt idx="4">
                  <c:v>0.13734399999999999</c:v>
                </c:pt>
                <c:pt idx="5">
                  <c:v>0.40750399999999998</c:v>
                </c:pt>
                <c:pt idx="6">
                  <c:v>0.58977000000000002</c:v>
                </c:pt>
                <c:pt idx="7">
                  <c:v>9.7665600000000001</c:v>
                </c:pt>
                <c:pt idx="8">
                  <c:v>0</c:v>
                </c:pt>
                <c:pt idx="9">
                  <c:v>18.512</c:v>
                </c:pt>
                <c:pt idx="10">
                  <c:v>5.1123000000000003</c:v>
                </c:pt>
                <c:pt idx="11">
                  <c:v>2.7276600000000002</c:v>
                </c:pt>
                <c:pt idx="12">
                  <c:v>4.2235300000000002</c:v>
                </c:pt>
                <c:pt idx="13">
                  <c:v>4949.1899999999996</c:v>
                </c:pt>
                <c:pt idx="14">
                  <c:v>4350.2</c:v>
                </c:pt>
                <c:pt idx="15">
                  <c:v>2.8826399999999999</c:v>
                </c:pt>
                <c:pt idx="16">
                  <c:v>0.89323600000000003</c:v>
                </c:pt>
                <c:pt idx="17">
                  <c:v>2.7949299999999999</c:v>
                </c:pt>
                <c:pt idx="18">
                  <c:v>1.9331100000000001</c:v>
                </c:pt>
                <c:pt idx="19">
                  <c:v>1.38106</c:v>
                </c:pt>
                <c:pt idx="20">
                  <c:v>1.5239799999999999</c:v>
                </c:pt>
                <c:pt idx="21">
                  <c:v>1.55836</c:v>
                </c:pt>
                <c:pt idx="22">
                  <c:v>1.32707</c:v>
                </c:pt>
                <c:pt idx="23">
                  <c:v>0.96122200000000002</c:v>
                </c:pt>
                <c:pt idx="24">
                  <c:v>0</c:v>
                </c:pt>
                <c:pt idx="25">
                  <c:v>0</c:v>
                </c:pt>
                <c:pt idx="26">
                  <c:v>0.63451900000000006</c:v>
                </c:pt>
                <c:pt idx="27">
                  <c:v>0.18412899999999999</c:v>
                </c:pt>
                <c:pt idx="28">
                  <c:v>1.05586</c:v>
                </c:pt>
                <c:pt idx="29">
                  <c:v>0</c:v>
                </c:pt>
                <c:pt idx="30">
                  <c:v>0</c:v>
                </c:pt>
                <c:pt idx="31">
                  <c:v>0.116383</c:v>
                </c:pt>
                <c:pt idx="32">
                  <c:v>4.1799299999999997</c:v>
                </c:pt>
                <c:pt idx="33">
                  <c:v>3.1438100000000002</c:v>
                </c:pt>
                <c:pt idx="34">
                  <c:v>2.88253</c:v>
                </c:pt>
                <c:pt idx="35">
                  <c:v>0.34851300000000002</c:v>
                </c:pt>
                <c:pt idx="36">
                  <c:v>0.57506100000000004</c:v>
                </c:pt>
                <c:pt idx="37">
                  <c:v>1.22963</c:v>
                </c:pt>
                <c:pt idx="38">
                  <c:v>0.78448899999999999</c:v>
                </c:pt>
                <c:pt idx="39">
                  <c:v>2.41866</c:v>
                </c:pt>
                <c:pt idx="40">
                  <c:v>2.88253</c:v>
                </c:pt>
                <c:pt idx="41">
                  <c:v>3.25316999999999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2381568"/>
        <c:axId val="92383104"/>
      </c:barChart>
      <c:catAx>
        <c:axId val="9238156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92383104"/>
        <c:crosses val="autoZero"/>
        <c:auto val="1"/>
        <c:lblAlgn val="ctr"/>
        <c:lblOffset val="100"/>
        <c:noMultiLvlLbl val="0"/>
      </c:catAx>
      <c:valAx>
        <c:axId val="9238310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9238156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66</c:f>
              <c:strCache>
                <c:ptCount val="1"/>
                <c:pt idx="0">
                  <c:v>AAEL000507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66:$AQ$66</c:f>
              <c:numCache>
                <c:formatCode>General</c:formatCode>
                <c:ptCount val="42"/>
                <c:pt idx="0">
                  <c:v>2.1130400000000002E-6</c:v>
                </c:pt>
                <c:pt idx="1">
                  <c:v>2.2608399999999999E-6</c:v>
                </c:pt>
                <c:pt idx="2">
                  <c:v>0</c:v>
                </c:pt>
                <c:pt idx="3">
                  <c:v>1.0187399999999999E-6</c:v>
                </c:pt>
                <c:pt idx="4">
                  <c:v>9.6247500000000005E-7</c:v>
                </c:pt>
                <c:pt idx="5">
                  <c:v>0</c:v>
                </c:pt>
                <c:pt idx="6">
                  <c:v>14.5755</c:v>
                </c:pt>
                <c:pt idx="7">
                  <c:v>6.9609000000000004E-2</c:v>
                </c:pt>
                <c:pt idx="8">
                  <c:v>2.1483299999999998E-6</c:v>
                </c:pt>
                <c:pt idx="9">
                  <c:v>0</c:v>
                </c:pt>
                <c:pt idx="10">
                  <c:v>2.7123100000000001E-6</c:v>
                </c:pt>
                <c:pt idx="11">
                  <c:v>0</c:v>
                </c:pt>
                <c:pt idx="12">
                  <c:v>0</c:v>
                </c:pt>
                <c:pt idx="13">
                  <c:v>261.76400000000001</c:v>
                </c:pt>
                <c:pt idx="14">
                  <c:v>141.17500000000001</c:v>
                </c:pt>
                <c:pt idx="15">
                  <c:v>1.2944499999999999E-6</c:v>
                </c:pt>
                <c:pt idx="16">
                  <c:v>1.87677E-6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9.3600899999999995E-7</c:v>
                </c:pt>
                <c:pt idx="24">
                  <c:v>0</c:v>
                </c:pt>
                <c:pt idx="25">
                  <c:v>0</c:v>
                </c:pt>
                <c:pt idx="26">
                  <c:v>1.6164699999999999E-6</c:v>
                </c:pt>
                <c:pt idx="27">
                  <c:v>9.4288299999999996E-7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9.809420000000001E-7</c:v>
                </c:pt>
                <c:pt idx="33">
                  <c:v>0</c:v>
                </c:pt>
                <c:pt idx="34">
                  <c:v>1.6647900000000001E-6</c:v>
                </c:pt>
                <c:pt idx="35">
                  <c:v>6.1072200000000001E-7</c:v>
                </c:pt>
                <c:pt idx="36">
                  <c:v>1.1432900000000001E-6</c:v>
                </c:pt>
                <c:pt idx="37">
                  <c:v>0</c:v>
                </c:pt>
                <c:pt idx="38">
                  <c:v>0</c:v>
                </c:pt>
                <c:pt idx="39">
                  <c:v>1.5892299999999999E-6</c:v>
                </c:pt>
                <c:pt idx="40">
                  <c:v>1.6647900000000001E-6</c:v>
                </c:pt>
                <c:pt idx="41">
                  <c:v>1.42344E-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3162112"/>
        <c:axId val="93168000"/>
      </c:barChart>
      <c:catAx>
        <c:axId val="9316211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93168000"/>
        <c:crosses val="autoZero"/>
        <c:auto val="1"/>
        <c:lblAlgn val="ctr"/>
        <c:lblOffset val="100"/>
        <c:noMultiLvlLbl val="0"/>
      </c:catAx>
      <c:valAx>
        <c:axId val="9316800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9316211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4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3</c:f>
              <c:strCache>
                <c:ptCount val="1"/>
                <c:pt idx="0">
                  <c:v>AAEL004386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3:$AQ$3</c:f>
              <c:numCache>
                <c:formatCode>General</c:formatCode>
                <c:ptCount val="42"/>
                <c:pt idx="0">
                  <c:v>2.3624100000000001</c:v>
                </c:pt>
                <c:pt idx="1">
                  <c:v>0.64368800000000004</c:v>
                </c:pt>
                <c:pt idx="2">
                  <c:v>1.08389</c:v>
                </c:pt>
                <c:pt idx="3">
                  <c:v>0.27424199999999999</c:v>
                </c:pt>
                <c:pt idx="4">
                  <c:v>5.4306700000000001</c:v>
                </c:pt>
                <c:pt idx="5">
                  <c:v>0.83425800000000006</c:v>
                </c:pt>
                <c:pt idx="6">
                  <c:v>6.3450100000000003</c:v>
                </c:pt>
                <c:pt idx="7">
                  <c:v>1.9722</c:v>
                </c:pt>
                <c:pt idx="8">
                  <c:v>14.846500000000001</c:v>
                </c:pt>
                <c:pt idx="9">
                  <c:v>24.478100000000001</c:v>
                </c:pt>
                <c:pt idx="10">
                  <c:v>534.303</c:v>
                </c:pt>
                <c:pt idx="11">
                  <c:v>480.745</c:v>
                </c:pt>
                <c:pt idx="12">
                  <c:v>478.77199999999999</c:v>
                </c:pt>
                <c:pt idx="13">
                  <c:v>677.86500000000001</c:v>
                </c:pt>
                <c:pt idx="14">
                  <c:v>518.09699999999998</c:v>
                </c:pt>
                <c:pt idx="15">
                  <c:v>596.27499999999998</c:v>
                </c:pt>
                <c:pt idx="16">
                  <c:v>652.60299999999995</c:v>
                </c:pt>
                <c:pt idx="17">
                  <c:v>324.06200000000001</c:v>
                </c:pt>
                <c:pt idx="18">
                  <c:v>188.298</c:v>
                </c:pt>
                <c:pt idx="19">
                  <c:v>160.14599999999999</c:v>
                </c:pt>
                <c:pt idx="20">
                  <c:v>100.983</c:v>
                </c:pt>
                <c:pt idx="21">
                  <c:v>75.764799999999994</c:v>
                </c:pt>
                <c:pt idx="22">
                  <c:v>44.002400000000002</c:v>
                </c:pt>
                <c:pt idx="23">
                  <c:v>38.265599999999999</c:v>
                </c:pt>
                <c:pt idx="24">
                  <c:v>29.391400000000001</c:v>
                </c:pt>
                <c:pt idx="25">
                  <c:v>28.8246</c:v>
                </c:pt>
                <c:pt idx="26">
                  <c:v>32.124400000000001</c:v>
                </c:pt>
                <c:pt idx="27">
                  <c:v>40.732399999999998</c:v>
                </c:pt>
                <c:pt idx="28">
                  <c:v>36.228999999999999</c:v>
                </c:pt>
                <c:pt idx="29">
                  <c:v>17.928100000000001</c:v>
                </c:pt>
                <c:pt idx="30">
                  <c:v>16.149100000000001</c:v>
                </c:pt>
                <c:pt idx="31">
                  <c:v>15.0124</c:v>
                </c:pt>
                <c:pt idx="32">
                  <c:v>21.591899999999999</c:v>
                </c:pt>
                <c:pt idx="33">
                  <c:v>6.8992800000000001</c:v>
                </c:pt>
                <c:pt idx="34">
                  <c:v>5.2606200000000003</c:v>
                </c:pt>
                <c:pt idx="35">
                  <c:v>2.8980200000000001E-2</c:v>
                </c:pt>
                <c:pt idx="36">
                  <c:v>0.90749800000000003</c:v>
                </c:pt>
                <c:pt idx="37">
                  <c:v>2.1538499999999999E-2</c:v>
                </c:pt>
                <c:pt idx="38">
                  <c:v>2.0101500000000001E-2</c:v>
                </c:pt>
                <c:pt idx="39">
                  <c:v>0</c:v>
                </c:pt>
                <c:pt idx="40">
                  <c:v>5.2606200000000003</c:v>
                </c:pt>
                <c:pt idx="41">
                  <c:v>9.40230000000000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2901760"/>
        <c:axId val="92903296"/>
      </c:barChart>
      <c:catAx>
        <c:axId val="9290176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92903296"/>
        <c:crosses val="autoZero"/>
        <c:auto val="1"/>
        <c:lblAlgn val="ctr"/>
        <c:lblOffset val="100"/>
        <c:noMultiLvlLbl val="0"/>
      </c:catAx>
      <c:valAx>
        <c:axId val="9290329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9290176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A$2</c:f>
              <c:strCache>
                <c:ptCount val="1"/>
                <c:pt idx="0">
                  <c:v>AAEL004390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2:$AQ$2</c:f>
              <c:numCache>
                <c:formatCode>General</c:formatCode>
                <c:ptCount val="42"/>
                <c:pt idx="0">
                  <c:v>2.0882800000000001</c:v>
                </c:pt>
                <c:pt idx="1">
                  <c:v>0.24129999999999999</c:v>
                </c:pt>
                <c:pt idx="2">
                  <c:v>1.70851</c:v>
                </c:pt>
                <c:pt idx="3">
                  <c:v>0.299564</c:v>
                </c:pt>
                <c:pt idx="4">
                  <c:v>14.426600000000001</c:v>
                </c:pt>
                <c:pt idx="5">
                  <c:v>1.8707400000000001</c:v>
                </c:pt>
                <c:pt idx="6">
                  <c:v>10.841699999999999</c:v>
                </c:pt>
                <c:pt idx="7">
                  <c:v>3.4780099999999998</c:v>
                </c:pt>
                <c:pt idx="8">
                  <c:v>24.188800000000001</c:v>
                </c:pt>
                <c:pt idx="9">
                  <c:v>34.803400000000003</c:v>
                </c:pt>
                <c:pt idx="10">
                  <c:v>734.89599999999996</c:v>
                </c:pt>
                <c:pt idx="11">
                  <c:v>1181.17</c:v>
                </c:pt>
                <c:pt idx="12">
                  <c:v>1392.79</c:v>
                </c:pt>
                <c:pt idx="13">
                  <c:v>1251.83</c:v>
                </c:pt>
                <c:pt idx="14">
                  <c:v>885.97699999999998</c:v>
                </c:pt>
                <c:pt idx="15">
                  <c:v>930.69299999999998</c:v>
                </c:pt>
                <c:pt idx="16">
                  <c:v>957.46900000000005</c:v>
                </c:pt>
                <c:pt idx="17">
                  <c:v>216.548</c:v>
                </c:pt>
                <c:pt idx="18">
                  <c:v>107.657</c:v>
                </c:pt>
                <c:pt idx="19">
                  <c:v>19.959900000000001</c:v>
                </c:pt>
                <c:pt idx="20">
                  <c:v>15.489800000000001</c:v>
                </c:pt>
                <c:pt idx="21">
                  <c:v>10.8095</c:v>
                </c:pt>
                <c:pt idx="22">
                  <c:v>5.8813800000000001</c:v>
                </c:pt>
                <c:pt idx="23">
                  <c:v>5.76959</c:v>
                </c:pt>
                <c:pt idx="24">
                  <c:v>2.7984599999999999</c:v>
                </c:pt>
                <c:pt idx="25">
                  <c:v>2.9328799999999999</c:v>
                </c:pt>
                <c:pt idx="26">
                  <c:v>8.4989799999999995</c:v>
                </c:pt>
                <c:pt idx="27">
                  <c:v>13.8621</c:v>
                </c:pt>
                <c:pt idx="28">
                  <c:v>12.322100000000001</c:v>
                </c:pt>
                <c:pt idx="29">
                  <c:v>2.9941200000000001</c:v>
                </c:pt>
                <c:pt idx="30">
                  <c:v>2.2231999999999998</c:v>
                </c:pt>
                <c:pt idx="31">
                  <c:v>4.9838100000000001</c:v>
                </c:pt>
                <c:pt idx="32">
                  <c:v>8.9847000000000001</c:v>
                </c:pt>
                <c:pt idx="33">
                  <c:v>0.97425600000000001</c:v>
                </c:pt>
                <c:pt idx="34">
                  <c:v>2.0327299999999999</c:v>
                </c:pt>
                <c:pt idx="35">
                  <c:v>0.167098</c:v>
                </c:pt>
                <c:pt idx="36">
                  <c:v>0.61082000000000003</c:v>
                </c:pt>
                <c:pt idx="37">
                  <c:v>2.1598200000000001E-2</c:v>
                </c:pt>
                <c:pt idx="38">
                  <c:v>0</c:v>
                </c:pt>
                <c:pt idx="39">
                  <c:v>0.14441799999999999</c:v>
                </c:pt>
                <c:pt idx="40">
                  <c:v>2.0327299999999999</c:v>
                </c:pt>
                <c:pt idx="41">
                  <c:v>24.050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2949888"/>
        <c:axId val="93000832"/>
      </c:barChart>
      <c:catAx>
        <c:axId val="9294988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93000832"/>
        <c:crosses val="autoZero"/>
        <c:auto val="1"/>
        <c:lblAlgn val="ctr"/>
        <c:lblOffset val="100"/>
        <c:noMultiLvlLbl val="0"/>
      </c:catAx>
      <c:valAx>
        <c:axId val="9300083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9294988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60</c:f>
              <c:strCache>
                <c:ptCount val="1"/>
                <c:pt idx="0">
                  <c:v>AAEL013492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60:$AQ$60</c:f>
              <c:numCache>
                <c:formatCode>General</c:formatCode>
                <c:ptCount val="42"/>
                <c:pt idx="0">
                  <c:v>0.34843600000000002</c:v>
                </c:pt>
                <c:pt idx="1">
                  <c:v>0.63571999999999995</c:v>
                </c:pt>
                <c:pt idx="2">
                  <c:v>5.6605400000000001</c:v>
                </c:pt>
                <c:pt idx="3">
                  <c:v>72.695300000000003</c:v>
                </c:pt>
                <c:pt idx="4">
                  <c:v>395.77600000000001</c:v>
                </c:pt>
                <c:pt idx="5">
                  <c:v>171.04</c:v>
                </c:pt>
                <c:pt idx="6">
                  <c:v>127.545</c:v>
                </c:pt>
                <c:pt idx="7">
                  <c:v>4.8493500000000003</c:v>
                </c:pt>
                <c:pt idx="8">
                  <c:v>3.0928</c:v>
                </c:pt>
                <c:pt idx="9">
                  <c:v>0.13596800000000001</c:v>
                </c:pt>
                <c:pt idx="10">
                  <c:v>2.0563400000000001</c:v>
                </c:pt>
                <c:pt idx="11">
                  <c:v>3.04792</c:v>
                </c:pt>
                <c:pt idx="12">
                  <c:v>1.0023599999999999</c:v>
                </c:pt>
                <c:pt idx="13">
                  <c:v>0.50293299999999996</c:v>
                </c:pt>
                <c:pt idx="14">
                  <c:v>0.42985099999999998</c:v>
                </c:pt>
                <c:pt idx="15">
                  <c:v>0.47513300000000003</c:v>
                </c:pt>
                <c:pt idx="16">
                  <c:v>0.574743</c:v>
                </c:pt>
                <c:pt idx="17">
                  <c:v>0.47452499999999997</c:v>
                </c:pt>
                <c:pt idx="18">
                  <c:v>0.43645</c:v>
                </c:pt>
                <c:pt idx="19">
                  <c:v>0.19125800000000001</c:v>
                </c:pt>
                <c:pt idx="20">
                  <c:v>3.4950200000000001E-2</c:v>
                </c:pt>
                <c:pt idx="21">
                  <c:v>0.13720399999999999</c:v>
                </c:pt>
                <c:pt idx="22">
                  <c:v>0.16906299999999999</c:v>
                </c:pt>
                <c:pt idx="23">
                  <c:v>6.6147999999999998E-2</c:v>
                </c:pt>
                <c:pt idx="24">
                  <c:v>0</c:v>
                </c:pt>
                <c:pt idx="25">
                  <c:v>7.5940499999999994E-2</c:v>
                </c:pt>
                <c:pt idx="26">
                  <c:v>0.28967100000000001</c:v>
                </c:pt>
                <c:pt idx="27">
                  <c:v>0.37759399999999999</c:v>
                </c:pt>
                <c:pt idx="28">
                  <c:v>0.50850600000000001</c:v>
                </c:pt>
                <c:pt idx="29">
                  <c:v>4.6707199999999997E-2</c:v>
                </c:pt>
                <c:pt idx="30">
                  <c:v>9.4045199999999995E-2</c:v>
                </c:pt>
                <c:pt idx="31">
                  <c:v>2.1797500000000001E-2</c:v>
                </c:pt>
                <c:pt idx="32">
                  <c:v>0.209734</c:v>
                </c:pt>
                <c:pt idx="33">
                  <c:v>0</c:v>
                </c:pt>
                <c:pt idx="34">
                  <c:v>2.2948300000000001E-2</c:v>
                </c:pt>
                <c:pt idx="35">
                  <c:v>0.35908499999999999</c:v>
                </c:pt>
                <c:pt idx="36">
                  <c:v>0.48477799999999999</c:v>
                </c:pt>
                <c:pt idx="37">
                  <c:v>0.10077899999999999</c:v>
                </c:pt>
                <c:pt idx="38">
                  <c:v>0.14108299999999999</c:v>
                </c:pt>
                <c:pt idx="39">
                  <c:v>0.29949900000000002</c:v>
                </c:pt>
                <c:pt idx="40">
                  <c:v>2.2948300000000001E-2</c:v>
                </c:pt>
                <c:pt idx="41">
                  <c:v>2.61548999999999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3049984"/>
        <c:axId val="93051520"/>
      </c:barChart>
      <c:catAx>
        <c:axId val="9304998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93051520"/>
        <c:crosses val="autoZero"/>
        <c:auto val="1"/>
        <c:lblAlgn val="ctr"/>
        <c:lblOffset val="100"/>
        <c:noMultiLvlLbl val="0"/>
      </c:catAx>
      <c:valAx>
        <c:axId val="9305152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9304998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4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27</c:f>
              <c:strCache>
                <c:ptCount val="1"/>
                <c:pt idx="0">
                  <c:v>AAEL006830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27:$AQ$27</c:f>
              <c:numCache>
                <c:formatCode>General</c:formatCode>
                <c:ptCount val="42"/>
                <c:pt idx="0">
                  <c:v>3.75901</c:v>
                </c:pt>
                <c:pt idx="1">
                  <c:v>1.0373000000000001</c:v>
                </c:pt>
                <c:pt idx="2">
                  <c:v>1.1779599999999999</c:v>
                </c:pt>
                <c:pt idx="3">
                  <c:v>0.482655</c:v>
                </c:pt>
                <c:pt idx="4">
                  <c:v>5.58141</c:v>
                </c:pt>
                <c:pt idx="5">
                  <c:v>2.7188699999999999</c:v>
                </c:pt>
                <c:pt idx="6">
                  <c:v>6.37256</c:v>
                </c:pt>
                <c:pt idx="7">
                  <c:v>1.84063</c:v>
                </c:pt>
                <c:pt idx="8">
                  <c:v>18.050599999999999</c:v>
                </c:pt>
                <c:pt idx="9">
                  <c:v>22.608799999999999</c:v>
                </c:pt>
                <c:pt idx="10">
                  <c:v>374.20600000000002</c:v>
                </c:pt>
                <c:pt idx="11">
                  <c:v>746.24099999999999</c:v>
                </c:pt>
                <c:pt idx="12">
                  <c:v>1259.76</c:v>
                </c:pt>
                <c:pt idx="13">
                  <c:v>558.577</c:v>
                </c:pt>
                <c:pt idx="14">
                  <c:v>540.18299999999999</c:v>
                </c:pt>
                <c:pt idx="15">
                  <c:v>571.68299999999999</c:v>
                </c:pt>
                <c:pt idx="16">
                  <c:v>539.69500000000005</c:v>
                </c:pt>
                <c:pt idx="17">
                  <c:v>268.81299999999999</c:v>
                </c:pt>
                <c:pt idx="18">
                  <c:v>71.6447</c:v>
                </c:pt>
                <c:pt idx="19">
                  <c:v>44.143700000000003</c:v>
                </c:pt>
                <c:pt idx="20">
                  <c:v>21.932700000000001</c:v>
                </c:pt>
                <c:pt idx="21">
                  <c:v>18.387699999999999</c:v>
                </c:pt>
                <c:pt idx="22">
                  <c:v>9.5978899999999996</c:v>
                </c:pt>
                <c:pt idx="23">
                  <c:v>10.9053</c:v>
                </c:pt>
                <c:pt idx="24">
                  <c:v>3.7701600000000002</c:v>
                </c:pt>
                <c:pt idx="25">
                  <c:v>4.6578600000000003</c:v>
                </c:pt>
                <c:pt idx="26">
                  <c:v>7.4655399999999998</c:v>
                </c:pt>
                <c:pt idx="27">
                  <c:v>14.9544</c:v>
                </c:pt>
                <c:pt idx="28">
                  <c:v>13.47</c:v>
                </c:pt>
                <c:pt idx="29">
                  <c:v>5.9614599999999998</c:v>
                </c:pt>
                <c:pt idx="30">
                  <c:v>59.392099999999999</c:v>
                </c:pt>
                <c:pt idx="31">
                  <c:v>202.09899999999999</c:v>
                </c:pt>
                <c:pt idx="32">
                  <c:v>180.749</c:v>
                </c:pt>
                <c:pt idx="33">
                  <c:v>221.87799999999999</c:v>
                </c:pt>
                <c:pt idx="34">
                  <c:v>146.20699999999999</c:v>
                </c:pt>
                <c:pt idx="35">
                  <c:v>2.4305099999999999</c:v>
                </c:pt>
                <c:pt idx="36">
                  <c:v>4.8698100000000002</c:v>
                </c:pt>
                <c:pt idx="37">
                  <c:v>254.9</c:v>
                </c:pt>
                <c:pt idx="38">
                  <c:v>93.436899999999994</c:v>
                </c:pt>
                <c:pt idx="39">
                  <c:v>106.39700000000001</c:v>
                </c:pt>
                <c:pt idx="40">
                  <c:v>146.20699999999999</c:v>
                </c:pt>
                <c:pt idx="41">
                  <c:v>251.94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3118848"/>
        <c:axId val="93120384"/>
      </c:barChart>
      <c:catAx>
        <c:axId val="9311884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93120384"/>
        <c:crosses val="autoZero"/>
        <c:auto val="1"/>
        <c:lblAlgn val="ctr"/>
        <c:lblOffset val="100"/>
        <c:noMultiLvlLbl val="0"/>
      </c:catAx>
      <c:valAx>
        <c:axId val="9312038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9311884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4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37</c:f>
              <c:strCache>
                <c:ptCount val="1"/>
                <c:pt idx="0">
                  <c:v>AAEL002333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37:$AQ$37</c:f>
              <c:numCache>
                <c:formatCode>General</c:formatCode>
                <c:ptCount val="4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1.6269899999999999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.108309</c:v>
                </c:pt>
                <c:pt idx="11">
                  <c:v>3.3949399999999998E-2</c:v>
                </c:pt>
                <c:pt idx="12">
                  <c:v>0.29778700000000002</c:v>
                </c:pt>
                <c:pt idx="13">
                  <c:v>2.76024</c:v>
                </c:pt>
                <c:pt idx="14">
                  <c:v>1.08958</c:v>
                </c:pt>
                <c:pt idx="15">
                  <c:v>5.2938800000000001E-2</c:v>
                </c:pt>
                <c:pt idx="16">
                  <c:v>6.4037300000000005E-2</c:v>
                </c:pt>
                <c:pt idx="17">
                  <c:v>4.5821599999999997E-2</c:v>
                </c:pt>
                <c:pt idx="18">
                  <c:v>0</c:v>
                </c:pt>
                <c:pt idx="19">
                  <c:v>4.6171200000000003E-2</c:v>
                </c:pt>
                <c:pt idx="20">
                  <c:v>0</c:v>
                </c:pt>
                <c:pt idx="21">
                  <c:v>0</c:v>
                </c:pt>
                <c:pt idx="22">
                  <c:v>6.1219599999999999E-2</c:v>
                </c:pt>
                <c:pt idx="23">
                  <c:v>3.1933999999999997E-2</c:v>
                </c:pt>
                <c:pt idx="24">
                  <c:v>0.46041799999999999</c:v>
                </c:pt>
                <c:pt idx="25">
                  <c:v>0.51326099999999997</c:v>
                </c:pt>
                <c:pt idx="26">
                  <c:v>3.2274799999999999E-2</c:v>
                </c:pt>
                <c:pt idx="27">
                  <c:v>0</c:v>
                </c:pt>
                <c:pt idx="28">
                  <c:v>0</c:v>
                </c:pt>
                <c:pt idx="29">
                  <c:v>0.21135200000000001</c:v>
                </c:pt>
                <c:pt idx="30">
                  <c:v>0.54725400000000002</c:v>
                </c:pt>
                <c:pt idx="31">
                  <c:v>0</c:v>
                </c:pt>
                <c:pt idx="32">
                  <c:v>0</c:v>
                </c:pt>
                <c:pt idx="33">
                  <c:v>0.28969600000000001</c:v>
                </c:pt>
                <c:pt idx="34">
                  <c:v>3.3239400000000002E-2</c:v>
                </c:pt>
                <c:pt idx="35">
                  <c:v>0</c:v>
                </c:pt>
                <c:pt idx="36">
                  <c:v>0</c:v>
                </c:pt>
                <c:pt idx="37">
                  <c:v>3.6489500000000001E-2</c:v>
                </c:pt>
                <c:pt idx="38">
                  <c:v>0</c:v>
                </c:pt>
                <c:pt idx="39">
                  <c:v>0</c:v>
                </c:pt>
                <c:pt idx="40">
                  <c:v>3.3239400000000002E-2</c:v>
                </c:pt>
                <c:pt idx="41">
                  <c:v>0.218561000000000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3243264"/>
        <c:axId val="93244800"/>
      </c:barChart>
      <c:catAx>
        <c:axId val="9324326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93244800"/>
        <c:crosses val="autoZero"/>
        <c:auto val="1"/>
        <c:lblAlgn val="ctr"/>
        <c:lblOffset val="100"/>
        <c:noMultiLvlLbl val="0"/>
      </c:catAx>
      <c:valAx>
        <c:axId val="9324480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9324326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26</c:f>
              <c:strCache>
                <c:ptCount val="1"/>
                <c:pt idx="0">
                  <c:v>AAEL006670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26:$AQ$26</c:f>
              <c:numCache>
                <c:formatCode>General</c:formatCode>
                <c:ptCount val="4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20.027200000000001</c:v>
                </c:pt>
                <c:pt idx="4">
                  <c:v>604.10599999999999</c:v>
                </c:pt>
                <c:pt idx="5">
                  <c:v>104.961</c:v>
                </c:pt>
                <c:pt idx="6">
                  <c:v>4.5379800000000001</c:v>
                </c:pt>
                <c:pt idx="7">
                  <c:v>14.5876</c:v>
                </c:pt>
                <c:pt idx="8">
                  <c:v>0</c:v>
                </c:pt>
                <c:pt idx="9">
                  <c:v>1.6527799999999999</c:v>
                </c:pt>
                <c:pt idx="10">
                  <c:v>10192.1</c:v>
                </c:pt>
                <c:pt idx="11">
                  <c:v>81032.399999999994</c:v>
                </c:pt>
                <c:pt idx="12">
                  <c:v>268202</c:v>
                </c:pt>
                <c:pt idx="13">
                  <c:v>5.7402699999999998</c:v>
                </c:pt>
                <c:pt idx="14">
                  <c:v>10.801399999999999</c:v>
                </c:pt>
                <c:pt idx="15">
                  <c:v>0</c:v>
                </c:pt>
                <c:pt idx="16">
                  <c:v>0</c:v>
                </c:pt>
                <c:pt idx="17">
                  <c:v>1.15364</c:v>
                </c:pt>
                <c:pt idx="18">
                  <c:v>0</c:v>
                </c:pt>
                <c:pt idx="19">
                  <c:v>0</c:v>
                </c:pt>
                <c:pt idx="20">
                  <c:v>175.886</c:v>
                </c:pt>
                <c:pt idx="21">
                  <c:v>25.047000000000001</c:v>
                </c:pt>
                <c:pt idx="22">
                  <c:v>51.661000000000001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39.003599999999999</c:v>
                </c:pt>
                <c:pt idx="27">
                  <c:v>125.56</c:v>
                </c:pt>
                <c:pt idx="28">
                  <c:v>30.050799999999999</c:v>
                </c:pt>
                <c:pt idx="29">
                  <c:v>0</c:v>
                </c:pt>
                <c:pt idx="30">
                  <c:v>0.42739199999999999</c:v>
                </c:pt>
                <c:pt idx="31">
                  <c:v>0</c:v>
                </c:pt>
                <c:pt idx="32">
                  <c:v>30.625399999999999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.97915300000000005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1780.1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9462272"/>
        <c:axId val="49468160"/>
      </c:barChart>
      <c:catAx>
        <c:axId val="4946227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49468160"/>
        <c:crosses val="autoZero"/>
        <c:auto val="1"/>
        <c:lblAlgn val="ctr"/>
        <c:lblOffset val="100"/>
        <c:noMultiLvlLbl val="0"/>
      </c:catAx>
      <c:valAx>
        <c:axId val="4946816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4946227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5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28</c:f>
              <c:strCache>
                <c:ptCount val="1"/>
                <c:pt idx="0">
                  <c:v>AAEL006985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28:$AQ$28</c:f>
              <c:numCache>
                <c:formatCode>General</c:formatCode>
                <c:ptCount val="42"/>
                <c:pt idx="0">
                  <c:v>0.54527000000000003</c:v>
                </c:pt>
                <c:pt idx="1">
                  <c:v>0.37444100000000002</c:v>
                </c:pt>
                <c:pt idx="2">
                  <c:v>0</c:v>
                </c:pt>
                <c:pt idx="3">
                  <c:v>0</c:v>
                </c:pt>
                <c:pt idx="4">
                  <c:v>0.55660299999999996</c:v>
                </c:pt>
                <c:pt idx="5">
                  <c:v>0.25095299999999998</c:v>
                </c:pt>
                <c:pt idx="6">
                  <c:v>0.13503499999999999</c:v>
                </c:pt>
                <c:pt idx="7">
                  <c:v>0.17776600000000001</c:v>
                </c:pt>
                <c:pt idx="8">
                  <c:v>1.3742000000000001</c:v>
                </c:pt>
                <c:pt idx="9">
                  <c:v>0.49034899999999998</c:v>
                </c:pt>
                <c:pt idx="10">
                  <c:v>25.241099999999999</c:v>
                </c:pt>
                <c:pt idx="11">
                  <c:v>38.701300000000003</c:v>
                </c:pt>
                <c:pt idx="12">
                  <c:v>71.291899999999998</c:v>
                </c:pt>
                <c:pt idx="13">
                  <c:v>37.394799999999996</c:v>
                </c:pt>
                <c:pt idx="14">
                  <c:v>47.959299999999999</c:v>
                </c:pt>
                <c:pt idx="15">
                  <c:v>36.458100000000002</c:v>
                </c:pt>
                <c:pt idx="16">
                  <c:v>28.9864</c:v>
                </c:pt>
                <c:pt idx="17">
                  <c:v>15.881</c:v>
                </c:pt>
                <c:pt idx="18">
                  <c:v>3.8408199999999999</c:v>
                </c:pt>
                <c:pt idx="19">
                  <c:v>1.7933399999999999</c:v>
                </c:pt>
                <c:pt idx="20">
                  <c:v>0.68299699999999997</c:v>
                </c:pt>
                <c:pt idx="21">
                  <c:v>0.89138200000000001</c:v>
                </c:pt>
                <c:pt idx="22">
                  <c:v>0.77737100000000003</c:v>
                </c:pt>
                <c:pt idx="23">
                  <c:v>1.33582</c:v>
                </c:pt>
                <c:pt idx="24">
                  <c:v>0.831121</c:v>
                </c:pt>
                <c:pt idx="25">
                  <c:v>1.0414000000000001</c:v>
                </c:pt>
                <c:pt idx="26">
                  <c:v>0.43393500000000002</c:v>
                </c:pt>
                <c:pt idx="27">
                  <c:v>0.76898500000000003</c:v>
                </c:pt>
                <c:pt idx="28">
                  <c:v>0.68114799999999998</c:v>
                </c:pt>
                <c:pt idx="29">
                  <c:v>1.01047</c:v>
                </c:pt>
                <c:pt idx="30">
                  <c:v>8.3938000000000006</c:v>
                </c:pt>
                <c:pt idx="31">
                  <c:v>28.6297</c:v>
                </c:pt>
                <c:pt idx="32">
                  <c:v>8.9063300000000005</c:v>
                </c:pt>
                <c:pt idx="33">
                  <c:v>37.997300000000003</c:v>
                </c:pt>
                <c:pt idx="34">
                  <c:v>19.912099999999999</c:v>
                </c:pt>
                <c:pt idx="35">
                  <c:v>7.9460500000000003E-2</c:v>
                </c:pt>
                <c:pt idx="36">
                  <c:v>0.41033599999999998</c:v>
                </c:pt>
                <c:pt idx="37">
                  <c:v>22.732099999999999</c:v>
                </c:pt>
                <c:pt idx="38">
                  <c:v>6.2579099999999999</c:v>
                </c:pt>
                <c:pt idx="39">
                  <c:v>5.5088299999999997</c:v>
                </c:pt>
                <c:pt idx="40">
                  <c:v>19.912099999999999</c:v>
                </c:pt>
                <c:pt idx="41">
                  <c:v>15.164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3344896"/>
        <c:axId val="93346432"/>
      </c:barChart>
      <c:catAx>
        <c:axId val="9334489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93346432"/>
        <c:crosses val="autoZero"/>
        <c:auto val="1"/>
        <c:lblAlgn val="ctr"/>
        <c:lblOffset val="100"/>
        <c:noMultiLvlLbl val="0"/>
      </c:catAx>
      <c:valAx>
        <c:axId val="9334643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9334489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5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29</c:f>
              <c:strCache>
                <c:ptCount val="1"/>
                <c:pt idx="0">
                  <c:v>AAEL007096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29:$AQ$29</c:f>
              <c:numCache>
                <c:formatCode>General</c:formatCode>
                <c:ptCount val="4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2.297750000000000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.333042</c:v>
                </c:pt>
                <c:pt idx="11">
                  <c:v>9.3969300000000006E-2</c:v>
                </c:pt>
                <c:pt idx="12">
                  <c:v>0.183146</c:v>
                </c:pt>
                <c:pt idx="13">
                  <c:v>2.8764699999999999</c:v>
                </c:pt>
                <c:pt idx="14">
                  <c:v>1.2922899999999999</c:v>
                </c:pt>
                <c:pt idx="15">
                  <c:v>0.26587899999999998</c:v>
                </c:pt>
                <c:pt idx="16">
                  <c:v>0.17721899999999999</c:v>
                </c:pt>
                <c:pt idx="17">
                  <c:v>0.12680900000000001</c:v>
                </c:pt>
                <c:pt idx="18">
                  <c:v>0</c:v>
                </c:pt>
                <c:pt idx="19">
                  <c:v>2.8394599999999999E-2</c:v>
                </c:pt>
                <c:pt idx="20">
                  <c:v>0</c:v>
                </c:pt>
                <c:pt idx="21">
                  <c:v>0</c:v>
                </c:pt>
                <c:pt idx="22">
                  <c:v>3.7649200000000001E-2</c:v>
                </c:pt>
                <c:pt idx="23">
                  <c:v>0.19885700000000001</c:v>
                </c:pt>
                <c:pt idx="24">
                  <c:v>0.64415599999999995</c:v>
                </c:pt>
                <c:pt idx="25">
                  <c:v>0.54114499999999999</c:v>
                </c:pt>
                <c:pt idx="26">
                  <c:v>8.9318499999999995E-2</c:v>
                </c:pt>
                <c:pt idx="27">
                  <c:v>0</c:v>
                </c:pt>
                <c:pt idx="28">
                  <c:v>0</c:v>
                </c:pt>
                <c:pt idx="29">
                  <c:v>0.25168299999999999</c:v>
                </c:pt>
                <c:pt idx="30">
                  <c:v>0.378272</c:v>
                </c:pt>
                <c:pt idx="31">
                  <c:v>3.8833300000000001E-2</c:v>
                </c:pt>
                <c:pt idx="32">
                  <c:v>0</c:v>
                </c:pt>
                <c:pt idx="33">
                  <c:v>0.22089400000000001</c:v>
                </c:pt>
                <c:pt idx="34">
                  <c:v>0.24734600000000001</c:v>
                </c:pt>
                <c:pt idx="35">
                  <c:v>0</c:v>
                </c:pt>
                <c:pt idx="36">
                  <c:v>0</c:v>
                </c:pt>
                <c:pt idx="37">
                  <c:v>0.100989</c:v>
                </c:pt>
                <c:pt idx="38">
                  <c:v>0</c:v>
                </c:pt>
                <c:pt idx="39">
                  <c:v>0</c:v>
                </c:pt>
                <c:pt idx="40">
                  <c:v>0.24734600000000001</c:v>
                </c:pt>
                <c:pt idx="41">
                  <c:v>0.186682999999999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3272704"/>
        <c:axId val="93274496"/>
      </c:barChart>
      <c:catAx>
        <c:axId val="9327270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93274496"/>
        <c:crosses val="autoZero"/>
        <c:auto val="1"/>
        <c:lblAlgn val="ctr"/>
        <c:lblOffset val="100"/>
        <c:noMultiLvlLbl val="0"/>
      </c:catAx>
      <c:valAx>
        <c:axId val="9327449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9327270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5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35</c:f>
              <c:strCache>
                <c:ptCount val="1"/>
                <c:pt idx="0">
                  <c:v>AAEL010848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35:$AQ$35</c:f>
              <c:numCache>
                <c:formatCode>General</c:formatCode>
                <c:ptCount val="42"/>
                <c:pt idx="0">
                  <c:v>1.4736800000000001</c:v>
                </c:pt>
                <c:pt idx="1">
                  <c:v>0.12420299999999999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.60652700000000004</c:v>
                </c:pt>
                <c:pt idx="7">
                  <c:v>0</c:v>
                </c:pt>
                <c:pt idx="8">
                  <c:v>0</c:v>
                </c:pt>
                <c:pt idx="9">
                  <c:v>0.26413900000000001</c:v>
                </c:pt>
                <c:pt idx="10">
                  <c:v>0.10910599999999999</c:v>
                </c:pt>
                <c:pt idx="11">
                  <c:v>0</c:v>
                </c:pt>
                <c:pt idx="12">
                  <c:v>3.2169699999999999</c:v>
                </c:pt>
                <c:pt idx="13">
                  <c:v>1.7735799999999999</c:v>
                </c:pt>
                <c:pt idx="14">
                  <c:v>0.469472</c:v>
                </c:pt>
                <c:pt idx="15">
                  <c:v>0.10657999999999999</c:v>
                </c:pt>
                <c:pt idx="16">
                  <c:v>0</c:v>
                </c:pt>
                <c:pt idx="17">
                  <c:v>9.22351E-2</c:v>
                </c:pt>
                <c:pt idx="18">
                  <c:v>0</c:v>
                </c:pt>
                <c:pt idx="19">
                  <c:v>0</c:v>
                </c:pt>
                <c:pt idx="20">
                  <c:v>0.102155</c:v>
                </c:pt>
                <c:pt idx="21">
                  <c:v>0</c:v>
                </c:pt>
                <c:pt idx="22">
                  <c:v>6.1813300000000002E-2</c:v>
                </c:pt>
                <c:pt idx="23">
                  <c:v>6.4597500000000002E-2</c:v>
                </c:pt>
                <c:pt idx="24">
                  <c:v>0.197489</c:v>
                </c:pt>
                <c:pt idx="25">
                  <c:v>0.221748</c:v>
                </c:pt>
                <c:pt idx="26">
                  <c:v>6.5007400000000007E-2</c:v>
                </c:pt>
                <c:pt idx="27">
                  <c:v>6.4905599999999994E-2</c:v>
                </c:pt>
                <c:pt idx="28">
                  <c:v>7.0927400000000002E-2</c:v>
                </c:pt>
                <c:pt idx="29">
                  <c:v>0.204842</c:v>
                </c:pt>
                <c:pt idx="30">
                  <c:v>6.8831000000000003E-2</c:v>
                </c:pt>
                <c:pt idx="31">
                  <c:v>0.127854</c:v>
                </c:pt>
                <c:pt idx="32">
                  <c:v>7.6824000000000003E-2</c:v>
                </c:pt>
                <c:pt idx="33">
                  <c:v>7.1651199999999998E-2</c:v>
                </c:pt>
                <c:pt idx="34">
                  <c:v>0.133794</c:v>
                </c:pt>
                <c:pt idx="35">
                  <c:v>9.5145800000000003E-2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.133794</c:v>
                </c:pt>
                <c:pt idx="41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3394816"/>
        <c:axId val="93396352"/>
      </c:barChart>
      <c:catAx>
        <c:axId val="9339481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93396352"/>
        <c:crosses val="autoZero"/>
        <c:auto val="1"/>
        <c:lblAlgn val="ctr"/>
        <c:lblOffset val="100"/>
        <c:noMultiLvlLbl val="0"/>
      </c:catAx>
      <c:valAx>
        <c:axId val="9339635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9339481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5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31</c:f>
              <c:strCache>
                <c:ptCount val="1"/>
                <c:pt idx="0">
                  <c:v>AAEL007641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31:$AQ$31</c:f>
              <c:numCache>
                <c:formatCode>General</c:formatCode>
                <c:ptCount val="42"/>
                <c:pt idx="0">
                  <c:v>0</c:v>
                </c:pt>
                <c:pt idx="1">
                  <c:v>0.18093400000000001</c:v>
                </c:pt>
                <c:pt idx="2">
                  <c:v>0</c:v>
                </c:pt>
                <c:pt idx="3">
                  <c:v>7.6415899999999995E-2</c:v>
                </c:pt>
                <c:pt idx="4">
                  <c:v>0</c:v>
                </c:pt>
                <c:pt idx="5">
                  <c:v>3.0313900000000001E-2</c:v>
                </c:pt>
                <c:pt idx="6">
                  <c:v>0</c:v>
                </c:pt>
                <c:pt idx="7">
                  <c:v>2.14758E-2</c:v>
                </c:pt>
                <c:pt idx="8">
                  <c:v>0</c:v>
                </c:pt>
                <c:pt idx="9">
                  <c:v>0.145118</c:v>
                </c:pt>
                <c:pt idx="10">
                  <c:v>0.119712</c:v>
                </c:pt>
                <c:pt idx="11">
                  <c:v>2.50231E-2</c:v>
                </c:pt>
                <c:pt idx="12">
                  <c:v>0</c:v>
                </c:pt>
                <c:pt idx="13">
                  <c:v>8.4753700000000001E-2</c:v>
                </c:pt>
                <c:pt idx="14">
                  <c:v>8.6021100000000003E-2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.88456100000000004</c:v>
                </c:pt>
                <c:pt idx="20">
                  <c:v>0.78334800000000004</c:v>
                </c:pt>
                <c:pt idx="21">
                  <c:v>0.53693800000000003</c:v>
                </c:pt>
                <c:pt idx="22">
                  <c:v>0.42854599999999998</c:v>
                </c:pt>
                <c:pt idx="23">
                  <c:v>9.4132499999999994E-2</c:v>
                </c:pt>
                <c:pt idx="24">
                  <c:v>0.26506299999999999</c:v>
                </c:pt>
                <c:pt idx="25">
                  <c:v>0.24315300000000001</c:v>
                </c:pt>
                <c:pt idx="26">
                  <c:v>1.6409499999999999</c:v>
                </c:pt>
                <c:pt idx="27">
                  <c:v>0.52153700000000003</c:v>
                </c:pt>
                <c:pt idx="28">
                  <c:v>0.491039</c:v>
                </c:pt>
                <c:pt idx="29">
                  <c:v>0.32402500000000001</c:v>
                </c:pt>
                <c:pt idx="30">
                  <c:v>0.175654</c:v>
                </c:pt>
                <c:pt idx="31">
                  <c:v>0.13958699999999999</c:v>
                </c:pt>
                <c:pt idx="32">
                  <c:v>0.27981</c:v>
                </c:pt>
                <c:pt idx="33">
                  <c:v>2.61411E-2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7.5288499999999994E-2</c:v>
                </c:pt>
                <c:pt idx="39">
                  <c:v>0.39956799999999998</c:v>
                </c:pt>
                <c:pt idx="40">
                  <c:v>0</c:v>
                </c:pt>
                <c:pt idx="41">
                  <c:v>0.250520000000000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3465984"/>
        <c:axId val="93484160"/>
      </c:barChart>
      <c:catAx>
        <c:axId val="9346598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93484160"/>
        <c:crosses val="autoZero"/>
        <c:auto val="1"/>
        <c:lblAlgn val="ctr"/>
        <c:lblOffset val="100"/>
        <c:noMultiLvlLbl val="0"/>
      </c:catAx>
      <c:valAx>
        <c:axId val="9348416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9346598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5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70</c:f>
              <c:strCache>
                <c:ptCount val="1"/>
                <c:pt idx="0">
                  <c:v>AAEL016992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70:$AQ$70</c:f>
              <c:numCache>
                <c:formatCode>General</c:formatCode>
                <c:ptCount val="42"/>
                <c:pt idx="0">
                  <c:v>1.6771500000000002E-2</c:v>
                </c:pt>
                <c:pt idx="1">
                  <c:v>3.8090100000000002E-2</c:v>
                </c:pt>
                <c:pt idx="2">
                  <c:v>2.1849400000000001E-9</c:v>
                </c:pt>
                <c:pt idx="3">
                  <c:v>0</c:v>
                </c:pt>
                <c:pt idx="4">
                  <c:v>0.53795499999999996</c:v>
                </c:pt>
                <c:pt idx="5">
                  <c:v>7.8144599999999995E-2</c:v>
                </c:pt>
                <c:pt idx="6">
                  <c:v>4.3809300000000002E-2</c:v>
                </c:pt>
                <c:pt idx="7">
                  <c:v>6.7799899999999996E-2</c:v>
                </c:pt>
                <c:pt idx="8">
                  <c:v>7.8084500000000001E-2</c:v>
                </c:pt>
                <c:pt idx="9">
                  <c:v>0.70280399999999998</c:v>
                </c:pt>
                <c:pt idx="10">
                  <c:v>0.53041400000000005</c:v>
                </c:pt>
                <c:pt idx="11">
                  <c:v>121.261</c:v>
                </c:pt>
                <c:pt idx="12">
                  <c:v>50.588500000000003</c:v>
                </c:pt>
                <c:pt idx="13">
                  <c:v>9.0306999999999998E-2</c:v>
                </c:pt>
                <c:pt idx="14">
                  <c:v>0.16199</c:v>
                </c:pt>
                <c:pt idx="15">
                  <c:v>0.20113800000000001</c:v>
                </c:pt>
                <c:pt idx="16">
                  <c:v>0.10906100000000001</c:v>
                </c:pt>
                <c:pt idx="17">
                  <c:v>4.7965399999999998E-2</c:v>
                </c:pt>
                <c:pt idx="18">
                  <c:v>0.11862499999999999</c:v>
                </c:pt>
                <c:pt idx="19">
                  <c:v>0.10874499999999999</c:v>
                </c:pt>
                <c:pt idx="20">
                  <c:v>9.4207799999999994E-2</c:v>
                </c:pt>
                <c:pt idx="21">
                  <c:v>7.7048300000000002E-3</c:v>
                </c:pt>
                <c:pt idx="22">
                  <c:v>2.8481699999999999E-2</c:v>
                </c:pt>
                <c:pt idx="23">
                  <c:v>7.4293500000000004E-3</c:v>
                </c:pt>
                <c:pt idx="24">
                  <c:v>0</c:v>
                </c:pt>
                <c:pt idx="25">
                  <c:v>0</c:v>
                </c:pt>
                <c:pt idx="26">
                  <c:v>2.2073</c:v>
                </c:pt>
                <c:pt idx="27">
                  <c:v>13.7309</c:v>
                </c:pt>
                <c:pt idx="28">
                  <c:v>17.588999999999999</c:v>
                </c:pt>
                <c:pt idx="29">
                  <c:v>19.399000000000001</c:v>
                </c:pt>
                <c:pt idx="30">
                  <c:v>11.1297</c:v>
                </c:pt>
                <c:pt idx="31">
                  <c:v>2.7027999999999999</c:v>
                </c:pt>
                <c:pt idx="32">
                  <c:v>3.1093600000000001</c:v>
                </c:pt>
                <c:pt idx="33">
                  <c:v>0.13807700000000001</c:v>
                </c:pt>
                <c:pt idx="34">
                  <c:v>0.216499</c:v>
                </c:pt>
                <c:pt idx="35">
                  <c:v>0</c:v>
                </c:pt>
                <c:pt idx="36">
                  <c:v>0</c:v>
                </c:pt>
                <c:pt idx="37">
                  <c:v>0.52261800000000003</c:v>
                </c:pt>
                <c:pt idx="38">
                  <c:v>8.7259199999999995E-2</c:v>
                </c:pt>
                <c:pt idx="39">
                  <c:v>0.366116</c:v>
                </c:pt>
                <c:pt idx="40">
                  <c:v>0.216499</c:v>
                </c:pt>
                <c:pt idx="41">
                  <c:v>20.733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8377856"/>
        <c:axId val="138379648"/>
      </c:barChart>
      <c:catAx>
        <c:axId val="13837785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38379648"/>
        <c:crosses val="autoZero"/>
        <c:auto val="1"/>
        <c:lblAlgn val="ctr"/>
        <c:lblOffset val="100"/>
        <c:noMultiLvlLbl val="0"/>
      </c:catAx>
      <c:valAx>
        <c:axId val="138379648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3837785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5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76</c:f>
              <c:strCache>
                <c:ptCount val="1"/>
                <c:pt idx="0">
                  <c:v>AAEL007415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76:$AQ$76</c:f>
              <c:numCache>
                <c:formatCode>General</c:formatCode>
                <c:ptCount val="42"/>
                <c:pt idx="0">
                  <c:v>1.4671500000000001E-2</c:v>
                </c:pt>
                <c:pt idx="1">
                  <c:v>6.5526899999999999E-2</c:v>
                </c:pt>
                <c:pt idx="2">
                  <c:v>3.6454899999999998E-2</c:v>
                </c:pt>
                <c:pt idx="3">
                  <c:v>7.6966199999999999E-2</c:v>
                </c:pt>
                <c:pt idx="4">
                  <c:v>0.188913</c:v>
                </c:pt>
                <c:pt idx="5">
                  <c:v>6.6337599999999997E-2</c:v>
                </c:pt>
                <c:pt idx="6">
                  <c:v>2.8653700000000001E-2</c:v>
                </c:pt>
                <c:pt idx="7">
                  <c:v>1.32195E-2</c:v>
                </c:pt>
                <c:pt idx="8">
                  <c:v>3.8064500000000001E-2</c:v>
                </c:pt>
                <c:pt idx="9">
                  <c:v>0.10710600000000001</c:v>
                </c:pt>
                <c:pt idx="10">
                  <c:v>0.24246100000000001</c:v>
                </c:pt>
                <c:pt idx="11">
                  <c:v>77.4696</c:v>
                </c:pt>
                <c:pt idx="12">
                  <c:v>36.276899999999998</c:v>
                </c:pt>
                <c:pt idx="13">
                  <c:v>4.8512699999999999E-2</c:v>
                </c:pt>
                <c:pt idx="14">
                  <c:v>1.57295E-2</c:v>
                </c:pt>
                <c:pt idx="15">
                  <c:v>4.2167299999999998E-2</c:v>
                </c:pt>
                <c:pt idx="16">
                  <c:v>5.6325800000000002E-2</c:v>
                </c:pt>
                <c:pt idx="17">
                  <c:v>4.3165200000000001E-2</c:v>
                </c:pt>
                <c:pt idx="18">
                  <c:v>4.0654900000000001E-2</c:v>
                </c:pt>
                <c:pt idx="19">
                  <c:v>4.4632600000000001E-2</c:v>
                </c:pt>
                <c:pt idx="20">
                  <c:v>0.11589099999999999</c:v>
                </c:pt>
                <c:pt idx="21">
                  <c:v>2.63544E-2</c:v>
                </c:pt>
                <c:pt idx="22">
                  <c:v>3.0550799999999999E-2</c:v>
                </c:pt>
                <c:pt idx="23">
                  <c:v>6.5757599999999999E-3</c:v>
                </c:pt>
                <c:pt idx="24" formatCode="0.00E+00">
                  <c:v>2.2810100000000002E-22</c:v>
                </c:pt>
                <c:pt idx="25">
                  <c:v>9.99916E-3</c:v>
                </c:pt>
                <c:pt idx="26">
                  <c:v>1.1941200000000001</c:v>
                </c:pt>
                <c:pt idx="27">
                  <c:v>7.2069599999999996</c:v>
                </c:pt>
                <c:pt idx="28">
                  <c:v>9.6622900000000005</c:v>
                </c:pt>
                <c:pt idx="29">
                  <c:v>11.430300000000001</c:v>
                </c:pt>
                <c:pt idx="30">
                  <c:v>7.3655799999999996</c:v>
                </c:pt>
                <c:pt idx="31">
                  <c:v>1.9768600000000001</c:v>
                </c:pt>
                <c:pt idx="32">
                  <c:v>2.2175600000000002</c:v>
                </c:pt>
                <c:pt idx="33">
                  <c:v>9.1469800000000004E-2</c:v>
                </c:pt>
                <c:pt idx="34">
                  <c:v>0.108889</c:v>
                </c:pt>
                <c:pt idx="35" formatCode="0.00E+00">
                  <c:v>1.5324E-17</c:v>
                </c:pt>
                <c:pt idx="36" formatCode="0.00E+00">
                  <c:v>3.3805700000000002E-24</c:v>
                </c:pt>
                <c:pt idx="37">
                  <c:v>0.371645</c:v>
                </c:pt>
                <c:pt idx="38">
                  <c:v>1.6617900000000001E-2</c:v>
                </c:pt>
                <c:pt idx="39">
                  <c:v>0.210704</c:v>
                </c:pt>
                <c:pt idx="40">
                  <c:v>0.108889</c:v>
                </c:pt>
                <c:pt idx="41">
                  <c:v>22.2356000000000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6999296"/>
        <c:axId val="137000832"/>
      </c:barChart>
      <c:catAx>
        <c:axId val="13699929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37000832"/>
        <c:crosses val="autoZero"/>
        <c:auto val="1"/>
        <c:lblAlgn val="ctr"/>
        <c:lblOffset val="100"/>
        <c:noMultiLvlLbl val="0"/>
      </c:catAx>
      <c:valAx>
        <c:axId val="13700083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3699929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5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</c:title>
    <c:autoTitleDeleted val="0"/>
    <c:plotArea>
      <c:layout/>
      <c:barChart>
        <c:barDir val="col"/>
        <c:grouping val="clustered"/>
        <c:varyColors val="0"/>
        <c:ser>
          <c:idx val="3"/>
          <c:order val="0"/>
          <c:tx>
            <c:strRef>
              <c:f>Sheet1!$A$19</c:f>
              <c:strCache>
                <c:ptCount val="1"/>
                <c:pt idx="0">
                  <c:v>AAEL000144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19:$AQ$19</c:f>
              <c:numCache>
                <c:formatCode>General</c:formatCode>
                <c:ptCount val="4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5.1074300000000003E-2</c:v>
                </c:pt>
                <c:pt idx="4">
                  <c:v>0</c:v>
                </c:pt>
                <c:pt idx="5">
                  <c:v>6.0782999999999997E-2</c:v>
                </c:pt>
                <c:pt idx="6">
                  <c:v>32.998699999999999</c:v>
                </c:pt>
                <c:pt idx="7">
                  <c:v>4.30467E-2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.109986</c:v>
                </c:pt>
                <c:pt idx="13">
                  <c:v>305.24799999999999</c:v>
                </c:pt>
                <c:pt idx="14">
                  <c:v>30.855399999999999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6.8217299999999995E-2</c:v>
                </c:pt>
                <c:pt idx="20">
                  <c:v>7.4795500000000001E-2</c:v>
                </c:pt>
                <c:pt idx="21">
                  <c:v>0</c:v>
                </c:pt>
                <c:pt idx="22">
                  <c:v>4.5225599999999998E-2</c:v>
                </c:pt>
                <c:pt idx="23">
                  <c:v>0</c:v>
                </c:pt>
                <c:pt idx="24">
                  <c:v>0</c:v>
                </c:pt>
                <c:pt idx="25">
                  <c:v>5.4162799999999997E-2</c:v>
                </c:pt>
                <c:pt idx="26">
                  <c:v>9.53711E-2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5.3908699999999997E-2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7051520"/>
        <c:axId val="137061504"/>
      </c:barChart>
      <c:catAx>
        <c:axId val="13705152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37061504"/>
        <c:crosses val="autoZero"/>
        <c:auto val="1"/>
        <c:lblAlgn val="ctr"/>
        <c:lblOffset val="100"/>
        <c:noMultiLvlLbl val="0"/>
      </c:catAx>
      <c:valAx>
        <c:axId val="13706150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3705152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5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38</c:f>
              <c:strCache>
                <c:ptCount val="1"/>
                <c:pt idx="0">
                  <c:v>AAEL002400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38:$AQ$38</c:f>
              <c:numCache>
                <c:formatCode>General</c:formatCode>
                <c:ptCount val="42"/>
                <c:pt idx="0">
                  <c:v>8.4174700000000005E-2</c:v>
                </c:pt>
                <c:pt idx="1">
                  <c:v>0.25084299999999998</c:v>
                </c:pt>
                <c:pt idx="2">
                  <c:v>0.156419</c:v>
                </c:pt>
                <c:pt idx="3">
                  <c:v>0.16101499999999999</c:v>
                </c:pt>
                <c:pt idx="4">
                  <c:v>9.4004599999999994E-2</c:v>
                </c:pt>
                <c:pt idx="5">
                  <c:v>0.22153600000000001</c:v>
                </c:pt>
                <c:pt idx="6">
                  <c:v>126.38500000000001</c:v>
                </c:pt>
                <c:pt idx="7">
                  <c:v>0.37450499999999998</c:v>
                </c:pt>
                <c:pt idx="8">
                  <c:v>0.114727</c:v>
                </c:pt>
                <c:pt idx="9">
                  <c:v>3.8321300000000003E-2</c:v>
                </c:pt>
                <c:pt idx="10">
                  <c:v>3.1612399999999999E-2</c:v>
                </c:pt>
                <c:pt idx="11">
                  <c:v>1.98242E-2</c:v>
                </c:pt>
                <c:pt idx="12">
                  <c:v>4.3462800000000003E-2</c:v>
                </c:pt>
                <c:pt idx="13">
                  <c:v>615.29399999999998</c:v>
                </c:pt>
                <c:pt idx="14">
                  <c:v>74.498500000000007</c:v>
                </c:pt>
                <c:pt idx="15">
                  <c:v>0.12486999999999999</c:v>
                </c:pt>
                <c:pt idx="16">
                  <c:v>0</c:v>
                </c:pt>
                <c:pt idx="17">
                  <c:v>0</c:v>
                </c:pt>
                <c:pt idx="18">
                  <c:v>2.4601899999999999E-2</c:v>
                </c:pt>
                <c:pt idx="19">
                  <c:v>0.40959800000000002</c:v>
                </c:pt>
                <c:pt idx="20">
                  <c:v>0.120668</c:v>
                </c:pt>
                <c:pt idx="21">
                  <c:v>6.4823599999999995E-2</c:v>
                </c:pt>
                <c:pt idx="22">
                  <c:v>0.164963</c:v>
                </c:pt>
                <c:pt idx="23">
                  <c:v>0.25559199999999999</c:v>
                </c:pt>
                <c:pt idx="24">
                  <c:v>0.10179199999999999</c:v>
                </c:pt>
                <c:pt idx="25">
                  <c:v>6.1470799999999999E-2</c:v>
                </c:pt>
                <c:pt idx="26">
                  <c:v>0.43730799999999997</c:v>
                </c:pt>
                <c:pt idx="27">
                  <c:v>0.28239300000000001</c:v>
                </c:pt>
                <c:pt idx="28">
                  <c:v>0.187168</c:v>
                </c:pt>
                <c:pt idx="29">
                  <c:v>0.14393600000000001</c:v>
                </c:pt>
                <c:pt idx="30">
                  <c:v>1.9879500000000001E-2</c:v>
                </c:pt>
                <c:pt idx="31">
                  <c:v>8.6696300000000004E-2</c:v>
                </c:pt>
                <c:pt idx="32">
                  <c:v>0.346161</c:v>
                </c:pt>
                <c:pt idx="33">
                  <c:v>4.3390999999999999E-2</c:v>
                </c:pt>
                <c:pt idx="34">
                  <c:v>0.10347199999999999</c:v>
                </c:pt>
                <c:pt idx="35">
                  <c:v>1.38008E-2</c:v>
                </c:pt>
                <c:pt idx="36">
                  <c:v>0.35504200000000002</c:v>
                </c:pt>
                <c:pt idx="37">
                  <c:v>0.24135699999999999</c:v>
                </c:pt>
                <c:pt idx="38">
                  <c:v>0.100316</c:v>
                </c:pt>
                <c:pt idx="39">
                  <c:v>3.16542E-2</c:v>
                </c:pt>
                <c:pt idx="40">
                  <c:v>0.10347199999999999</c:v>
                </c:pt>
                <c:pt idx="41">
                  <c:v>0.16063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7163904"/>
        <c:axId val="137165440"/>
      </c:barChart>
      <c:catAx>
        <c:axId val="13716390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37165440"/>
        <c:crosses val="autoZero"/>
        <c:auto val="1"/>
        <c:lblAlgn val="ctr"/>
        <c:lblOffset val="100"/>
        <c:noMultiLvlLbl val="0"/>
      </c:catAx>
      <c:valAx>
        <c:axId val="13716544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3716390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5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A$20</c:f>
              <c:strCache>
                <c:ptCount val="1"/>
                <c:pt idx="0">
                  <c:v>AAEL006328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20:$AQ$20</c:f>
              <c:numCache>
                <c:formatCode>General</c:formatCode>
                <c:ptCount val="42"/>
                <c:pt idx="0">
                  <c:v>0.18804299999999999</c:v>
                </c:pt>
                <c:pt idx="1">
                  <c:v>0.26683800000000002</c:v>
                </c:pt>
                <c:pt idx="2">
                  <c:v>0.72312900000000002</c:v>
                </c:pt>
                <c:pt idx="3">
                  <c:v>0.99174499999999999</c:v>
                </c:pt>
                <c:pt idx="4">
                  <c:v>0.485875</c:v>
                </c:pt>
                <c:pt idx="5">
                  <c:v>0.28612500000000002</c:v>
                </c:pt>
                <c:pt idx="6">
                  <c:v>50.453499999999998</c:v>
                </c:pt>
                <c:pt idx="7">
                  <c:v>1.6215999999999999</c:v>
                </c:pt>
                <c:pt idx="8">
                  <c:v>0.499307</c:v>
                </c:pt>
                <c:pt idx="9">
                  <c:v>0.17121600000000001</c:v>
                </c:pt>
                <c:pt idx="10">
                  <c:v>3.01315</c:v>
                </c:pt>
                <c:pt idx="11">
                  <c:v>1.978</c:v>
                </c:pt>
                <c:pt idx="12">
                  <c:v>3.1393</c:v>
                </c:pt>
                <c:pt idx="13">
                  <c:v>600.89099999999996</c:v>
                </c:pt>
                <c:pt idx="14">
                  <c:v>26.793700000000001</c:v>
                </c:pt>
                <c:pt idx="15">
                  <c:v>2.8994900000000001</c:v>
                </c:pt>
                <c:pt idx="16">
                  <c:v>2.6166</c:v>
                </c:pt>
                <c:pt idx="17">
                  <c:v>1.7527900000000001</c:v>
                </c:pt>
                <c:pt idx="18">
                  <c:v>1.2823899999999999</c:v>
                </c:pt>
                <c:pt idx="19">
                  <c:v>1.08378</c:v>
                </c:pt>
                <c:pt idx="20">
                  <c:v>0.30807499999999999</c:v>
                </c:pt>
                <c:pt idx="21">
                  <c:v>0.316751</c:v>
                </c:pt>
                <c:pt idx="22">
                  <c:v>0.13305700000000001</c:v>
                </c:pt>
                <c:pt idx="23">
                  <c:v>0.194356</c:v>
                </c:pt>
                <c:pt idx="24">
                  <c:v>0.19900499999999999</c:v>
                </c:pt>
                <c:pt idx="25">
                  <c:v>9.5626299999999997E-2</c:v>
                </c:pt>
                <c:pt idx="26">
                  <c:v>0.224471</c:v>
                </c:pt>
                <c:pt idx="27">
                  <c:v>0.36360500000000001</c:v>
                </c:pt>
                <c:pt idx="28">
                  <c:v>0.182952</c:v>
                </c:pt>
                <c:pt idx="29">
                  <c:v>0.32347300000000001</c:v>
                </c:pt>
                <c:pt idx="30">
                  <c:v>0.17763599999999999</c:v>
                </c:pt>
                <c:pt idx="31">
                  <c:v>0.32938000000000001</c:v>
                </c:pt>
                <c:pt idx="32">
                  <c:v>0.52821099999999999</c:v>
                </c:pt>
                <c:pt idx="33">
                  <c:v>0.43178899999999998</c:v>
                </c:pt>
                <c:pt idx="34">
                  <c:v>0.49125799999999997</c:v>
                </c:pt>
                <c:pt idx="35">
                  <c:v>0.287744</c:v>
                </c:pt>
                <c:pt idx="36">
                  <c:v>0.57653200000000004</c:v>
                </c:pt>
                <c:pt idx="37">
                  <c:v>1.0786800000000001</c:v>
                </c:pt>
                <c:pt idx="38">
                  <c:v>1.65812</c:v>
                </c:pt>
                <c:pt idx="39">
                  <c:v>2.2157100000000001</c:v>
                </c:pt>
                <c:pt idx="40">
                  <c:v>0.49125799999999997</c:v>
                </c:pt>
                <c:pt idx="41">
                  <c:v>0.211124000000000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7112960"/>
        <c:axId val="137229440"/>
      </c:barChart>
      <c:catAx>
        <c:axId val="13711296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37229440"/>
        <c:crosses val="autoZero"/>
        <c:auto val="1"/>
        <c:lblAlgn val="ctr"/>
        <c:lblOffset val="100"/>
        <c:noMultiLvlLbl val="0"/>
      </c:catAx>
      <c:valAx>
        <c:axId val="13722944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3711296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40</c:f>
              <c:strCache>
                <c:ptCount val="1"/>
                <c:pt idx="0">
                  <c:v>AAEL017471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40:$AQ$40</c:f>
              <c:numCache>
                <c:formatCode>General</c:formatCode>
                <c:ptCount val="42"/>
                <c:pt idx="0">
                  <c:v>0</c:v>
                </c:pt>
                <c:pt idx="1">
                  <c:v>0.18936</c:v>
                </c:pt>
                <c:pt idx="2">
                  <c:v>0</c:v>
                </c:pt>
                <c:pt idx="3">
                  <c:v>0.64007000000000003</c:v>
                </c:pt>
                <c:pt idx="4">
                  <c:v>0</c:v>
                </c:pt>
                <c:pt idx="5">
                  <c:v>0</c:v>
                </c:pt>
                <c:pt idx="6">
                  <c:v>148.53299999999999</c:v>
                </c:pt>
                <c:pt idx="7">
                  <c:v>0.40439900000000001</c:v>
                </c:pt>
                <c:pt idx="8">
                  <c:v>0.79757299999999998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.11483400000000001</c:v>
                </c:pt>
                <c:pt idx="13">
                  <c:v>695.78899999999999</c:v>
                </c:pt>
                <c:pt idx="14">
                  <c:v>38.908299999999997</c:v>
                </c:pt>
                <c:pt idx="15">
                  <c:v>20.585899999999999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.527339</c:v>
                </c:pt>
                <c:pt idx="33">
                  <c:v>0</c:v>
                </c:pt>
                <c:pt idx="34">
                  <c:v>0.102577</c:v>
                </c:pt>
                <c:pt idx="35">
                  <c:v>0</c:v>
                </c:pt>
                <c:pt idx="36">
                  <c:v>0</c:v>
                </c:pt>
                <c:pt idx="37">
                  <c:v>0.11257</c:v>
                </c:pt>
                <c:pt idx="38">
                  <c:v>0.10506</c:v>
                </c:pt>
                <c:pt idx="39">
                  <c:v>1.04589</c:v>
                </c:pt>
                <c:pt idx="40">
                  <c:v>0.102577</c:v>
                </c:pt>
                <c:pt idx="41">
                  <c:v>0.5995390000000000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2907904"/>
        <c:axId val="42602496"/>
      </c:barChart>
      <c:catAx>
        <c:axId val="4290790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42602496"/>
        <c:crosses val="autoZero"/>
        <c:auto val="1"/>
        <c:lblAlgn val="ctr"/>
        <c:lblOffset val="100"/>
        <c:noMultiLvlLbl val="0"/>
      </c:catAx>
      <c:valAx>
        <c:axId val="4260249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4290790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65</c:f>
              <c:strCache>
                <c:ptCount val="1"/>
                <c:pt idx="0">
                  <c:v>AAEL017501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65:$AQ$65</c:f>
              <c:numCache>
                <c:formatCode>General</c:formatCode>
                <c:ptCount val="4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2.1047899999999999</c:v>
                </c:pt>
                <c:pt idx="4">
                  <c:v>73.729100000000003</c:v>
                </c:pt>
                <c:pt idx="5">
                  <c:v>16.281700000000001</c:v>
                </c:pt>
                <c:pt idx="6">
                  <c:v>1.83335</c:v>
                </c:pt>
                <c:pt idx="7">
                  <c:v>1.7720199999999999</c:v>
                </c:pt>
                <c:pt idx="8">
                  <c:v>0</c:v>
                </c:pt>
                <c:pt idx="9">
                  <c:v>0</c:v>
                </c:pt>
                <c:pt idx="10">
                  <c:v>772.125</c:v>
                </c:pt>
                <c:pt idx="11">
                  <c:v>13379.4</c:v>
                </c:pt>
                <c:pt idx="12">
                  <c:v>17958.2</c:v>
                </c:pt>
                <c:pt idx="13">
                  <c:v>3.4941900000000001</c:v>
                </c:pt>
                <c:pt idx="14">
                  <c:v>1.5795699999999999</c:v>
                </c:pt>
                <c:pt idx="15">
                  <c:v>0.537219</c:v>
                </c:pt>
                <c:pt idx="16">
                  <c:v>0</c:v>
                </c:pt>
                <c:pt idx="17">
                  <c:v>0</c:v>
                </c:pt>
                <c:pt idx="18">
                  <c:v>0.42768400000000001</c:v>
                </c:pt>
                <c:pt idx="19">
                  <c:v>0</c:v>
                </c:pt>
                <c:pt idx="20">
                  <c:v>14.3843</c:v>
                </c:pt>
                <c:pt idx="21">
                  <c:v>3.69733</c:v>
                </c:pt>
                <c:pt idx="22">
                  <c:v>3.7275200000000002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5.89541</c:v>
                </c:pt>
                <c:pt idx="27">
                  <c:v>20.8947</c:v>
                </c:pt>
                <c:pt idx="28">
                  <c:v>5.6947799999999997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2.3121200000000002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1.1101799999999999</c:v>
                </c:pt>
                <c:pt idx="38">
                  <c:v>0.34537099999999998</c:v>
                </c:pt>
                <c:pt idx="39">
                  <c:v>0</c:v>
                </c:pt>
                <c:pt idx="40">
                  <c:v>0</c:v>
                </c:pt>
                <c:pt idx="41">
                  <c:v>276.011000000000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2668032"/>
        <c:axId val="42669568"/>
      </c:barChart>
      <c:catAx>
        <c:axId val="4266803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42669568"/>
        <c:crosses val="autoZero"/>
        <c:auto val="1"/>
        <c:lblAlgn val="ctr"/>
        <c:lblOffset val="100"/>
        <c:noMultiLvlLbl val="0"/>
      </c:catAx>
      <c:valAx>
        <c:axId val="42669568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4266803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49</c:f>
              <c:strCache>
                <c:ptCount val="1"/>
                <c:pt idx="0">
                  <c:v>AAEL000319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49:$AQ$49</c:f>
              <c:numCache>
                <c:formatCode>General</c:formatCode>
                <c:ptCount val="42"/>
                <c:pt idx="0">
                  <c:v>0</c:v>
                </c:pt>
                <c:pt idx="1">
                  <c:v>0.118865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7.9667000000000002E-2</c:v>
                </c:pt>
                <c:pt idx="6">
                  <c:v>0.116692</c:v>
                </c:pt>
                <c:pt idx="7">
                  <c:v>0.112859</c:v>
                </c:pt>
                <c:pt idx="8">
                  <c:v>0</c:v>
                </c:pt>
                <c:pt idx="9">
                  <c:v>0.12712699999999999</c:v>
                </c:pt>
                <c:pt idx="10">
                  <c:v>0.20974100000000001</c:v>
                </c:pt>
                <c:pt idx="11">
                  <c:v>0</c:v>
                </c:pt>
                <c:pt idx="12">
                  <c:v>0</c:v>
                </c:pt>
                <c:pt idx="13">
                  <c:v>0.37112899999999999</c:v>
                </c:pt>
                <c:pt idx="14">
                  <c:v>0.45213799999999998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.19606599999999999</c:v>
                </c:pt>
                <c:pt idx="21">
                  <c:v>6.4141299999999998E-2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6.79202E-2</c:v>
                </c:pt>
                <c:pt idx="29">
                  <c:v>0</c:v>
                </c:pt>
                <c:pt idx="30">
                  <c:v>6.5941200000000005E-2</c:v>
                </c:pt>
                <c:pt idx="31">
                  <c:v>0</c:v>
                </c:pt>
                <c:pt idx="32">
                  <c:v>0</c:v>
                </c:pt>
                <c:pt idx="33">
                  <c:v>6.8694199999999997E-2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.263793</c:v>
                </c:pt>
                <c:pt idx="39">
                  <c:v>1.3651199999999999</c:v>
                </c:pt>
                <c:pt idx="40">
                  <c:v>0</c:v>
                </c:pt>
                <c:pt idx="41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2801408"/>
        <c:axId val="42815488"/>
      </c:barChart>
      <c:catAx>
        <c:axId val="4280140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42815488"/>
        <c:crosses val="autoZero"/>
        <c:auto val="1"/>
        <c:lblAlgn val="ctr"/>
        <c:lblOffset val="100"/>
        <c:noMultiLvlLbl val="0"/>
      </c:catAx>
      <c:valAx>
        <c:axId val="42815488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4280140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48</c:f>
              <c:strCache>
                <c:ptCount val="1"/>
                <c:pt idx="0">
                  <c:v>AAEL000377-RA</c:v>
                </c:pt>
              </c:strCache>
            </c:strRef>
          </c:tx>
          <c:invertIfNegative val="0"/>
          <c:cat>
            <c:strRef>
              <c:f>Sheet1!$B$1:$AQ$1</c:f>
              <c:strCache>
                <c:ptCount val="42"/>
                <c:pt idx="0">
                  <c:v>11357_MaleTestes</c:v>
                </c:pt>
                <c:pt idx="1">
                  <c:v>11356_MaleCarcass</c:v>
                </c:pt>
                <c:pt idx="2">
                  <c:v>11358_NBF_Fcarcass</c:v>
                </c:pt>
                <c:pt idx="3">
                  <c:v>11780_12hr_BF_Fcarcass</c:v>
                </c:pt>
                <c:pt idx="4">
                  <c:v>11781_24hr_BF_carcass</c:v>
                </c:pt>
                <c:pt idx="5">
                  <c:v>12072_36hr_BF_Fcarcass</c:v>
                </c:pt>
                <c:pt idx="6">
                  <c:v>12073_48hr_BF_Fcarcass</c:v>
                </c:pt>
                <c:pt idx="7">
                  <c:v>12074_60hr_BF_Fcarcass</c:v>
                </c:pt>
                <c:pt idx="8">
                  <c:v>11361_72hr_BF_Fcarcass</c:v>
                </c:pt>
                <c:pt idx="9">
                  <c:v>11359_NBF_Ovaries</c:v>
                </c:pt>
                <c:pt idx="10">
                  <c:v>12hr BF ovaries_11511_FPKM</c:v>
                </c:pt>
                <c:pt idx="11">
                  <c:v>11512_24hr_BF_Ovaries</c:v>
                </c:pt>
                <c:pt idx="12">
                  <c:v>11513_36hr_BF_Ovaries</c:v>
                </c:pt>
                <c:pt idx="13">
                  <c:v>11514_48hr_BF_ovaries</c:v>
                </c:pt>
                <c:pt idx="14">
                  <c:v>11515_60hr_BF_ovaries</c:v>
                </c:pt>
                <c:pt idx="15">
                  <c:v>11360_72hr_BF_Ovaries</c:v>
                </c:pt>
                <c:pt idx="16">
                  <c:v>11362_0-2Hr_Embryos</c:v>
                </c:pt>
                <c:pt idx="17">
                  <c:v>11507_2-4hr_Embryos</c:v>
                </c:pt>
                <c:pt idx="18">
                  <c:v>11508_4-8hr_Embryos</c:v>
                </c:pt>
                <c:pt idx="19">
                  <c:v>11509_8-12hr_Embryos</c:v>
                </c:pt>
                <c:pt idx="20">
                  <c:v>11724_12-16hr_embryos</c:v>
                </c:pt>
                <c:pt idx="21">
                  <c:v>11772_16-20hr_Embryos</c:v>
                </c:pt>
                <c:pt idx="22">
                  <c:v>11773_20-24hr_embryos</c:v>
                </c:pt>
                <c:pt idx="23">
                  <c:v>12105_24-28hr_Embryos</c:v>
                </c:pt>
                <c:pt idx="24">
                  <c:v>12170_28-32hr_embryos</c:v>
                </c:pt>
                <c:pt idx="25">
                  <c:v>12171_32-36hr_embryos</c:v>
                </c:pt>
                <c:pt idx="26">
                  <c:v>11774_36-40hr_embryos</c:v>
                </c:pt>
                <c:pt idx="27">
                  <c:v>11775_40-44hr_embryos</c:v>
                </c:pt>
                <c:pt idx="28">
                  <c:v>11776_44-48hr_embryos</c:v>
                </c:pt>
                <c:pt idx="29">
                  <c:v>12172_48-52hr_embryos</c:v>
                </c:pt>
                <c:pt idx="30">
                  <c:v>12173_52-56hr_embryos</c:v>
                </c:pt>
                <c:pt idx="31">
                  <c:v>12106_56-60hr_Embryos</c:v>
                </c:pt>
                <c:pt idx="32">
                  <c:v>11777_60-64hr_embryos</c:v>
                </c:pt>
                <c:pt idx="33">
                  <c:v>12174_64-68hr_embryos</c:v>
                </c:pt>
                <c:pt idx="34">
                  <c:v>12175_68-72hr_embryos</c:v>
                </c:pt>
                <c:pt idx="35">
                  <c:v>12107_72-76hr_embryos</c:v>
                </c:pt>
                <c:pt idx="36">
                  <c:v>11782_1st_Instar_larvae</c:v>
                </c:pt>
                <c:pt idx="37">
                  <c:v>11783_2nd_Instar_larvae</c:v>
                </c:pt>
                <c:pt idx="38">
                  <c:v>11784_3rd_Instar_Larvae</c:v>
                </c:pt>
                <c:pt idx="39">
                  <c:v>11363_4th_instar_larvae</c:v>
                </c:pt>
                <c:pt idx="40">
                  <c:v>11725_MalePupae</c:v>
                </c:pt>
                <c:pt idx="41">
                  <c:v>11666_FemalePupae</c:v>
                </c:pt>
              </c:strCache>
            </c:strRef>
          </c:cat>
          <c:val>
            <c:numRef>
              <c:f>Sheet1!$B$48:$AQ$48</c:f>
              <c:numCache>
                <c:formatCode>General</c:formatCode>
                <c:ptCount val="4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1.6810400000000001</c:v>
                </c:pt>
                <c:pt idx="7">
                  <c:v>0.128359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7.8794700000000004</c:v>
                </c:pt>
                <c:pt idx="14">
                  <c:v>1.0284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5.3829000000000002E-2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4.9655400000000002E-2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5.3576400000000003E-2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9787264"/>
        <c:axId val="49788800"/>
      </c:barChart>
      <c:catAx>
        <c:axId val="4978726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49788800"/>
        <c:crosses val="autoZero"/>
        <c:auto val="1"/>
        <c:lblAlgn val="ctr"/>
        <c:lblOffset val="100"/>
        <c:noMultiLvlLbl val="0"/>
      </c:catAx>
      <c:valAx>
        <c:axId val="4978880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4978726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  <c:userShapes r:id="rId2"/>
</c:chartSpace>
</file>

<file path=ppt/drawings/_rels/drawing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png"/></Relationships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4815</cdr:x>
      <cdr:y>0.02778</cdr:y>
    </cdr:from>
    <cdr:to>
      <cdr:x>0.47685</cdr:x>
      <cdr:y>0.20114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219200" y="76206"/>
          <a:ext cx="2705100" cy="47555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sz="1400" dirty="0" smtClean="0"/>
            <a:t>Functional annotation</a:t>
          </a:r>
          <a:endParaRPr lang="en-US" sz="1400" dirty="0"/>
        </a:p>
      </cdr:txBody>
    </cdr:sp>
  </cdr:relSizeAnchor>
  <cdr:relSizeAnchor xmlns:cdr="http://schemas.openxmlformats.org/drawingml/2006/chartDrawing">
    <cdr:from>
      <cdr:x>0.07407</cdr:x>
      <cdr:y>0.16667</cdr:y>
    </cdr:from>
    <cdr:to>
      <cdr:x>0.98148</cdr:x>
      <cdr:y>0.61111</cdr:y>
    </cdr:to>
    <cdr:sp macro="" textlink="">
      <cdr:nvSpPr>
        <cdr:cNvPr id="3" name="Rectangle 2"/>
        <cdr:cNvSpPr/>
      </cdr:nvSpPr>
      <cdr:spPr>
        <a:xfrm xmlns:a="http://schemas.openxmlformats.org/drawingml/2006/main">
          <a:off x="609600" y="457200"/>
          <a:ext cx="7467600" cy="1219200"/>
        </a:xfrm>
        <a:prstGeom xmlns:a="http://schemas.openxmlformats.org/drawingml/2006/main" prst="rect">
          <a:avLst/>
        </a:prstGeom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66667</cdr:x>
      <cdr:y>0</cdr:y>
    </cdr:from>
    <cdr:to>
      <cdr:x>0.95833</cdr:x>
      <cdr:y>0.58333</cdr:y>
    </cdr:to>
    <cdr:pic>
      <cdr:nvPicPr>
        <cdr:cNvPr id="4" name="Picture 3" descr="http://www.aegep.bio.uci.edu/helperfxns/graph-error.php?id=AAEL013027-RA"/>
        <cdr:cNvPicPr>
          <a:picLocks xmlns:a="http://schemas.openxmlformats.org/drawingml/2006/main" noChangeAspect="1" noChangeArrowheads="1"/>
        </cdr:cNvPicPr>
      </cdr:nvPicPr>
      <cdr:blipFill>
        <a:blip xmlns:a="http://schemas.openxmlformats.org/drawingml/2006/main" xmlns:r="http://schemas.openxmlformats.org/officeDocument/2006/relationships" r:embed="rId1">
          <a:extLst>
            <a:ext uri="{28A0092B-C50C-407E-A947-70E740481C1C}">
              <a14:useLocalDpi xmlns:a14="http://schemas.microsoft.com/office/drawing/2010/main" val="0"/>
            </a:ext>
          </a:extLst>
        </a:blip>
        <a:srcRect xmlns:a="http://schemas.openxmlformats.org/drawingml/2006/main"/>
        <a:stretch xmlns:a="http://schemas.openxmlformats.org/drawingml/2006/main">
          <a:fillRect/>
        </a:stretch>
      </cdr:blipFill>
      <cdr:spPr bwMode="auto">
        <a:xfrm xmlns:a="http://schemas.openxmlformats.org/drawingml/2006/main">
          <a:off x="5486400" y="0"/>
          <a:ext cx="2400300" cy="1600200"/>
        </a:xfrm>
        <a:prstGeom xmlns:a="http://schemas.openxmlformats.org/drawingml/2006/main" prst="rect">
          <a:avLst/>
        </a:prstGeom>
        <a:noFill xmlns:a="http://schemas.openxmlformats.org/drawingml/2006/main"/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val="FFFFFF"/>
              </a:solidFill>
            </a14:hiddenFill>
          </a:ext>
        </a:extLst>
      </cdr:spPr>
    </cdr:pic>
  </cdr:relSizeAnchor>
  <cdr:relSizeAnchor xmlns:cdr="http://schemas.openxmlformats.org/drawingml/2006/chartDrawing">
    <cdr:from>
      <cdr:x>0.12963</cdr:x>
      <cdr:y>0.27778</cdr:y>
    </cdr:from>
    <cdr:to>
      <cdr:x>0.49074</cdr:x>
      <cdr:y>0.5</cdr:y>
    </cdr:to>
    <cdr:sp macro="" textlink="">
      <cdr:nvSpPr>
        <cdr:cNvPr id="5" name="TextBox 4"/>
        <cdr:cNvSpPr txBox="1"/>
      </cdr:nvSpPr>
      <cdr:spPr>
        <a:xfrm xmlns:a="http://schemas.openxmlformats.org/drawingml/2006/main">
          <a:off x="1066800" y="762000"/>
          <a:ext cx="2971800" cy="6096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US" sz="1100" dirty="0"/>
        </a:p>
      </cdr:txBody>
    </cdr:sp>
  </cdr:relSizeAnchor>
  <cdr:relSizeAnchor xmlns:cdr="http://schemas.openxmlformats.org/drawingml/2006/chartDrawing">
    <cdr:from>
      <cdr:x>0.07407</cdr:x>
      <cdr:y>0.19444</cdr:y>
    </cdr:from>
    <cdr:to>
      <cdr:x>0.60185</cdr:x>
      <cdr:y>0.69444</cdr:y>
    </cdr:to>
    <cdr:sp macro="" textlink="">
      <cdr:nvSpPr>
        <cdr:cNvPr id="6" name="TextBox 5"/>
        <cdr:cNvSpPr txBox="1"/>
      </cdr:nvSpPr>
      <cdr:spPr>
        <a:xfrm xmlns:a="http://schemas.openxmlformats.org/drawingml/2006/main">
          <a:off x="609600" y="533400"/>
          <a:ext cx="4343400" cy="13716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sz="3200" dirty="0" smtClean="0">
              <a:solidFill>
                <a:srgbClr val="000000"/>
              </a:solidFill>
              <a:latin typeface="Arial" charset="0"/>
            </a:rPr>
            <a:t>Data from </a:t>
          </a:r>
          <a:r>
            <a:rPr lang="en-US" sz="3200" dirty="0" err="1" smtClean="0">
              <a:solidFill>
                <a:srgbClr val="000000"/>
              </a:solidFill>
              <a:latin typeface="Arial" charset="0"/>
            </a:rPr>
            <a:t>Akbari</a:t>
          </a:r>
          <a:r>
            <a:rPr lang="en-US" sz="3200" dirty="0" smtClean="0">
              <a:solidFill>
                <a:srgbClr val="000000"/>
              </a:solidFill>
              <a:latin typeface="Arial" charset="0"/>
            </a:rPr>
            <a:t> et al., 2013 </a:t>
          </a:r>
          <a:endParaRPr lang="en-US" sz="3200" dirty="0"/>
        </a:p>
      </cdr:txBody>
    </cdr:sp>
  </cdr:relSizeAnchor>
</c:userShapes>
</file>

<file path=ppt/drawings/drawing10.xml><?xml version="1.0" encoding="utf-8"?>
<c:userShapes xmlns:c="http://schemas.openxmlformats.org/drawingml/2006/chart">
  <cdr:relSizeAnchor xmlns:cdr="http://schemas.openxmlformats.org/drawingml/2006/chartDrawing">
    <cdr:from>
      <cdr:x>0.16358</cdr:x>
      <cdr:y>0.07407</cdr:y>
    </cdr:from>
    <cdr:to>
      <cdr:x>0.36728</cdr:x>
      <cdr:y>0.18519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346200" y="203200"/>
          <a:ext cx="1676400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 smtClean="0"/>
            <a:t>AaegOBP112 / matype4</a:t>
          </a:r>
          <a:endParaRPr lang="en-US" sz="1100" dirty="0"/>
        </a:p>
      </cdr:txBody>
    </cdr:sp>
  </cdr:relSizeAnchor>
</c:userShapes>
</file>

<file path=ppt/drawings/drawing11.xml><?xml version="1.0" encoding="utf-8"?>
<c:userShapes xmlns:c="http://schemas.openxmlformats.org/drawingml/2006/chart">
  <cdr:relSizeAnchor xmlns:cdr="http://schemas.openxmlformats.org/drawingml/2006/chartDrawing">
    <cdr:from>
      <cdr:x>0.16358</cdr:x>
      <cdr:y>0.07407</cdr:y>
    </cdr:from>
    <cdr:to>
      <cdr:x>0.36728</cdr:x>
      <cdr:y>0.18519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346200" y="203200"/>
          <a:ext cx="1676400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 smtClean="0"/>
            <a:t>AaegOBP106 / matype2</a:t>
          </a:r>
          <a:endParaRPr lang="en-US" sz="1100" dirty="0"/>
        </a:p>
      </cdr:txBody>
    </cdr:sp>
  </cdr:relSizeAnchor>
</c:userShapes>
</file>

<file path=ppt/drawings/drawing12.xml><?xml version="1.0" encoding="utf-8"?>
<c:userShapes xmlns:c="http://schemas.openxmlformats.org/drawingml/2006/chart">
  <cdr:relSizeAnchor xmlns:cdr="http://schemas.openxmlformats.org/drawingml/2006/chartDrawing">
    <cdr:from>
      <cdr:x>0.16358</cdr:x>
      <cdr:y>0.07407</cdr:y>
    </cdr:from>
    <cdr:to>
      <cdr:x>0.36728</cdr:x>
      <cdr:y>0.18519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346200" y="203200"/>
          <a:ext cx="1676400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 smtClean="0"/>
            <a:t>AaegOBP16 / matype4</a:t>
          </a:r>
          <a:endParaRPr lang="en-US" sz="1100" dirty="0"/>
        </a:p>
      </cdr:txBody>
    </cdr:sp>
  </cdr:relSizeAnchor>
</c:userShapes>
</file>

<file path=ppt/drawings/drawing13.xml><?xml version="1.0" encoding="utf-8"?>
<c:userShapes xmlns:c="http://schemas.openxmlformats.org/drawingml/2006/chart">
  <cdr:relSizeAnchor xmlns:cdr="http://schemas.openxmlformats.org/drawingml/2006/chartDrawing">
    <cdr:from>
      <cdr:x>0.16358</cdr:x>
      <cdr:y>0.07407</cdr:y>
    </cdr:from>
    <cdr:to>
      <cdr:x>0.36728</cdr:x>
      <cdr:y>0.18519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346200" y="203200"/>
          <a:ext cx="1676400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 smtClean="0"/>
            <a:t>AaegOBP87 / matype4</a:t>
          </a:r>
          <a:endParaRPr lang="en-US" sz="1100" dirty="0"/>
        </a:p>
      </cdr:txBody>
    </cdr:sp>
  </cdr:relSizeAnchor>
</c:userShapes>
</file>

<file path=ppt/drawings/drawing14.xml><?xml version="1.0" encoding="utf-8"?>
<c:userShapes xmlns:c="http://schemas.openxmlformats.org/drawingml/2006/chart">
  <cdr:relSizeAnchor xmlns:cdr="http://schemas.openxmlformats.org/drawingml/2006/chartDrawing">
    <cdr:from>
      <cdr:x>0.16358</cdr:x>
      <cdr:y>0.07407</cdr:y>
    </cdr:from>
    <cdr:to>
      <cdr:x>0.36728</cdr:x>
      <cdr:y>0.18519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346200" y="203200"/>
          <a:ext cx="1676400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 smtClean="0"/>
            <a:t>AaegOBP100 / matype4</a:t>
          </a:r>
          <a:endParaRPr lang="en-US" sz="1100" dirty="0"/>
        </a:p>
      </cdr:txBody>
    </cdr:sp>
  </cdr:relSizeAnchor>
</c:userShapes>
</file>

<file path=ppt/drawings/drawing15.xml><?xml version="1.0" encoding="utf-8"?>
<c:userShapes xmlns:c="http://schemas.openxmlformats.org/drawingml/2006/chart">
  <cdr:relSizeAnchor xmlns:cdr="http://schemas.openxmlformats.org/drawingml/2006/chartDrawing">
    <cdr:from>
      <cdr:x>0.16358</cdr:x>
      <cdr:y>0.07407</cdr:y>
    </cdr:from>
    <cdr:to>
      <cdr:x>0.36728</cdr:x>
      <cdr:y>0.18519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346200" y="203200"/>
          <a:ext cx="1676400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 smtClean="0"/>
            <a:t>AaegOBP101 / matype4</a:t>
          </a:r>
          <a:endParaRPr lang="en-US" sz="1100" dirty="0"/>
        </a:p>
      </cdr:txBody>
    </cdr:sp>
  </cdr:relSizeAnchor>
</c:userShapes>
</file>

<file path=ppt/drawings/drawing16.xml><?xml version="1.0" encoding="utf-8"?>
<c:userShapes xmlns:c="http://schemas.openxmlformats.org/drawingml/2006/chart">
  <cdr:relSizeAnchor xmlns:cdr="http://schemas.openxmlformats.org/drawingml/2006/chartDrawing">
    <cdr:from>
      <cdr:x>0.16358</cdr:x>
      <cdr:y>0.07407</cdr:y>
    </cdr:from>
    <cdr:to>
      <cdr:x>0.36728</cdr:x>
      <cdr:y>0.18519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346200" y="203200"/>
          <a:ext cx="1676400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 smtClean="0"/>
            <a:t>AaegOBP102 / matype4</a:t>
          </a:r>
          <a:endParaRPr lang="en-US" sz="1100" dirty="0"/>
        </a:p>
      </cdr:txBody>
    </cdr:sp>
  </cdr:relSizeAnchor>
</c:userShapes>
</file>

<file path=ppt/drawings/drawing17.xml><?xml version="1.0" encoding="utf-8"?>
<c:userShapes xmlns:c="http://schemas.openxmlformats.org/drawingml/2006/chart">
  <cdr:relSizeAnchor xmlns:cdr="http://schemas.openxmlformats.org/drawingml/2006/chartDrawing">
    <cdr:from>
      <cdr:x>0.16358</cdr:x>
      <cdr:y>0.07407</cdr:y>
    </cdr:from>
    <cdr:to>
      <cdr:x>0.36728</cdr:x>
      <cdr:y>0.18519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346200" y="203200"/>
          <a:ext cx="1676400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 smtClean="0"/>
            <a:t>AaegOBP86 / matype4</a:t>
          </a:r>
          <a:endParaRPr lang="en-US" sz="1100" dirty="0"/>
        </a:p>
      </cdr:txBody>
    </cdr:sp>
  </cdr:relSizeAnchor>
</c:userShapes>
</file>

<file path=ppt/drawings/drawing18.xml><?xml version="1.0" encoding="utf-8"?>
<c:userShapes xmlns:c="http://schemas.openxmlformats.org/drawingml/2006/chart">
  <cdr:relSizeAnchor xmlns:cdr="http://schemas.openxmlformats.org/drawingml/2006/chartDrawing">
    <cdr:from>
      <cdr:x>0.16358</cdr:x>
      <cdr:y>0.07407</cdr:y>
    </cdr:from>
    <cdr:to>
      <cdr:x>0.36728</cdr:x>
      <cdr:y>0.18519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346200" y="203200"/>
          <a:ext cx="1676400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 smtClean="0"/>
            <a:t>AaegOBP33 / matype3</a:t>
          </a:r>
          <a:endParaRPr lang="en-US" sz="1100" dirty="0"/>
        </a:p>
      </cdr:txBody>
    </cdr:sp>
  </cdr:relSizeAnchor>
</c:userShapes>
</file>

<file path=ppt/drawings/drawing19.xml><?xml version="1.0" encoding="utf-8"?>
<c:userShapes xmlns:c="http://schemas.openxmlformats.org/drawingml/2006/chart">
  <cdr:relSizeAnchor xmlns:cdr="http://schemas.openxmlformats.org/drawingml/2006/chartDrawing">
    <cdr:from>
      <cdr:x>0.16358</cdr:x>
      <cdr:y>0.07407</cdr:y>
    </cdr:from>
    <cdr:to>
      <cdr:x>0.36728</cdr:x>
      <cdr:y>0.18519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346200" y="203200"/>
          <a:ext cx="1676400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 smtClean="0"/>
            <a:t>AaegOBP29 / matype3</a:t>
          </a:r>
          <a:endParaRPr lang="en-US" sz="1100" dirty="0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27778</cdr:x>
      <cdr:y>0.02778</cdr:y>
    </cdr:from>
    <cdr:to>
      <cdr:x>0.40741</cdr:x>
      <cdr:y>0.13889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2286000" y="76200"/>
          <a:ext cx="1066800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sz="1400" dirty="0" smtClean="0"/>
            <a:t>VMP 15a-3</a:t>
          </a:r>
          <a:endParaRPr lang="en-US" sz="1400" dirty="0"/>
        </a:p>
      </cdr:txBody>
    </cdr:sp>
  </cdr:relSizeAnchor>
</c:userShapes>
</file>

<file path=ppt/drawings/drawing20.xml><?xml version="1.0" encoding="utf-8"?>
<c:userShapes xmlns:c="http://schemas.openxmlformats.org/drawingml/2006/chart">
  <cdr:relSizeAnchor xmlns:cdr="http://schemas.openxmlformats.org/drawingml/2006/chartDrawing">
    <cdr:from>
      <cdr:x>0.16975</cdr:x>
      <cdr:y>0.09259</cdr:y>
    </cdr:from>
    <cdr:to>
      <cdr:x>0.37346</cdr:x>
      <cdr:y>0.2037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397000" y="254000"/>
          <a:ext cx="1676400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 smtClean="0"/>
            <a:t>AaegOBP28 / matype3</a:t>
          </a:r>
          <a:endParaRPr lang="en-US" sz="1100" dirty="0"/>
        </a:p>
      </cdr:txBody>
    </cdr:sp>
  </cdr:relSizeAnchor>
</c:userShapes>
</file>

<file path=ppt/drawings/drawing21.xml><?xml version="1.0" encoding="utf-8"?>
<c:userShapes xmlns:c="http://schemas.openxmlformats.org/drawingml/2006/chart">
  <cdr:relSizeAnchor xmlns:cdr="http://schemas.openxmlformats.org/drawingml/2006/chartDrawing">
    <cdr:from>
      <cdr:x>0.16975</cdr:x>
      <cdr:y>0.09259</cdr:y>
    </cdr:from>
    <cdr:to>
      <cdr:x>0.37346</cdr:x>
      <cdr:y>0.2037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397000" y="254000"/>
          <a:ext cx="1676400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 smtClean="0"/>
            <a:t>AaegOBP31 / matype3</a:t>
          </a:r>
          <a:endParaRPr lang="en-US" sz="1100" dirty="0"/>
        </a:p>
      </cdr:txBody>
    </cdr:sp>
  </cdr:relSizeAnchor>
</c:userShapes>
</file>

<file path=ppt/drawings/drawing22.xml><?xml version="1.0" encoding="utf-8"?>
<c:userShapes xmlns:c="http://schemas.openxmlformats.org/drawingml/2006/chart">
  <cdr:relSizeAnchor xmlns:cdr="http://schemas.openxmlformats.org/drawingml/2006/chartDrawing">
    <cdr:from>
      <cdr:x>0.16975</cdr:x>
      <cdr:y>0.09259</cdr:y>
    </cdr:from>
    <cdr:to>
      <cdr:x>0.37346</cdr:x>
      <cdr:y>0.2037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397000" y="254000"/>
          <a:ext cx="1676400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 smtClean="0"/>
            <a:t>AaegOBP32 / matype3</a:t>
          </a:r>
          <a:endParaRPr lang="en-US" sz="1100" dirty="0"/>
        </a:p>
      </cdr:txBody>
    </cdr:sp>
  </cdr:relSizeAnchor>
</c:userShapes>
</file>

<file path=ppt/drawings/drawing23.xml><?xml version="1.0" encoding="utf-8"?>
<c:userShapes xmlns:c="http://schemas.openxmlformats.org/drawingml/2006/chart">
  <cdr:relSizeAnchor xmlns:cdr="http://schemas.openxmlformats.org/drawingml/2006/chartDrawing">
    <cdr:from>
      <cdr:x>0.16975</cdr:x>
      <cdr:y>0.09259</cdr:y>
    </cdr:from>
    <cdr:to>
      <cdr:x>0.37346</cdr:x>
      <cdr:y>0.2037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397000" y="254000"/>
          <a:ext cx="1676400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 smtClean="0"/>
            <a:t>AaegOBP109 / matype2</a:t>
          </a:r>
          <a:endParaRPr lang="en-US" sz="1100" dirty="0"/>
        </a:p>
      </cdr:txBody>
    </cdr:sp>
  </cdr:relSizeAnchor>
</c:userShapes>
</file>

<file path=ppt/drawings/drawing24.xml><?xml version="1.0" encoding="utf-8"?>
<c:userShapes xmlns:c="http://schemas.openxmlformats.org/drawingml/2006/chart">
  <cdr:relSizeAnchor xmlns:cdr="http://schemas.openxmlformats.org/drawingml/2006/chartDrawing">
    <cdr:from>
      <cdr:x>0.16975</cdr:x>
      <cdr:y>0.09259</cdr:y>
    </cdr:from>
    <cdr:to>
      <cdr:x>0.37346</cdr:x>
      <cdr:y>0.2037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397000" y="254000"/>
          <a:ext cx="1676400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 smtClean="0"/>
            <a:t>AaegOBP41 / matype1</a:t>
          </a:r>
          <a:endParaRPr lang="en-US" sz="1100" dirty="0"/>
        </a:p>
      </cdr:txBody>
    </cdr:sp>
  </cdr:relSizeAnchor>
</c:userShapes>
</file>

<file path=ppt/drawings/drawing25.xml><?xml version="1.0" encoding="utf-8"?>
<c:userShapes xmlns:c="http://schemas.openxmlformats.org/drawingml/2006/chart">
  <cdr:relSizeAnchor xmlns:cdr="http://schemas.openxmlformats.org/drawingml/2006/chartDrawing">
    <cdr:from>
      <cdr:x>0.16975</cdr:x>
      <cdr:y>0.09259</cdr:y>
    </cdr:from>
    <cdr:to>
      <cdr:x>0.37346</cdr:x>
      <cdr:y>0.2037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397000" y="254000"/>
          <a:ext cx="1676400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 smtClean="0"/>
            <a:t>AaegOBP44 / matype4</a:t>
          </a:r>
          <a:endParaRPr lang="en-US" sz="1100" dirty="0"/>
        </a:p>
      </cdr:txBody>
    </cdr:sp>
  </cdr:relSizeAnchor>
</c:userShapes>
</file>

<file path=ppt/drawings/drawing26.xml><?xml version="1.0" encoding="utf-8"?>
<c:userShapes xmlns:c="http://schemas.openxmlformats.org/drawingml/2006/chart">
  <cdr:relSizeAnchor xmlns:cdr="http://schemas.openxmlformats.org/drawingml/2006/chartDrawing">
    <cdr:from>
      <cdr:x>0.16975</cdr:x>
      <cdr:y>0.09259</cdr:y>
    </cdr:from>
    <cdr:to>
      <cdr:x>0.37346</cdr:x>
      <cdr:y>0.2037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397000" y="254000"/>
          <a:ext cx="1676400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 smtClean="0"/>
            <a:t>AaegOBP46 / matype4</a:t>
          </a:r>
          <a:endParaRPr lang="en-US" sz="1100" dirty="0"/>
        </a:p>
      </cdr:txBody>
    </cdr:sp>
  </cdr:relSizeAnchor>
</c:userShapes>
</file>

<file path=ppt/drawings/drawing27.xml><?xml version="1.0" encoding="utf-8"?>
<c:userShapes xmlns:c="http://schemas.openxmlformats.org/drawingml/2006/chart">
  <cdr:relSizeAnchor xmlns:cdr="http://schemas.openxmlformats.org/drawingml/2006/chartDrawing">
    <cdr:from>
      <cdr:x>0.6363</cdr:x>
      <cdr:y>0.05556</cdr:y>
    </cdr:from>
    <cdr:to>
      <cdr:x>0.84001</cdr:x>
      <cdr:y>0.16667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5236510" y="152400"/>
          <a:ext cx="1676400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 smtClean="0"/>
            <a:t>AaegOBP75 / </a:t>
          </a:r>
          <a:r>
            <a:rPr lang="en-US" dirty="0" err="1" smtClean="0"/>
            <a:t>plusC</a:t>
          </a:r>
          <a:r>
            <a:rPr lang="en-US" dirty="0" smtClean="0"/>
            <a:t> type</a:t>
          </a:r>
          <a:endParaRPr lang="en-US" sz="1100" dirty="0"/>
        </a:p>
      </cdr:txBody>
    </cdr:sp>
  </cdr:relSizeAnchor>
</c:userShapes>
</file>

<file path=ppt/drawings/drawing28.xml><?xml version="1.0" encoding="utf-8"?>
<c:userShapes xmlns:c="http://schemas.openxmlformats.org/drawingml/2006/chart">
  <cdr:relSizeAnchor xmlns:cdr="http://schemas.openxmlformats.org/drawingml/2006/chartDrawing">
    <cdr:from>
      <cdr:x>0.16975</cdr:x>
      <cdr:y>0.09259</cdr:y>
    </cdr:from>
    <cdr:to>
      <cdr:x>0.37346</cdr:x>
      <cdr:y>0.2037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397000" y="254000"/>
          <a:ext cx="1676400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 smtClean="0"/>
            <a:t>AaegOBP90 / matype2</a:t>
          </a:r>
          <a:endParaRPr lang="en-US" sz="1100" dirty="0"/>
        </a:p>
      </cdr:txBody>
    </cdr:sp>
  </cdr:relSizeAnchor>
</c:userShapes>
</file>

<file path=ppt/drawings/drawing29.xml><?xml version="1.0" encoding="utf-8"?>
<c:userShapes xmlns:c="http://schemas.openxmlformats.org/drawingml/2006/chart">
  <cdr:relSizeAnchor xmlns:cdr="http://schemas.openxmlformats.org/drawingml/2006/chartDrawing">
    <cdr:from>
      <cdr:x>0.16975</cdr:x>
      <cdr:y>0.09259</cdr:y>
    </cdr:from>
    <cdr:to>
      <cdr:x>0.37346</cdr:x>
      <cdr:y>0.2037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397000" y="254000"/>
          <a:ext cx="1676400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 smtClean="0"/>
            <a:t>AaegOBP107 / matype2</a:t>
          </a:r>
          <a:endParaRPr lang="en-US" sz="1100" dirty="0"/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28704</cdr:x>
      <cdr:y>0.02778</cdr:y>
    </cdr:from>
    <cdr:to>
      <cdr:x>0.41667</cdr:x>
      <cdr:y>0.13889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2362200" y="76200"/>
          <a:ext cx="1066800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dirty="0" smtClean="0"/>
            <a:t>VMP 15a-1</a:t>
          </a:r>
          <a:endParaRPr lang="en-US" sz="1400" dirty="0"/>
        </a:p>
      </cdr:txBody>
    </cdr:sp>
  </cdr:relSizeAnchor>
</c:userShapes>
</file>

<file path=ppt/drawings/drawing30.xml><?xml version="1.0" encoding="utf-8"?>
<c:userShapes xmlns:c="http://schemas.openxmlformats.org/drawingml/2006/chart">
  <cdr:relSizeAnchor xmlns:cdr="http://schemas.openxmlformats.org/drawingml/2006/chartDrawing">
    <cdr:from>
      <cdr:x>0.16975</cdr:x>
      <cdr:y>0.09259</cdr:y>
    </cdr:from>
    <cdr:to>
      <cdr:x>0.37346</cdr:x>
      <cdr:y>0.2037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397000" y="254000"/>
          <a:ext cx="1676400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 smtClean="0"/>
            <a:t>AaegOBP91 / matype2</a:t>
          </a:r>
          <a:endParaRPr lang="en-US" sz="1100" dirty="0"/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28395</cdr:x>
      <cdr:y>0.0463</cdr:y>
    </cdr:from>
    <cdr:to>
      <cdr:x>0.41358</cdr:x>
      <cdr:y>0.1574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2336800" y="127000"/>
          <a:ext cx="1066800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dirty="0" smtClean="0"/>
            <a:t>VMP 15a-2</a:t>
          </a:r>
          <a:endParaRPr lang="en-US" sz="1400" dirty="0"/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15741</cdr:x>
      <cdr:y>0.05556</cdr:y>
    </cdr:from>
    <cdr:to>
      <cdr:x>0.36111</cdr:x>
      <cdr:y>0.16667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295400" y="152400"/>
          <a:ext cx="1676400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sz="1100" dirty="0" smtClean="0"/>
            <a:t>AaegOBP93 / matype2</a:t>
          </a:r>
          <a:endParaRPr lang="en-US" sz="1100" dirty="0"/>
        </a:p>
      </cdr:txBody>
    </cdr: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.18519</cdr:x>
      <cdr:y>0.02778</cdr:y>
    </cdr:from>
    <cdr:to>
      <cdr:x>0.38889</cdr:x>
      <cdr:y>0.13889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524000" y="76200"/>
          <a:ext cx="1676400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 smtClean="0"/>
            <a:t>AaegOBP89 / matype2</a:t>
          </a:r>
          <a:endParaRPr lang="en-US" sz="1100" dirty="0"/>
        </a:p>
      </cdr:txBody>
    </cdr:sp>
  </cdr:relSizeAnchor>
</c:userShapes>
</file>

<file path=ppt/drawings/drawing7.xml><?xml version="1.0" encoding="utf-8"?>
<c:userShapes xmlns:c="http://schemas.openxmlformats.org/drawingml/2006/chart">
  <cdr:relSizeAnchor xmlns:cdr="http://schemas.openxmlformats.org/drawingml/2006/chartDrawing">
    <cdr:from>
      <cdr:x>0.16358</cdr:x>
      <cdr:y>0.07407</cdr:y>
    </cdr:from>
    <cdr:to>
      <cdr:x>0.36728</cdr:x>
      <cdr:y>0.18519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346200" y="203200"/>
          <a:ext cx="1676400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 smtClean="0"/>
            <a:t>AaegOBP96 / matype4</a:t>
          </a:r>
          <a:endParaRPr lang="en-US" sz="1100" dirty="0"/>
        </a:p>
      </cdr:txBody>
    </cdr:sp>
  </cdr:relSizeAnchor>
</c:userShapes>
</file>

<file path=ppt/drawings/drawing8.xml><?xml version="1.0" encoding="utf-8"?>
<c:userShapes xmlns:c="http://schemas.openxmlformats.org/drawingml/2006/chart">
  <cdr:relSizeAnchor xmlns:cdr="http://schemas.openxmlformats.org/drawingml/2006/chartDrawing">
    <cdr:from>
      <cdr:x>0.16358</cdr:x>
      <cdr:y>0.07407</cdr:y>
    </cdr:from>
    <cdr:to>
      <cdr:x>0.36728</cdr:x>
      <cdr:y>0.18519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346200" y="203200"/>
          <a:ext cx="1676400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 smtClean="0"/>
            <a:t>AaegOBP7 / matype4</a:t>
          </a:r>
          <a:endParaRPr lang="en-US" sz="1100" dirty="0"/>
        </a:p>
      </cdr:txBody>
    </cdr:sp>
  </cdr:relSizeAnchor>
</c:userShapes>
</file>

<file path=ppt/drawings/drawing9.xml><?xml version="1.0" encoding="utf-8"?>
<c:userShapes xmlns:c="http://schemas.openxmlformats.org/drawingml/2006/chart">
  <cdr:relSizeAnchor xmlns:cdr="http://schemas.openxmlformats.org/drawingml/2006/chartDrawing">
    <cdr:from>
      <cdr:x>0.16358</cdr:x>
      <cdr:y>0.07407</cdr:y>
    </cdr:from>
    <cdr:to>
      <cdr:x>0.36728</cdr:x>
      <cdr:y>0.18519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346200" y="203200"/>
          <a:ext cx="1676400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 smtClean="0"/>
            <a:t>AaegOBP97 / matype4</a:t>
          </a:r>
          <a:endParaRPr lang="en-US" sz="1100" dirty="0"/>
        </a:p>
      </cdr:txBody>
    </cdr:sp>
  </cdr:relSizeAnchor>
</c:userShape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21702CD-4A1A-4325-BDD7-97DFC5D3C08E}" type="datetimeFigureOut">
              <a:rPr lang="en-US" smtClean="0"/>
              <a:t>3/13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1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9292526-32BE-46DA-8C48-ECC4E30287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92067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C1663-D9F7-4141-A164-940D4E8A806F}" type="datetimeFigureOut">
              <a:rPr lang="en-US" smtClean="0"/>
              <a:t>3/1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EBD8B-E8DD-45C6-B13C-74CAEC79F9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62870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C1663-D9F7-4141-A164-940D4E8A806F}" type="datetimeFigureOut">
              <a:rPr lang="en-US" smtClean="0"/>
              <a:t>3/1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EBD8B-E8DD-45C6-B13C-74CAEC79F9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74124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C1663-D9F7-4141-A164-940D4E8A806F}" type="datetimeFigureOut">
              <a:rPr lang="en-US" smtClean="0"/>
              <a:t>3/1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EBD8B-E8DD-45C6-B13C-74CAEC79F9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30798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C1663-D9F7-4141-A164-940D4E8A806F}" type="datetimeFigureOut">
              <a:rPr lang="en-US" smtClean="0"/>
              <a:t>3/1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EBD8B-E8DD-45C6-B13C-74CAEC79F9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07048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C1663-D9F7-4141-A164-940D4E8A806F}" type="datetimeFigureOut">
              <a:rPr lang="en-US" smtClean="0"/>
              <a:t>3/1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EBD8B-E8DD-45C6-B13C-74CAEC79F9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81493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C1663-D9F7-4141-A164-940D4E8A806F}" type="datetimeFigureOut">
              <a:rPr lang="en-US" smtClean="0"/>
              <a:t>3/13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EBD8B-E8DD-45C6-B13C-74CAEC79F9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90071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C1663-D9F7-4141-A164-940D4E8A806F}" type="datetimeFigureOut">
              <a:rPr lang="en-US" smtClean="0"/>
              <a:t>3/13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EBD8B-E8DD-45C6-B13C-74CAEC79F9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68903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C1663-D9F7-4141-A164-940D4E8A806F}" type="datetimeFigureOut">
              <a:rPr lang="en-US" smtClean="0"/>
              <a:t>3/13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EBD8B-E8DD-45C6-B13C-74CAEC79F9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69048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C1663-D9F7-4141-A164-940D4E8A806F}" type="datetimeFigureOut">
              <a:rPr lang="en-US" smtClean="0"/>
              <a:t>3/13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EBD8B-E8DD-45C6-B13C-74CAEC79F9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31615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C1663-D9F7-4141-A164-940D4E8A806F}" type="datetimeFigureOut">
              <a:rPr lang="en-US" smtClean="0"/>
              <a:t>3/13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EBD8B-E8DD-45C6-B13C-74CAEC79F9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34363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C1663-D9F7-4141-A164-940D4E8A806F}" type="datetimeFigureOut">
              <a:rPr lang="en-US" smtClean="0"/>
              <a:t>3/13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EBD8B-E8DD-45C6-B13C-74CAEC79F9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580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9C1663-D9F7-4141-A164-940D4E8A806F}" type="datetimeFigureOut">
              <a:rPr lang="en-US" smtClean="0"/>
              <a:t>3/1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2EBD8B-E8DD-45C6-B13C-74CAEC79F9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47675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chart" Target="../charts/chart18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4.png"/><Relationship Id="rId4" Type="http://schemas.openxmlformats.org/officeDocument/2006/relationships/chart" Target="../charts/chart19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chart" Target="../charts/chart20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6.png"/><Relationship Id="rId4" Type="http://schemas.openxmlformats.org/officeDocument/2006/relationships/chart" Target="../charts/chart21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chart" Target="../charts/chart2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8.png"/><Relationship Id="rId4" Type="http://schemas.openxmlformats.org/officeDocument/2006/relationships/chart" Target="../charts/chart23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chart" Target="../charts/chart24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0.png"/><Relationship Id="rId4" Type="http://schemas.openxmlformats.org/officeDocument/2006/relationships/chart" Target="../charts/chart25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chart" Target="../charts/chart26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2.png"/><Relationship Id="rId4" Type="http://schemas.openxmlformats.org/officeDocument/2006/relationships/chart" Target="../charts/chart2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chart" Target="../charts/chart28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4.png"/><Relationship Id="rId4" Type="http://schemas.openxmlformats.org/officeDocument/2006/relationships/chart" Target="../charts/chart29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chart" Target="../charts/chart30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6.png"/><Relationship Id="rId4" Type="http://schemas.openxmlformats.org/officeDocument/2006/relationships/chart" Target="../charts/chart31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3.xml"/><Relationship Id="rId2" Type="http://schemas.openxmlformats.org/officeDocument/2006/relationships/chart" Target="../charts/chart3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chart" Target="../charts/chart34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0.png"/><Relationship Id="rId4" Type="http://schemas.openxmlformats.org/officeDocument/2006/relationships/chart" Target="../charts/chart35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chart" Target="../charts/chart36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2.png"/><Relationship Id="rId4" Type="http://schemas.openxmlformats.org/officeDocument/2006/relationships/chart" Target="../charts/chart3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.png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chart" Target="../charts/chart38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4.png"/><Relationship Id="rId4" Type="http://schemas.openxmlformats.org/officeDocument/2006/relationships/chart" Target="../charts/chart39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chart" Target="../charts/chart40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6.png"/><Relationship Id="rId4" Type="http://schemas.openxmlformats.org/officeDocument/2006/relationships/chart" Target="../charts/chart41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2" Type="http://schemas.openxmlformats.org/officeDocument/2006/relationships/chart" Target="../charts/chart4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8.png"/><Relationship Id="rId4" Type="http://schemas.openxmlformats.org/officeDocument/2006/relationships/chart" Target="../charts/chart43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png"/><Relationship Id="rId2" Type="http://schemas.openxmlformats.org/officeDocument/2006/relationships/chart" Target="../charts/chart44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0.png"/><Relationship Id="rId4" Type="http://schemas.openxmlformats.org/officeDocument/2006/relationships/chart" Target="../charts/chart45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png"/><Relationship Id="rId2" Type="http://schemas.openxmlformats.org/officeDocument/2006/relationships/chart" Target="../charts/chart46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2.png"/><Relationship Id="rId4" Type="http://schemas.openxmlformats.org/officeDocument/2006/relationships/chart" Target="../charts/chart47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9.xml"/><Relationship Id="rId2" Type="http://schemas.openxmlformats.org/officeDocument/2006/relationships/chart" Target="../charts/chart48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4.png"/><Relationship Id="rId4" Type="http://schemas.openxmlformats.org/officeDocument/2006/relationships/image" Target="../media/image43.png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1.xml"/><Relationship Id="rId2" Type="http://schemas.openxmlformats.org/officeDocument/2006/relationships/chart" Target="../charts/chart50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6.png"/><Relationship Id="rId4" Type="http://schemas.openxmlformats.org/officeDocument/2006/relationships/image" Target="../media/image45.png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png"/><Relationship Id="rId2" Type="http://schemas.openxmlformats.org/officeDocument/2006/relationships/chart" Target="../charts/chart5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8.png"/><Relationship Id="rId4" Type="http://schemas.openxmlformats.org/officeDocument/2006/relationships/chart" Target="../charts/chart53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5.xml"/><Relationship Id="rId2" Type="http://schemas.openxmlformats.org/officeDocument/2006/relationships/chart" Target="../charts/chart5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9.png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png"/><Relationship Id="rId2" Type="http://schemas.openxmlformats.org/officeDocument/2006/relationships/chart" Target="../charts/chart56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1.png"/><Relationship Id="rId4" Type="http://schemas.openxmlformats.org/officeDocument/2006/relationships/chart" Target="../charts/chart5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png"/><Relationship Id="rId2" Type="http://schemas.openxmlformats.org/officeDocument/2006/relationships/chart" Target="../charts/chart58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.xml"/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chart" Target="../charts/chart8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chart" Target="../charts/chart9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chart" Target="../charts/chart10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png"/><Relationship Id="rId4" Type="http://schemas.openxmlformats.org/officeDocument/2006/relationships/chart" Target="../charts/chart1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chart" Target="../charts/chart1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chart" Target="../charts/chart13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chart" Target="../charts/chart14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0.png"/><Relationship Id="rId4" Type="http://schemas.openxmlformats.org/officeDocument/2006/relationships/chart" Target="../charts/chart15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chart" Target="../charts/chart16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png"/><Relationship Id="rId4" Type="http://schemas.openxmlformats.org/officeDocument/2006/relationships/chart" Target="../charts/chart1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762000" y="533400"/>
            <a:ext cx="7391400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fontAlgn="base">
              <a:spcBef>
                <a:spcPct val="50000"/>
              </a:spcBef>
              <a:spcAft>
                <a:spcPct val="0"/>
              </a:spcAft>
            </a:pPr>
            <a:r>
              <a:rPr lang="en-US" b="1" dirty="0" smtClean="0">
                <a:solidFill>
                  <a:srgbClr val="000000"/>
                </a:solidFill>
                <a:latin typeface="Arial" charset="0"/>
              </a:rPr>
              <a:t>Additional file 4</a:t>
            </a:r>
            <a:r>
              <a:rPr lang="en-US" dirty="0" smtClean="0">
                <a:solidFill>
                  <a:srgbClr val="000000"/>
                </a:solidFill>
                <a:latin typeface="Arial" charset="0"/>
              </a:rPr>
              <a:t>. </a:t>
            </a:r>
            <a:r>
              <a:rPr lang="en-US" dirty="0">
                <a:solidFill>
                  <a:srgbClr val="000000"/>
                </a:solidFill>
                <a:latin typeface="Arial" charset="0"/>
              </a:rPr>
              <a:t>Expression profiles of selected </a:t>
            </a:r>
            <a:r>
              <a:rPr lang="en-US" i="1" dirty="0" err="1" smtClean="0">
                <a:solidFill>
                  <a:srgbClr val="000000"/>
                </a:solidFill>
                <a:latin typeface="Arial" charset="0"/>
              </a:rPr>
              <a:t>Aedes</a:t>
            </a:r>
            <a:r>
              <a:rPr lang="en-US" i="1" dirty="0" smtClean="0">
                <a:solidFill>
                  <a:srgbClr val="000000"/>
                </a:solidFill>
                <a:latin typeface="Arial" charset="0"/>
              </a:rPr>
              <a:t> </a:t>
            </a:r>
            <a:r>
              <a:rPr lang="en-US" i="1" dirty="0" err="1" smtClean="0">
                <a:solidFill>
                  <a:srgbClr val="000000"/>
                </a:solidFill>
                <a:latin typeface="Arial" charset="0"/>
              </a:rPr>
              <a:t>aegypti</a:t>
            </a:r>
            <a:r>
              <a:rPr lang="en-US" i="1" dirty="0" smtClean="0">
                <a:solidFill>
                  <a:srgbClr val="000000"/>
                </a:solidFill>
                <a:latin typeface="Arial" charset="0"/>
              </a:rPr>
              <a:t> </a:t>
            </a:r>
            <a:r>
              <a:rPr lang="en-US" dirty="0" smtClean="0">
                <a:solidFill>
                  <a:srgbClr val="000000"/>
                </a:solidFill>
                <a:latin typeface="Arial" charset="0"/>
              </a:rPr>
              <a:t>eggshell- </a:t>
            </a:r>
            <a:r>
              <a:rPr lang="en-US" dirty="0">
                <a:solidFill>
                  <a:srgbClr val="000000"/>
                </a:solidFill>
                <a:latin typeface="Arial" charset="0"/>
              </a:rPr>
              <a:t>related genes. </a:t>
            </a:r>
            <a:r>
              <a:rPr lang="en-US" dirty="0" err="1">
                <a:solidFill>
                  <a:srgbClr val="000000"/>
                </a:solidFill>
                <a:latin typeface="Arial" charset="0"/>
              </a:rPr>
              <a:t>RNAseq</a:t>
            </a:r>
            <a:r>
              <a:rPr lang="en-US" dirty="0">
                <a:solidFill>
                  <a:srgbClr val="000000"/>
                </a:solidFill>
                <a:latin typeface="Arial" charset="0"/>
              </a:rPr>
              <a:t> data extracted from </a:t>
            </a:r>
            <a:r>
              <a:rPr lang="en-US" dirty="0" err="1">
                <a:solidFill>
                  <a:srgbClr val="000000"/>
                </a:solidFill>
                <a:latin typeface="Arial" charset="0"/>
              </a:rPr>
              <a:t>Akbari</a:t>
            </a:r>
            <a:r>
              <a:rPr lang="en-US" dirty="0">
                <a:solidFill>
                  <a:srgbClr val="000000"/>
                </a:solidFill>
                <a:latin typeface="Arial" charset="0"/>
              </a:rPr>
              <a:t> </a:t>
            </a:r>
            <a:r>
              <a:rPr lang="en-US" i="1" dirty="0">
                <a:solidFill>
                  <a:srgbClr val="000000"/>
                </a:solidFill>
                <a:latin typeface="Arial" charset="0"/>
              </a:rPr>
              <a:t>et al</a:t>
            </a:r>
            <a:r>
              <a:rPr lang="en-US" dirty="0">
                <a:solidFill>
                  <a:srgbClr val="000000"/>
                </a:solidFill>
                <a:latin typeface="Arial" charset="0"/>
              </a:rPr>
              <a:t>., 2013 </a:t>
            </a:r>
            <a:r>
              <a:rPr lang="en-US" dirty="0" smtClean="0">
                <a:solidFill>
                  <a:srgbClr val="000000"/>
                </a:solidFill>
                <a:latin typeface="Arial" charset="0"/>
              </a:rPr>
              <a:t>[26] show </a:t>
            </a:r>
            <a:r>
              <a:rPr lang="en-US" dirty="0">
                <a:solidFill>
                  <a:srgbClr val="000000"/>
                </a:solidFill>
                <a:latin typeface="Arial" charset="0"/>
              </a:rPr>
              <a:t>transcript abundance (</a:t>
            </a:r>
            <a:r>
              <a:rPr lang="en-US" dirty="0" smtClean="0">
                <a:solidFill>
                  <a:srgbClr val="000000"/>
                </a:solidFill>
                <a:latin typeface="Arial" charset="0"/>
              </a:rPr>
              <a:t>FPKM) at </a:t>
            </a:r>
            <a:r>
              <a:rPr lang="en-US" dirty="0">
                <a:solidFill>
                  <a:srgbClr val="000000"/>
                </a:solidFill>
                <a:latin typeface="Arial" charset="0"/>
              </a:rPr>
              <a:t>developmental stages and dissected tissues, including ovaries</a:t>
            </a:r>
            <a:r>
              <a:rPr lang="en-US" dirty="0" smtClean="0">
                <a:solidFill>
                  <a:srgbClr val="000000"/>
                </a:solidFill>
                <a:latin typeface="Arial" charset="0"/>
              </a:rPr>
              <a:t>. Microarray data </a:t>
            </a:r>
            <a:r>
              <a:rPr lang="en-US" dirty="0" smtClean="0">
                <a:solidFill>
                  <a:srgbClr val="000000"/>
                </a:solidFill>
                <a:latin typeface="Arial" charset="0"/>
              </a:rPr>
              <a:t>[25] are </a:t>
            </a:r>
            <a:r>
              <a:rPr lang="en-US" dirty="0" smtClean="0">
                <a:solidFill>
                  <a:srgbClr val="000000"/>
                </a:solidFill>
                <a:latin typeface="Arial" charset="0"/>
              </a:rPr>
              <a:t>presented </a:t>
            </a:r>
            <a:r>
              <a:rPr lang="en-US" dirty="0">
                <a:solidFill>
                  <a:srgbClr val="000000"/>
                </a:solidFill>
                <a:latin typeface="Arial" charset="0"/>
              </a:rPr>
              <a:t>when available as </a:t>
            </a:r>
            <a:r>
              <a:rPr lang="en-US" dirty="0" smtClean="0">
                <a:solidFill>
                  <a:srgbClr val="000000"/>
                </a:solidFill>
                <a:latin typeface="Arial" charset="0"/>
              </a:rPr>
              <a:t>an inset, and represent the abundance </a:t>
            </a:r>
            <a:r>
              <a:rPr lang="en-US" dirty="0">
                <a:solidFill>
                  <a:srgbClr val="000000"/>
                </a:solidFill>
                <a:latin typeface="Arial" charset="0"/>
              </a:rPr>
              <a:t>of specific mRNAs in </a:t>
            </a:r>
            <a:r>
              <a:rPr lang="en-US" dirty="0" smtClean="0">
                <a:solidFill>
                  <a:srgbClr val="000000"/>
                </a:solidFill>
                <a:latin typeface="Arial" charset="0"/>
              </a:rPr>
              <a:t>samples derived </a:t>
            </a:r>
            <a:r>
              <a:rPr lang="en-US" dirty="0">
                <a:solidFill>
                  <a:srgbClr val="000000"/>
                </a:solidFill>
                <a:latin typeface="Arial" charset="0"/>
              </a:rPr>
              <a:t>from non-blood fed whole females </a:t>
            </a:r>
            <a:r>
              <a:rPr lang="en-US" dirty="0" smtClean="0">
                <a:solidFill>
                  <a:srgbClr val="000000"/>
                </a:solidFill>
                <a:latin typeface="Arial" charset="0"/>
              </a:rPr>
              <a:t>(NBF) and those at </a:t>
            </a:r>
            <a:r>
              <a:rPr lang="en-US" dirty="0">
                <a:solidFill>
                  <a:srgbClr val="000000"/>
                </a:solidFill>
                <a:latin typeface="Arial" charset="0"/>
              </a:rPr>
              <a:t>3, </a:t>
            </a:r>
            <a:r>
              <a:rPr lang="en-US" dirty="0" smtClean="0">
                <a:solidFill>
                  <a:srgbClr val="000000"/>
                </a:solidFill>
                <a:latin typeface="Arial" charset="0"/>
              </a:rPr>
              <a:t>12, 24</a:t>
            </a:r>
            <a:r>
              <a:rPr lang="en-US" dirty="0">
                <a:solidFill>
                  <a:srgbClr val="000000"/>
                </a:solidFill>
                <a:latin typeface="Arial" charset="0"/>
              </a:rPr>
              <a:t>, 48, 72, and 96 hours following a blood </a:t>
            </a:r>
            <a:r>
              <a:rPr lang="en-US" dirty="0" smtClean="0">
                <a:solidFill>
                  <a:srgbClr val="000000"/>
                </a:solidFill>
                <a:latin typeface="Arial" charset="0"/>
              </a:rPr>
              <a:t>meal (BF). A sample from adult males (M) also is included.</a:t>
            </a:r>
            <a:endParaRPr lang="en-US" dirty="0">
              <a:solidFill>
                <a:srgbClr val="000000"/>
              </a:solidFill>
              <a:latin typeface="Arial" charset="0"/>
            </a:endParaRPr>
          </a:p>
        </p:txBody>
      </p:sp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19404559"/>
              </p:ext>
            </p:extLst>
          </p:nvPr>
        </p:nvGraphicFramePr>
        <p:xfrm>
          <a:off x="457200" y="36576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Rectangle 5"/>
          <p:cNvSpPr/>
          <p:nvPr/>
        </p:nvSpPr>
        <p:spPr>
          <a:xfrm>
            <a:off x="6248400" y="3828365"/>
            <a:ext cx="1981200" cy="7620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6477000" y="3886200"/>
            <a:ext cx="16002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Data from </a:t>
            </a:r>
            <a:r>
              <a:rPr lang="en-US" sz="1200" dirty="0" err="1">
                <a:solidFill>
                  <a:srgbClr val="000000"/>
                </a:solidFill>
                <a:latin typeface="Arial" charset="0"/>
              </a:rPr>
              <a:t>Dissanayake</a:t>
            </a:r>
            <a:r>
              <a:rPr lang="en-US" sz="1200" dirty="0">
                <a:solidFill>
                  <a:srgbClr val="000000"/>
                </a:solidFill>
                <a:latin typeface="Arial" charset="0"/>
              </a:rPr>
              <a:t> et al., 2010</a:t>
            </a:r>
            <a:r>
              <a:rPr lang="en-US" sz="1200" dirty="0" smtClean="0"/>
              <a:t>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52999457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27366858"/>
              </p:ext>
            </p:extLst>
          </p:nvPr>
        </p:nvGraphicFramePr>
        <p:xfrm>
          <a:off x="508747" y="4572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7" name="Picture 10" descr="http://www.aegep.bio.uci.edu/helperfxns/graph-error.php?id=AAEL003525-RA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15000" y="1524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42435206"/>
              </p:ext>
            </p:extLst>
          </p:nvPr>
        </p:nvGraphicFramePr>
        <p:xfrm>
          <a:off x="495300" y="38100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pic>
        <p:nvPicPr>
          <p:cNvPr id="9" name="Picture 12" descr="http://www.aegep.bio.uci.edu/helperfxns/graph-error.php?id=AAEL003538-RA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67400" y="34290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2819400" y="6336268"/>
            <a:ext cx="2743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Odorant Binding Protein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993987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69978558"/>
              </p:ext>
            </p:extLst>
          </p:nvPr>
        </p:nvGraphicFramePr>
        <p:xfrm>
          <a:off x="533400" y="4572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7" name="Picture 18" descr="http://www.aegep.bio.uci.edu/helperfxns/graph-error.php?id=AAEL004856-RA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15000" y="762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09877995"/>
              </p:ext>
            </p:extLst>
          </p:nvPr>
        </p:nvGraphicFramePr>
        <p:xfrm>
          <a:off x="457200" y="34290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pic>
        <p:nvPicPr>
          <p:cNvPr id="9" name="Picture 12" descr="http://www.aegep.bio.uci.edu/helperfxns/graph-error.php?id=AAEL006385-RA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6000" y="30480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2819400" y="6248400"/>
            <a:ext cx="2743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Odorant Binding Protein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8862197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04899454"/>
              </p:ext>
            </p:extLst>
          </p:nvPr>
        </p:nvGraphicFramePr>
        <p:xfrm>
          <a:off x="381000" y="5334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7" name="Picture 14" descr="http://www.aegep.bio.uci.edu/helperfxns/graph-error.php?id=AAEL006387-RA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15000" y="1524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8695036"/>
              </p:ext>
            </p:extLst>
          </p:nvPr>
        </p:nvGraphicFramePr>
        <p:xfrm>
          <a:off x="457200" y="37338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pic>
        <p:nvPicPr>
          <p:cNvPr id="9" name="Picture 16" descr="http://www.aegep.bio.uci.edu/helperfxns/graph-error.php?id=AAEL006393-RA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33247" y="32766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2819400" y="6412468"/>
            <a:ext cx="2743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Odorant Binding Protein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9682916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65619839"/>
              </p:ext>
            </p:extLst>
          </p:nvPr>
        </p:nvGraphicFramePr>
        <p:xfrm>
          <a:off x="457200" y="5334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8" name="Picture 20" descr="http://www.aegep.bio.uci.edu/helperfxns/graph-error.php?id=AAEL006396-RA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43600" y="1524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44050043"/>
              </p:ext>
            </p:extLst>
          </p:nvPr>
        </p:nvGraphicFramePr>
        <p:xfrm>
          <a:off x="381000" y="38100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pic>
        <p:nvPicPr>
          <p:cNvPr id="10" name="Picture 18" descr="http://www.aegep.bio.uci.edu/helperfxns/graph-error.php?id=AAEL006398-RA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21188" y="34290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2819400" y="6412468"/>
            <a:ext cx="2743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Odorant Binding Protein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6114385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02981374"/>
              </p:ext>
            </p:extLst>
          </p:nvPr>
        </p:nvGraphicFramePr>
        <p:xfrm>
          <a:off x="381000" y="4572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5" name="Picture 12" descr="http://www.aegep.bio.uci.edu/helperfxns/graph-error.php?id=AAEL009433-RA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91200" y="762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95813561"/>
              </p:ext>
            </p:extLst>
          </p:nvPr>
        </p:nvGraphicFramePr>
        <p:xfrm>
          <a:off x="533400" y="35052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pic>
        <p:nvPicPr>
          <p:cNvPr id="7" name="Picture 14" descr="http://www.aegep.bio.uci.edu/helperfxns/graph-error.php?id=AAEL009599-RA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09129" y="31242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2819400" y="6248400"/>
            <a:ext cx="2743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Odorant Binding Protein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72956027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96933387"/>
              </p:ext>
            </p:extLst>
          </p:nvPr>
        </p:nvGraphicFramePr>
        <p:xfrm>
          <a:off x="381000" y="3810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91200" y="31376"/>
            <a:ext cx="2859087" cy="19018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31236254"/>
              </p:ext>
            </p:extLst>
          </p:nvPr>
        </p:nvGraphicFramePr>
        <p:xfrm>
          <a:off x="533400" y="37338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pic>
        <p:nvPicPr>
          <p:cNvPr id="7" name="Picture 4" descr="http://www.aegep.bio.uci.edu/helperfxns/graph-error.php?id=AAEL010872-RA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01752" y="33528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2819400" y="6336268"/>
            <a:ext cx="2743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Odorant Binding Protein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8048152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56548877"/>
              </p:ext>
            </p:extLst>
          </p:nvPr>
        </p:nvGraphicFramePr>
        <p:xfrm>
          <a:off x="457200" y="3810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7" name="Picture 6" descr="http://www.aegep.bio.uci.edu/helperfxns/graph-error.php?id=AAEL011483-RA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6460" y="152400"/>
            <a:ext cx="2743200" cy="18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72325602"/>
              </p:ext>
            </p:extLst>
          </p:nvPr>
        </p:nvGraphicFramePr>
        <p:xfrm>
          <a:off x="381000" y="36576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pic>
        <p:nvPicPr>
          <p:cNvPr id="9" name="Picture 12" descr="http://www.aegep.bio.uci.edu/helperfxns/graph-error.php?id=AAEL013719-RA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54806" y="31623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2819400" y="6248400"/>
            <a:ext cx="2743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Odorant Binding Protein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812293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22502195"/>
              </p:ext>
            </p:extLst>
          </p:nvPr>
        </p:nvGraphicFramePr>
        <p:xfrm>
          <a:off x="609600" y="38100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61911347"/>
              </p:ext>
            </p:extLst>
          </p:nvPr>
        </p:nvGraphicFramePr>
        <p:xfrm>
          <a:off x="533400" y="4572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7" name="Picture 14" descr="http://www.aegep.bio.uci.edu/helperfxns/graph-error.php?id=AAEL013720-RA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62600" y="762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16" descr="http://www.aegep.bio.uci.edu/helperfxns/graph-error.php?id=AAEL014876-RA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38800" y="34290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2819400" y="6412468"/>
            <a:ext cx="2743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Odorant Binding Protein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7247109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86557755"/>
              </p:ext>
            </p:extLst>
          </p:nvPr>
        </p:nvGraphicFramePr>
        <p:xfrm>
          <a:off x="304800" y="5334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8" name="Picture 4" descr="http://www.aegep.bio.uci.edu/helperfxns/graph-error.php?id=AAEL000302-RA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62600" y="1524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38904096"/>
              </p:ext>
            </p:extLst>
          </p:nvPr>
        </p:nvGraphicFramePr>
        <p:xfrm>
          <a:off x="533400" y="35814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pic>
        <p:nvPicPr>
          <p:cNvPr id="10" name="Picture 2" descr="http://www.aegep.bio.uci.edu/helperfxns/graph-error.php?id=AAEL000317-RA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67400" y="32004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3200400" y="6324600"/>
            <a:ext cx="2362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ysteine Rich </a:t>
            </a:r>
            <a:r>
              <a:rPr lang="en-US" dirty="0"/>
              <a:t>P</a:t>
            </a:r>
            <a:r>
              <a:rPr lang="en-US" dirty="0" smtClean="0"/>
              <a:t>rotein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3322228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28153508"/>
              </p:ext>
            </p:extLst>
          </p:nvPr>
        </p:nvGraphicFramePr>
        <p:xfrm>
          <a:off x="381000" y="3810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5" name="Picture 12" descr="http://www.aegep.bio.uci.edu/helperfxns/graph-error.php?id=AAEL000333-RA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86400" y="762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49519350"/>
              </p:ext>
            </p:extLst>
          </p:nvPr>
        </p:nvGraphicFramePr>
        <p:xfrm>
          <a:off x="457200" y="37338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pic>
        <p:nvPicPr>
          <p:cNvPr id="7" name="Picture 14" descr="http://www.aegep.bio.uci.edu/helperfxns/graph-error.php?id=AAEL000361-RA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15000" y="33528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3200400" y="6324600"/>
            <a:ext cx="2362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ysteine Rich </a:t>
            </a:r>
            <a:r>
              <a:rPr lang="en-US" dirty="0"/>
              <a:t>P</a:t>
            </a:r>
            <a:r>
              <a:rPr lang="en-US" dirty="0" smtClean="0"/>
              <a:t>rotein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662843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91655108"/>
              </p:ext>
            </p:extLst>
          </p:nvPr>
        </p:nvGraphicFramePr>
        <p:xfrm>
          <a:off x="381000" y="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44994865"/>
              </p:ext>
            </p:extLst>
          </p:nvPr>
        </p:nvGraphicFramePr>
        <p:xfrm>
          <a:off x="457200" y="32766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8" name="Picture 8" descr="http://www.aegep.bio.uci.edu/helperfxns/graph-error.php?id=AAEL013027-RA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45841" y="28956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Rectangle 1"/>
          <p:cNvSpPr/>
          <p:nvPr/>
        </p:nvSpPr>
        <p:spPr>
          <a:xfrm>
            <a:off x="2819400" y="6248400"/>
            <a:ext cx="28738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err="1"/>
              <a:t>Vitelline</a:t>
            </a:r>
            <a:r>
              <a:rPr lang="en-US" dirty="0"/>
              <a:t> Membrane Proteins</a:t>
            </a:r>
          </a:p>
        </p:txBody>
      </p:sp>
    </p:spTree>
    <p:extLst>
      <p:ext uri="{BB962C8B-B14F-4D97-AF65-F5344CB8AC3E}">
        <p14:creationId xmlns:p14="http://schemas.microsoft.com/office/powerpoint/2010/main" val="1288228102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30504841"/>
              </p:ext>
            </p:extLst>
          </p:nvPr>
        </p:nvGraphicFramePr>
        <p:xfrm>
          <a:off x="381000" y="4572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7" name="Picture 16" descr="http://www.aegep.bio.uci.edu/helperfxns/graph-error.php?id=AAEL000363-RA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10200" y="762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40118161"/>
              </p:ext>
            </p:extLst>
          </p:nvPr>
        </p:nvGraphicFramePr>
        <p:xfrm>
          <a:off x="266700" y="35814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pic>
        <p:nvPicPr>
          <p:cNvPr id="9" name="Picture 18" descr="http://www.aegep.bio.uci.edu/helperfxns/graph-error.php?id=AAEL000369-RA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62600" y="32766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3200400" y="6324600"/>
            <a:ext cx="2362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ysteine Rich </a:t>
            </a:r>
            <a:r>
              <a:rPr lang="en-US" dirty="0"/>
              <a:t>P</a:t>
            </a:r>
            <a:r>
              <a:rPr lang="en-US" dirty="0" smtClean="0"/>
              <a:t>rotein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75739836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91935963"/>
              </p:ext>
            </p:extLst>
          </p:nvPr>
        </p:nvGraphicFramePr>
        <p:xfrm>
          <a:off x="381000" y="5334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5" name="Picture 2" descr="http://www.aegep.bio.uci.edu/helperfxns/graph-error.php?id=AAEL000375-RA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15000" y="1524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05641158"/>
              </p:ext>
            </p:extLst>
          </p:nvPr>
        </p:nvGraphicFramePr>
        <p:xfrm>
          <a:off x="381000" y="34290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pic>
        <p:nvPicPr>
          <p:cNvPr id="7" name="Picture 2" descr="http://www.aegep.bio.uci.edu/helperfxns/graph-error.php?id=AAEL005090-RA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38800" y="3074895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3200400" y="6324600"/>
            <a:ext cx="2362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ysteine Rich </a:t>
            </a:r>
            <a:r>
              <a:rPr lang="en-US" dirty="0"/>
              <a:t>P</a:t>
            </a:r>
            <a:r>
              <a:rPr lang="en-US" dirty="0" smtClean="0"/>
              <a:t>rotein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74865320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53734453"/>
              </p:ext>
            </p:extLst>
          </p:nvPr>
        </p:nvGraphicFramePr>
        <p:xfrm>
          <a:off x="228600" y="4572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5" name="Picture 4" descr="http://www.aegep.bio.uci.edu/helperfxns/graph-error.php?id=AAEL005098-RA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10200" y="762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59492102"/>
              </p:ext>
            </p:extLst>
          </p:nvPr>
        </p:nvGraphicFramePr>
        <p:xfrm>
          <a:off x="228600" y="38100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pic>
        <p:nvPicPr>
          <p:cNvPr id="7" name="Picture 6" descr="http://www.aegep.bio.uci.edu/helperfxns/graph-error.php?id=AAEL005487-RA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23647" y="32004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3200400" y="6324600"/>
            <a:ext cx="2362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ysteine Rich </a:t>
            </a:r>
            <a:r>
              <a:rPr lang="en-US" dirty="0"/>
              <a:t>P</a:t>
            </a:r>
            <a:r>
              <a:rPr lang="en-US" dirty="0" smtClean="0"/>
              <a:t>rotein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62423949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00843696"/>
              </p:ext>
            </p:extLst>
          </p:nvPr>
        </p:nvGraphicFramePr>
        <p:xfrm>
          <a:off x="457200" y="4572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3" name="Picture 6" descr="http://www.aegep.bio.uci.edu/helperfxns/graph-error.php?id=AAEL000507-RA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62600" y="762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37703126"/>
              </p:ext>
            </p:extLst>
          </p:nvPr>
        </p:nvGraphicFramePr>
        <p:xfrm>
          <a:off x="179294" y="35814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pic>
        <p:nvPicPr>
          <p:cNvPr id="5" name="Picture 14" descr="http://www.aegep.bio.uci.edu/helperfxns/graph-error.php?id=AAEL004386-RA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41894" y="32004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2590800" y="488575"/>
            <a:ext cx="19050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eroxidase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2330825" y="3621740"/>
            <a:ext cx="19050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eroxidase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3520888" y="6172200"/>
            <a:ext cx="1295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Enzym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90862084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20421272"/>
              </p:ext>
            </p:extLst>
          </p:nvPr>
        </p:nvGraphicFramePr>
        <p:xfrm>
          <a:off x="381000" y="4572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6" name="Picture 16" descr="http://www.aegep.bio.uci.edu/helperfxns/graph-error.php?id=AAEL004390-RA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38800" y="762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2563905" y="493060"/>
            <a:ext cx="19050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eroxidase</a:t>
            </a:r>
            <a:endParaRPr lang="en-US" dirty="0"/>
          </a:p>
        </p:txBody>
      </p:sp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22885822"/>
              </p:ext>
            </p:extLst>
          </p:nvPr>
        </p:nvGraphicFramePr>
        <p:xfrm>
          <a:off x="457200" y="35814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pic>
        <p:nvPicPr>
          <p:cNvPr id="10" name="Picture 10" descr="http://www.aegep.bio.uci.edu/helperfxns/graph-error.php?id=AAEL013492-RA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00700" y="32766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TextBox 10"/>
          <p:cNvSpPr txBox="1"/>
          <p:nvPr/>
        </p:nvSpPr>
        <p:spPr>
          <a:xfrm>
            <a:off x="2281535" y="3617260"/>
            <a:ext cx="19050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/>
              <a:t>Phenoloxidase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3520888" y="6172200"/>
            <a:ext cx="1295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Enzym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50575600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40808832"/>
              </p:ext>
            </p:extLst>
          </p:nvPr>
        </p:nvGraphicFramePr>
        <p:xfrm>
          <a:off x="266700" y="36957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52360822"/>
              </p:ext>
            </p:extLst>
          </p:nvPr>
        </p:nvGraphicFramePr>
        <p:xfrm>
          <a:off x="495300" y="6096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8" name="Picture 18" descr="http://www.aegep.bio.uci.edu/helperfxns/graph-error.php?id=AAEL002333-RA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38800" y="762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4" descr="http://www.aegep.bio.uci.edu/helperfxns/graph-error.php?id=AAEL006830-RA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15000" y="31623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609610" y="543580"/>
            <a:ext cx="335279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Major royal jelly </a:t>
            </a:r>
            <a:r>
              <a:rPr lang="en-US" sz="1400" dirty="0" smtClean="0"/>
              <a:t>protein/ </a:t>
            </a:r>
            <a:r>
              <a:rPr lang="en-US" sz="1400" dirty="0"/>
              <a:t>Yellow protein </a:t>
            </a:r>
            <a:r>
              <a:rPr lang="en-US" sz="1400" dirty="0" smtClean="0"/>
              <a:t>/ putative </a:t>
            </a:r>
            <a:r>
              <a:rPr lang="en-US" sz="1400" dirty="0" err="1"/>
              <a:t>dopachrome</a:t>
            </a:r>
            <a:r>
              <a:rPr lang="en-US" sz="1400" dirty="0"/>
              <a:t>-conversion enzyme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57200" y="3667780"/>
            <a:ext cx="335279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Major royal jelly </a:t>
            </a:r>
            <a:r>
              <a:rPr lang="en-US" sz="1400" dirty="0" smtClean="0"/>
              <a:t>protein/ </a:t>
            </a:r>
            <a:r>
              <a:rPr lang="en-US" sz="1400" dirty="0"/>
              <a:t>Yellow protein </a:t>
            </a:r>
            <a:r>
              <a:rPr lang="en-US" sz="1400" dirty="0" smtClean="0"/>
              <a:t>/ putative </a:t>
            </a:r>
            <a:r>
              <a:rPr lang="en-US" sz="1400" dirty="0" err="1"/>
              <a:t>dopachrome</a:t>
            </a:r>
            <a:r>
              <a:rPr lang="en-US" sz="1400" dirty="0"/>
              <a:t>-conversion enzyme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520888" y="6172200"/>
            <a:ext cx="1295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Enzym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16566182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74293333"/>
              </p:ext>
            </p:extLst>
          </p:nvPr>
        </p:nvGraphicFramePr>
        <p:xfrm>
          <a:off x="381000" y="3810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96306991"/>
              </p:ext>
            </p:extLst>
          </p:nvPr>
        </p:nvGraphicFramePr>
        <p:xfrm>
          <a:off x="533400" y="35052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6" name="Picture 6" descr="http://www.aegep.bio.uci.edu/helperfxns/graph-error.php?id=AAEL006985-RA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10200" y="152400"/>
            <a:ext cx="1943100" cy="1295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8" descr="http://www.aegep.bio.uci.edu/helperfxns/graph-error.php?id=AAEL007096-RA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15000" y="29718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609610" y="413595"/>
            <a:ext cx="335279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Major royal jelly </a:t>
            </a:r>
            <a:r>
              <a:rPr lang="en-US" sz="1400" dirty="0" smtClean="0"/>
              <a:t>protein/ </a:t>
            </a:r>
            <a:r>
              <a:rPr lang="en-US" sz="1400" dirty="0"/>
              <a:t>Yellow protein </a:t>
            </a:r>
            <a:r>
              <a:rPr lang="en-US" sz="1400" dirty="0" smtClean="0"/>
              <a:t>/ putative </a:t>
            </a:r>
            <a:r>
              <a:rPr lang="en-US" sz="1400" dirty="0" err="1"/>
              <a:t>dopachrome</a:t>
            </a:r>
            <a:r>
              <a:rPr lang="en-US" sz="1400" dirty="0"/>
              <a:t>-conversion enzyme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685800" y="3439180"/>
            <a:ext cx="335279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Major royal jelly </a:t>
            </a:r>
            <a:r>
              <a:rPr lang="en-US" sz="1400" dirty="0" smtClean="0"/>
              <a:t>protein/ </a:t>
            </a:r>
            <a:r>
              <a:rPr lang="en-US" sz="1400" dirty="0"/>
              <a:t>Yellow protein </a:t>
            </a:r>
            <a:r>
              <a:rPr lang="en-US" sz="1400" dirty="0" smtClean="0"/>
              <a:t>/ putative </a:t>
            </a:r>
            <a:r>
              <a:rPr lang="en-US" sz="1400" dirty="0" err="1"/>
              <a:t>dopachrome</a:t>
            </a:r>
            <a:r>
              <a:rPr lang="en-US" sz="1400" dirty="0"/>
              <a:t>-conversion enzyme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520888" y="6172200"/>
            <a:ext cx="1295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Enzym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08356904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09055459"/>
              </p:ext>
            </p:extLst>
          </p:nvPr>
        </p:nvGraphicFramePr>
        <p:xfrm>
          <a:off x="457200" y="4572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4" name="Picture 18" descr="http://www.aegep.bio.uci.edu/helperfxns/graph-error.php?id=AAEL010848-RA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67400" y="762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49813788"/>
              </p:ext>
            </p:extLst>
          </p:nvPr>
        </p:nvGraphicFramePr>
        <p:xfrm>
          <a:off x="381000" y="35814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pic>
        <p:nvPicPr>
          <p:cNvPr id="9" name="Picture 10" descr="http://www.aegep.bio.uci.edu/helperfxns/graph-error.php?id=AAEL007641-RA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78071" y="30480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1905000" y="3631168"/>
            <a:ext cx="1905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/>
              <a:t>Transglutaminase</a:t>
            </a:r>
            <a:r>
              <a:rPr lang="en-US" dirty="0" smtClean="0"/>
              <a:t> </a:t>
            </a:r>
            <a:endParaRPr 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609610" y="413595"/>
            <a:ext cx="335279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Major royal jelly </a:t>
            </a:r>
            <a:r>
              <a:rPr lang="en-US" sz="1400" dirty="0" smtClean="0"/>
              <a:t>protein/ </a:t>
            </a:r>
            <a:r>
              <a:rPr lang="en-US" sz="1400" dirty="0"/>
              <a:t>Yellow protein </a:t>
            </a:r>
            <a:r>
              <a:rPr lang="en-US" sz="1400" dirty="0" smtClean="0"/>
              <a:t>/ putative </a:t>
            </a:r>
            <a:r>
              <a:rPr lang="en-US" sz="1400" dirty="0" err="1"/>
              <a:t>dopachrome</a:t>
            </a:r>
            <a:r>
              <a:rPr lang="en-US" sz="1400" dirty="0"/>
              <a:t>-conversion enzyme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520888" y="6172200"/>
            <a:ext cx="1295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Enzym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64366567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50476957"/>
              </p:ext>
            </p:extLst>
          </p:nvPr>
        </p:nvGraphicFramePr>
        <p:xfrm>
          <a:off x="457200" y="32766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2743200" y="3352800"/>
            <a:ext cx="1905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/>
              <a:t>Laccase</a:t>
            </a:r>
            <a:r>
              <a:rPr lang="en-US" dirty="0" smtClean="0"/>
              <a:t> </a:t>
            </a:r>
            <a:endParaRPr lang="en-US" dirty="0"/>
          </a:p>
        </p:txBody>
      </p:sp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57608934"/>
              </p:ext>
            </p:extLst>
          </p:nvPr>
        </p:nvGraphicFramePr>
        <p:xfrm>
          <a:off x="457200" y="6096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4098" name="Picture 2" descr="http://www.aegep.bio.uci.edu/helperfxns/graph-error.php?id=AAEL007415-RA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86400" y="44824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2931455" y="649940"/>
            <a:ext cx="1905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/>
              <a:t>Laccase</a:t>
            </a:r>
            <a:r>
              <a:rPr lang="en-US" dirty="0" smtClean="0"/>
              <a:t> 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3520888" y="6172200"/>
            <a:ext cx="1295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Enzym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52420601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8879561"/>
              </p:ext>
            </p:extLst>
          </p:nvPr>
        </p:nvGraphicFramePr>
        <p:xfrm>
          <a:off x="533400" y="6096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3" name="Picture 18" descr="http://www.aegep.bio.uci.edu/helperfxns/graph-error.php?id=AAEL000144-RA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15000" y="2286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67874343"/>
              </p:ext>
            </p:extLst>
          </p:nvPr>
        </p:nvGraphicFramePr>
        <p:xfrm>
          <a:off x="609600" y="38100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pic>
        <p:nvPicPr>
          <p:cNvPr id="5" name="Picture 2" descr="http://www.aegep.bio.uci.edu/helperfxns/graph-error.php?id=AAEL002400-RA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91200" y="34290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5"/>
          <p:cNvSpPr/>
          <p:nvPr/>
        </p:nvSpPr>
        <p:spPr>
          <a:xfrm>
            <a:off x="2667000" y="6400800"/>
            <a:ext cx="36136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Proteins with chitin binding domains</a:t>
            </a:r>
          </a:p>
        </p:txBody>
      </p:sp>
    </p:spTree>
    <p:extLst>
      <p:ext uri="{BB962C8B-B14F-4D97-AF65-F5344CB8AC3E}">
        <p14:creationId xmlns:p14="http://schemas.microsoft.com/office/powerpoint/2010/main" val="12320408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08233338"/>
              </p:ext>
            </p:extLst>
          </p:nvPr>
        </p:nvGraphicFramePr>
        <p:xfrm>
          <a:off x="457200" y="4572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95044005"/>
              </p:ext>
            </p:extLst>
          </p:nvPr>
        </p:nvGraphicFramePr>
        <p:xfrm>
          <a:off x="381000" y="35052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6" name="Picture 2" descr="http://www.aegep.bio.uci.edu/helperfxns/graph-error.php?id=AAEL006670-RA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38800" y="31242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Rectangle 1"/>
          <p:cNvSpPr/>
          <p:nvPr/>
        </p:nvSpPr>
        <p:spPr>
          <a:xfrm>
            <a:off x="3048000" y="6248400"/>
            <a:ext cx="28738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err="1"/>
              <a:t>Vitelline</a:t>
            </a:r>
            <a:r>
              <a:rPr lang="en-US" dirty="0"/>
              <a:t> Membrane Proteins</a:t>
            </a:r>
          </a:p>
        </p:txBody>
      </p:sp>
    </p:spTree>
    <p:extLst>
      <p:ext uri="{BB962C8B-B14F-4D97-AF65-F5344CB8AC3E}">
        <p14:creationId xmlns:p14="http://schemas.microsoft.com/office/powerpoint/2010/main" val="2479996249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65060124"/>
              </p:ext>
            </p:extLst>
          </p:nvPr>
        </p:nvGraphicFramePr>
        <p:xfrm>
          <a:off x="457200" y="6858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6" name="Picture 8" descr="http://www.aegep.bio.uci.edu/helperfxns/graph-error.php?id=AAEL006328-RA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62600" y="2286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Rectangle 1"/>
          <p:cNvSpPr/>
          <p:nvPr/>
        </p:nvSpPr>
        <p:spPr>
          <a:xfrm>
            <a:off x="2765159" y="3244334"/>
            <a:ext cx="36136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Proteins with chitin binding domains</a:t>
            </a:r>
          </a:p>
        </p:txBody>
      </p:sp>
    </p:spTree>
    <p:extLst>
      <p:ext uri="{BB962C8B-B14F-4D97-AF65-F5344CB8AC3E}">
        <p14:creationId xmlns:p14="http://schemas.microsoft.com/office/powerpoint/2010/main" val="33379058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18325897"/>
              </p:ext>
            </p:extLst>
          </p:nvPr>
        </p:nvGraphicFramePr>
        <p:xfrm>
          <a:off x="457200" y="4572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41169158"/>
              </p:ext>
            </p:extLst>
          </p:nvPr>
        </p:nvGraphicFramePr>
        <p:xfrm>
          <a:off x="381000" y="35814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Rectangle 1"/>
          <p:cNvSpPr/>
          <p:nvPr/>
        </p:nvSpPr>
        <p:spPr>
          <a:xfrm>
            <a:off x="2971800" y="6248400"/>
            <a:ext cx="28738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err="1"/>
              <a:t>Vitelline</a:t>
            </a:r>
            <a:r>
              <a:rPr lang="en-US" dirty="0"/>
              <a:t> Membrane Proteins</a:t>
            </a:r>
          </a:p>
        </p:txBody>
      </p:sp>
    </p:spTree>
    <p:extLst>
      <p:ext uri="{BB962C8B-B14F-4D97-AF65-F5344CB8AC3E}">
        <p14:creationId xmlns:p14="http://schemas.microsoft.com/office/powerpoint/2010/main" val="370283897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62048091"/>
              </p:ext>
            </p:extLst>
          </p:nvPr>
        </p:nvGraphicFramePr>
        <p:xfrm>
          <a:off x="457200" y="5334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7" name="Picture 8" descr="http://www.aegep.bio.uci.edu/helperfxns/graph-error.php?id=AAEL000319-RA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10200" y="304800"/>
            <a:ext cx="2400300" cy="1600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37036013"/>
              </p:ext>
            </p:extLst>
          </p:nvPr>
        </p:nvGraphicFramePr>
        <p:xfrm>
          <a:off x="533400" y="35052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pic>
        <p:nvPicPr>
          <p:cNvPr id="9" name="Picture 4" descr="http://www.aegep.bio.uci.edu/helperfxns/graph-error.php?id=AAEL000377-RA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62600" y="31623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2819400" y="6248400"/>
            <a:ext cx="2743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Odorant Binding Protein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627057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64314359"/>
              </p:ext>
            </p:extLst>
          </p:nvPr>
        </p:nvGraphicFramePr>
        <p:xfrm>
          <a:off x="457200" y="6858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7" name="Picture 8" descr="http://www.aegep.bio.uci.edu/helperfxns/graph-error.php?id=AAEL000796-RA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15000" y="2286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49480782"/>
              </p:ext>
            </p:extLst>
          </p:nvPr>
        </p:nvGraphicFramePr>
        <p:xfrm>
          <a:off x="419100" y="36576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pic>
        <p:nvPicPr>
          <p:cNvPr id="9" name="Picture 10" descr="http://www.aegep.bio.uci.edu/helperfxns/graph-error.php?id=AAEL000833-RA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91200" y="32766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2819400" y="6248400"/>
            <a:ext cx="2743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Odorant Binding Protein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5356469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20087392"/>
              </p:ext>
            </p:extLst>
          </p:nvPr>
        </p:nvGraphicFramePr>
        <p:xfrm>
          <a:off x="457200" y="530225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38800" y="152400"/>
            <a:ext cx="2859087" cy="19018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08762802"/>
              </p:ext>
            </p:extLst>
          </p:nvPr>
        </p:nvGraphicFramePr>
        <p:xfrm>
          <a:off x="381000" y="35052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pic>
        <p:nvPicPr>
          <p:cNvPr id="7" name="Picture 14" descr="http://www.aegep.bio.uci.edu/helperfxns/graph-error.php?id=AAEL000837-RA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91200" y="3115235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2819400" y="6248400"/>
            <a:ext cx="2743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Odorant Binding Protein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9706830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02397331"/>
              </p:ext>
            </p:extLst>
          </p:nvPr>
        </p:nvGraphicFramePr>
        <p:xfrm>
          <a:off x="533400" y="5334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5" name="Picture 16" descr="http://www.aegep.bio.uci.edu/helperfxns/graph-error.php?id=AAEL001153-RA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91200" y="1524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23199553"/>
              </p:ext>
            </p:extLst>
          </p:nvPr>
        </p:nvGraphicFramePr>
        <p:xfrm>
          <a:off x="533400" y="35814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pic>
        <p:nvPicPr>
          <p:cNvPr id="7" name="Picture 4" descr="http://www.aegep.bio.uci.edu/helperfxns/graph-error.php?id=AAEL003315-RA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43600" y="31623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2819400" y="6248400"/>
            <a:ext cx="2743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Odorant Binding Protein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7228628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07770229"/>
              </p:ext>
            </p:extLst>
          </p:nvPr>
        </p:nvGraphicFramePr>
        <p:xfrm>
          <a:off x="289112" y="5334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5" name="Picture 6" descr="http://www.aegep.bio.uci.edu/helperfxns/graph-error.php?id=AAEL003511-RA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38800" y="1524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37217335"/>
              </p:ext>
            </p:extLst>
          </p:nvPr>
        </p:nvGraphicFramePr>
        <p:xfrm>
          <a:off x="266700" y="3429000"/>
          <a:ext cx="8229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pic>
        <p:nvPicPr>
          <p:cNvPr id="7" name="Picture 8" descr="http://www.aegep.bio.uci.edu/helperfxns/graph-error.php?id=AAEL003513-RA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72629" y="3124200"/>
            <a:ext cx="2857500" cy="1905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2819400" y="6248400"/>
            <a:ext cx="2743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Odorant Binding Protein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801253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93</TotalTime>
  <Words>432</Words>
  <Application>Microsoft Office PowerPoint</Application>
  <PresentationFormat>On-screen Show (4:3)</PresentationFormat>
  <Paragraphs>132</Paragraphs>
  <Slides>30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0</vt:i4>
      </vt:variant>
    </vt:vector>
  </HeadingPairs>
  <TitlesOfParts>
    <vt:vector size="31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svaldo Marinotti</dc:creator>
  <cp:lastModifiedBy>omarinot</cp:lastModifiedBy>
  <cp:revision>42</cp:revision>
  <cp:lastPrinted>2013-10-03T21:02:12Z</cp:lastPrinted>
  <dcterms:created xsi:type="dcterms:W3CDTF">2013-10-02T22:01:32Z</dcterms:created>
  <dcterms:modified xsi:type="dcterms:W3CDTF">2014-03-14T00:37:42Z</dcterms:modified>
</cp:coreProperties>
</file>